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charts/chart4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ppt/charts/chart5.xml" ContentType="application/vnd.openxmlformats-officedocument.drawingml.chart+xml"/>
  <Override PartName="/ppt/charts/style5.xml" ContentType="application/vnd.ms-office.chartstyle+xml"/>
  <Override PartName="/ppt/charts/colors5.xml" ContentType="application/vnd.ms-office.chartcolorstyle+xml"/>
  <Override PartName="/ppt/charts/chart6.xml" ContentType="application/vnd.openxmlformats-officedocument.drawingml.chart+xml"/>
  <Override PartName="/ppt/charts/style6.xml" ContentType="application/vnd.ms-office.chartstyle+xml"/>
  <Override PartName="/ppt/charts/colors6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00" autoAdjust="0"/>
    <p:restoredTop sz="94660"/>
  </p:normalViewPr>
  <p:slideViewPr>
    <p:cSldViewPr snapToGrid="0">
      <p:cViewPr varScale="1">
        <p:scale>
          <a:sx n="79" d="100"/>
          <a:sy n="79" d="100"/>
        </p:scale>
        <p:origin x="420" y="7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.xlsx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1.xlsx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2.xlsx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3.xlsx"/><Relationship Id="rId2" Type="http://schemas.microsoft.com/office/2011/relationships/chartColorStyle" Target="colors4.xml"/><Relationship Id="rId1" Type="http://schemas.microsoft.com/office/2011/relationships/chartStyle" Target="style4.xml"/></Relationships>
</file>

<file path=ppt/charts/_rels/chart5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4.xlsx"/><Relationship Id="rId2" Type="http://schemas.microsoft.com/office/2011/relationships/chartColorStyle" Target="colors5.xml"/><Relationship Id="rId1" Type="http://schemas.microsoft.com/office/2011/relationships/chartStyle" Target="style5.xml"/></Relationships>
</file>

<file path=ppt/charts/_rels/chart6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5.xlsx"/><Relationship Id="rId2" Type="http://schemas.microsoft.com/office/2011/relationships/chartColorStyle" Target="colors6.xml"/><Relationship Id="rId1" Type="http://schemas.microsoft.com/office/2011/relationships/chartStyle" Target="style6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 algn="ctr" rtl="0">
              <a:defRPr lang="en-US" sz="2000" b="0" i="0" u="none" strike="noStrike" kern="1200" spc="70" baseline="0">
                <a:solidFill>
                  <a:prstClr val="black">
                    <a:lumMod val="50000"/>
                    <a:lumOff val="50000"/>
                  </a:prst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US" sz="2000" b="1" i="0" u="none" strike="noStrike" kern="1200" spc="70" baseline="0" dirty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VS-GY</a:t>
            </a:r>
          </a:p>
        </c:rich>
      </c:tx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 algn="ctr" rtl="0">
            <a:defRPr lang="en-US" sz="2000" b="0" i="0" u="none" strike="noStrike" kern="1200" spc="70" baseline="0">
              <a:solidFill>
                <a:prstClr val="black">
                  <a:lumMod val="50000"/>
                  <a:lumOff val="50000"/>
                </a:prstClr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title>
    <c:autoTitleDeleted val="0"/>
    <c:plotArea>
      <c:layout/>
      <c:scatterChart>
        <c:scatterStyle val="lineMarker"/>
        <c:varyColors val="0"/>
        <c:ser>
          <c:idx val="0"/>
          <c:order val="0"/>
          <c:tx>
            <c:strRef>
              <c:f>'292RIL'!$K$1</c:f>
              <c:strCache>
                <c:ptCount val="1"/>
                <c:pt idx="0">
                  <c:v>GY</c:v>
                </c:pt>
              </c:strCache>
            </c:strRef>
          </c:tx>
          <c:spPr>
            <a:ln w="1905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trendline>
            <c:spPr>
              <a:ln w="19050" cap="rnd">
                <a:solidFill>
                  <a:schemeClr val="accent1"/>
                </a:solidFill>
                <a:prstDash val="sysDot"/>
              </a:ln>
              <a:effectLst/>
            </c:spPr>
            <c:trendlineType val="linear"/>
            <c:dispRSqr val="1"/>
            <c:dispEq val="1"/>
            <c:trendlineLbl>
              <c:layout>
                <c:manualLayout>
                  <c:x val="0.12879240740890888"/>
                  <c:y val="-0.2983118256051327"/>
                </c:manualLayout>
              </c:layout>
              <c:tx>
                <c:rich>
                  <a:bodyPr rot="0" spcFirstLastPara="1" vertOverflow="ellipsis" vert="horz" wrap="square" anchor="ctr" anchorCtr="1"/>
                  <a:lstStyle/>
                  <a:p>
                    <a:pPr algn="ctr" rtl="0">
                      <a:defRPr lang="en-US" sz="1197" b="0" i="0" u="none" strike="noStrike" kern="1200" baseline="0">
                        <a:solidFill>
                          <a:prstClr val="black">
                            <a:lumMod val="50000"/>
                            <a:lumOff val="50000"/>
                          </a:prstClr>
                        </a:solidFill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defRPr>
                    </a:pPr>
                    <a:r>
                      <a:rPr lang="en-US" b="1" baseline="0" dirty="0">
                        <a:solidFill>
                          <a:schemeClr val="tx1"/>
                        </a:solidFill>
                      </a:rPr>
                      <a:t>y = 48.911x - 32.848</a:t>
                    </a:r>
                    <a:br>
                      <a:rPr lang="en-US" b="1" baseline="0" dirty="0">
                        <a:solidFill>
                          <a:schemeClr val="tx1"/>
                        </a:solidFill>
                      </a:rPr>
                    </a:br>
                    <a:r>
                      <a:rPr lang="en-US" b="1" baseline="0" dirty="0">
                        <a:solidFill>
                          <a:schemeClr val="tx1"/>
                        </a:solidFill>
                      </a:rPr>
                      <a:t>R² = 0.4363</a:t>
                    </a:r>
                    <a:endParaRPr lang="en-US" b="1" dirty="0">
                      <a:solidFill>
                        <a:schemeClr val="tx1"/>
                      </a:solidFill>
                    </a:endParaRPr>
                  </a:p>
                </c:rich>
              </c:tx>
              <c:numFmt formatCode="General" sourceLinked="0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anchor="ctr" anchorCtr="1"/>
                <a:lstStyle/>
                <a:p>
                  <a:pPr algn="ctr" rtl="0">
                    <a:defRPr lang="en-US" sz="1197" b="0" i="0" u="none" strike="noStrike" kern="1200" baseline="0">
                      <a:solidFill>
                        <a:prstClr val="black">
                          <a:lumMod val="50000"/>
                          <a:lumOff val="50000"/>
                        </a:prstClr>
                      </a:solidFill>
                      <a:latin typeface="Arial" panose="020B0604020202020204" pitchFamily="34" charset="0"/>
                      <a:ea typeface="+mn-ea"/>
                      <a:cs typeface="Arial" panose="020B0604020202020204" pitchFamily="34" charset="0"/>
                    </a:defRPr>
                  </a:pPr>
                  <a:endParaRPr lang="en-US"/>
                </a:p>
              </c:txPr>
            </c:trendlineLbl>
          </c:trendline>
          <c:xVal>
            <c:numRef>
              <c:f>'292RIL'!$D$2:$D$295</c:f>
              <c:numCache>
                <c:formatCode>0.00</c:formatCode>
                <c:ptCount val="294"/>
                <c:pt idx="0">
                  <c:v>1.77464468877843</c:v>
                </c:pt>
                <c:pt idx="1">
                  <c:v>1.5830333522079201</c:v>
                </c:pt>
                <c:pt idx="2">
                  <c:v>1.8005268660624401</c:v>
                </c:pt>
                <c:pt idx="3">
                  <c:v>1.94243902675113</c:v>
                </c:pt>
                <c:pt idx="4">
                  <c:v>1.7515973149515001</c:v>
                </c:pt>
                <c:pt idx="5">
                  <c:v>1.9299519530417599</c:v>
                </c:pt>
                <c:pt idx="6">
                  <c:v>2.0415591726303002</c:v>
                </c:pt>
                <c:pt idx="7">
                  <c:v>1.8195618111295799</c:v>
                </c:pt>
                <c:pt idx="8">
                  <c:v>1.7121674111899701</c:v>
                </c:pt>
                <c:pt idx="9">
                  <c:v>1.68899504866252</c:v>
                </c:pt>
                <c:pt idx="10">
                  <c:v>1.8970086622498701</c:v>
                </c:pt>
                <c:pt idx="11">
                  <c:v>1.82784590699515</c:v>
                </c:pt>
                <c:pt idx="12">
                  <c:v>1.73062811557982</c:v>
                </c:pt>
                <c:pt idx="13">
                  <c:v>1.98581904842996</c:v>
                </c:pt>
                <c:pt idx="14">
                  <c:v>1.80671538459767</c:v>
                </c:pt>
                <c:pt idx="15">
                  <c:v>1.6768671206780399</c:v>
                </c:pt>
                <c:pt idx="16">
                  <c:v>1.95406534096933</c:v>
                </c:pt>
                <c:pt idx="17">
                  <c:v>1.88391952599521</c:v>
                </c:pt>
                <c:pt idx="18">
                  <c:v>1.68075160261752</c:v>
                </c:pt>
                <c:pt idx="19">
                  <c:v>1.78953915318223</c:v>
                </c:pt>
                <c:pt idx="20">
                  <c:v>1.6734125972609299</c:v>
                </c:pt>
                <c:pt idx="21">
                  <c:v>1.80489405697975</c:v>
                </c:pt>
                <c:pt idx="22">
                  <c:v>1.8866420375144</c:v>
                </c:pt>
                <c:pt idx="23">
                  <c:v>1.6772842183927299</c:v>
                </c:pt>
                <c:pt idx="24">
                  <c:v>1.8230916057754201</c:v>
                </c:pt>
                <c:pt idx="25">
                  <c:v>1.07443706976231</c:v>
                </c:pt>
                <c:pt idx="26">
                  <c:v>1.8989343088895501</c:v>
                </c:pt>
                <c:pt idx="27">
                  <c:v>1.8258205793091</c:v>
                </c:pt>
                <c:pt idx="28">
                  <c:v>1.8387035731646899</c:v>
                </c:pt>
                <c:pt idx="29">
                  <c:v>1.4739227226001801</c:v>
                </c:pt>
                <c:pt idx="30">
                  <c:v>1.9260853184572899</c:v>
                </c:pt>
                <c:pt idx="31">
                  <c:v>2.0405504866431801</c:v>
                </c:pt>
                <c:pt idx="32">
                  <c:v>1.6834280817557601</c:v>
                </c:pt>
                <c:pt idx="33">
                  <c:v>1.9285868033801501</c:v>
                </c:pt>
                <c:pt idx="34">
                  <c:v>1.9293856518207499</c:v>
                </c:pt>
                <c:pt idx="35">
                  <c:v>1.93755105935258</c:v>
                </c:pt>
                <c:pt idx="36">
                  <c:v>2.0542301033980701</c:v>
                </c:pt>
                <c:pt idx="37">
                  <c:v>1.8443066247750699</c:v>
                </c:pt>
                <c:pt idx="38">
                  <c:v>1.8301201786324099</c:v>
                </c:pt>
                <c:pt idx="39">
                  <c:v>1.9896974160952099</c:v>
                </c:pt>
                <c:pt idx="40">
                  <c:v>1.9676998287434699</c:v>
                </c:pt>
                <c:pt idx="41">
                  <c:v>1.9085940514649</c:v>
                </c:pt>
                <c:pt idx="42">
                  <c:v>1.8796588822714999</c:v>
                </c:pt>
                <c:pt idx="43">
                  <c:v>1.6951694937663899</c:v>
                </c:pt>
                <c:pt idx="44">
                  <c:v>1.96409641986518</c:v>
                </c:pt>
                <c:pt idx="45">
                  <c:v>1.74175629159555</c:v>
                </c:pt>
                <c:pt idx="46">
                  <c:v>1.1944997542392899</c:v>
                </c:pt>
                <c:pt idx="47">
                  <c:v>1.83232279240592</c:v>
                </c:pt>
                <c:pt idx="48">
                  <c:v>2.0039262446402701</c:v>
                </c:pt>
                <c:pt idx="49">
                  <c:v>1.67451112581198</c:v>
                </c:pt>
                <c:pt idx="50">
                  <c:v>1.81166185472281</c:v>
                </c:pt>
                <c:pt idx="51">
                  <c:v>1.7041209422582999</c:v>
                </c:pt>
                <c:pt idx="52">
                  <c:v>1.9361968734627899</c:v>
                </c:pt>
                <c:pt idx="53">
                  <c:v>1.9106072458914201</c:v>
                </c:pt>
                <c:pt idx="54">
                  <c:v>2.0200890609507902</c:v>
                </c:pt>
                <c:pt idx="55">
                  <c:v>1.97039799088948</c:v>
                </c:pt>
                <c:pt idx="56">
                  <c:v>1.8467502027394</c:v>
                </c:pt>
                <c:pt idx="57">
                  <c:v>1.7346403602059599</c:v>
                </c:pt>
                <c:pt idx="58">
                  <c:v>2.12358934842434</c:v>
                </c:pt>
                <c:pt idx="59">
                  <c:v>1.6346092973995101</c:v>
                </c:pt>
                <c:pt idx="60">
                  <c:v>1.87417214467353</c:v>
                </c:pt>
                <c:pt idx="61">
                  <c:v>1.85422203613851</c:v>
                </c:pt>
                <c:pt idx="62">
                  <c:v>1.8030624897074199</c:v>
                </c:pt>
                <c:pt idx="63">
                  <c:v>1.5354535597718</c:v>
                </c:pt>
                <c:pt idx="64">
                  <c:v>1.91632833469139</c:v>
                </c:pt>
                <c:pt idx="65">
                  <c:v>1.9368576242945601</c:v>
                </c:pt>
                <c:pt idx="66">
                  <c:v>1.8220545304192499</c:v>
                </c:pt>
                <c:pt idx="67">
                  <c:v>1.74041815710318</c:v>
                </c:pt>
                <c:pt idx="68">
                  <c:v>1.76879231004511</c:v>
                </c:pt>
                <c:pt idx="69">
                  <c:v>1.84621861895923</c:v>
                </c:pt>
                <c:pt idx="70">
                  <c:v>1.3222299666264301</c:v>
                </c:pt>
                <c:pt idx="71">
                  <c:v>1.4219693251291801</c:v>
                </c:pt>
                <c:pt idx="72">
                  <c:v>1.82177433640764</c:v>
                </c:pt>
                <c:pt idx="73">
                  <c:v>1.7355852174356301</c:v>
                </c:pt>
                <c:pt idx="74">
                  <c:v>2.01073856889127</c:v>
                </c:pt>
                <c:pt idx="75">
                  <c:v>1.68098569790742</c:v>
                </c:pt>
                <c:pt idx="76">
                  <c:v>2.0346460050735198</c:v>
                </c:pt>
                <c:pt idx="77">
                  <c:v>1.65299196964128</c:v>
                </c:pt>
                <c:pt idx="78">
                  <c:v>1.88378769489263</c:v>
                </c:pt>
                <c:pt idx="79">
                  <c:v>1.5881369712476701</c:v>
                </c:pt>
                <c:pt idx="80">
                  <c:v>1.9504232612763699</c:v>
                </c:pt>
                <c:pt idx="81">
                  <c:v>1.93512935165072</c:v>
                </c:pt>
                <c:pt idx="82">
                  <c:v>1.5681378797783601</c:v>
                </c:pt>
                <c:pt idx="83">
                  <c:v>1.9318026244191899</c:v>
                </c:pt>
                <c:pt idx="84">
                  <c:v>1.83304422072383</c:v>
                </c:pt>
                <c:pt idx="85">
                  <c:v>1.5465764941404001</c:v>
                </c:pt>
                <c:pt idx="86">
                  <c:v>1.8542762659738601</c:v>
                </c:pt>
                <c:pt idx="87">
                  <c:v>1.51950820271164</c:v>
                </c:pt>
                <c:pt idx="88">
                  <c:v>1.4773204686421899</c:v>
                </c:pt>
                <c:pt idx="89">
                  <c:v>1.6627975023669599</c:v>
                </c:pt>
                <c:pt idx="90">
                  <c:v>1.59377629840827</c:v>
                </c:pt>
                <c:pt idx="91">
                  <c:v>1.8306917792417601</c:v>
                </c:pt>
                <c:pt idx="92">
                  <c:v>2.0171573556941498</c:v>
                </c:pt>
                <c:pt idx="93">
                  <c:v>1.7527894236024999</c:v>
                </c:pt>
                <c:pt idx="94">
                  <c:v>1.9082434771974499</c:v>
                </c:pt>
                <c:pt idx="95">
                  <c:v>1.82066406780708</c:v>
                </c:pt>
                <c:pt idx="96">
                  <c:v>1.6545354299021899</c:v>
                </c:pt>
                <c:pt idx="97">
                  <c:v>1.9928654883988699</c:v>
                </c:pt>
                <c:pt idx="98">
                  <c:v>1.94982011923141</c:v>
                </c:pt>
                <c:pt idx="99">
                  <c:v>1.81903263314417</c:v>
                </c:pt>
                <c:pt idx="100">
                  <c:v>1.8417376869358</c:v>
                </c:pt>
                <c:pt idx="101">
                  <c:v>2.0450800256321102</c:v>
                </c:pt>
                <c:pt idx="102">
                  <c:v>1.84418860838989</c:v>
                </c:pt>
                <c:pt idx="103">
                  <c:v>1.9732868303147999</c:v>
                </c:pt>
                <c:pt idx="104">
                  <c:v>1.8549707708128</c:v>
                </c:pt>
                <c:pt idx="105">
                  <c:v>1.75138070050656</c:v>
                </c:pt>
                <c:pt idx="106">
                  <c:v>2.0175691555789199</c:v>
                </c:pt>
                <c:pt idx="107">
                  <c:v>1.9400755300450401</c:v>
                </c:pt>
                <c:pt idx="108">
                  <c:v>1.7777680620329499</c:v>
                </c:pt>
                <c:pt idx="109">
                  <c:v>1.9854869271028901</c:v>
                </c:pt>
                <c:pt idx="110">
                  <c:v>2.00553346313461</c:v>
                </c:pt>
                <c:pt idx="111">
                  <c:v>1.95847686286115</c:v>
                </c:pt>
                <c:pt idx="112">
                  <c:v>1.90572372033077</c:v>
                </c:pt>
                <c:pt idx="113">
                  <c:v>1.82742534943956</c:v>
                </c:pt>
                <c:pt idx="114">
                  <c:v>1.8860405852101401</c:v>
                </c:pt>
                <c:pt idx="115">
                  <c:v>1.9312865845757501</c:v>
                </c:pt>
                <c:pt idx="116">
                  <c:v>1.9011649717489101</c:v>
                </c:pt>
                <c:pt idx="117">
                  <c:v>1.56545514239844</c:v>
                </c:pt>
                <c:pt idx="118">
                  <c:v>2.0249641211773102</c:v>
                </c:pt>
                <c:pt idx="119">
                  <c:v>1.81894135779052</c:v>
                </c:pt>
                <c:pt idx="120">
                  <c:v>1.8492610918172101</c:v>
                </c:pt>
                <c:pt idx="121">
                  <c:v>1.7581547536545801</c:v>
                </c:pt>
                <c:pt idx="122">
                  <c:v>1.89947138083129</c:v>
                </c:pt>
                <c:pt idx="123">
                  <c:v>1.9211714441118899</c:v>
                </c:pt>
                <c:pt idx="124">
                  <c:v>1.91636757148488</c:v>
                </c:pt>
                <c:pt idx="125">
                  <c:v>1.6563111108575601</c:v>
                </c:pt>
                <c:pt idx="126">
                  <c:v>2.0574569678163299</c:v>
                </c:pt>
                <c:pt idx="127">
                  <c:v>1.9686530605193899</c:v>
                </c:pt>
                <c:pt idx="128">
                  <c:v>1.9942142787762001</c:v>
                </c:pt>
                <c:pt idx="129">
                  <c:v>1.93120872543206</c:v>
                </c:pt>
                <c:pt idx="130">
                  <c:v>1.9744745502157499</c:v>
                </c:pt>
                <c:pt idx="131">
                  <c:v>1.9004596048159099</c:v>
                </c:pt>
                <c:pt idx="132">
                  <c:v>1.8627672120015399</c:v>
                </c:pt>
                <c:pt idx="133">
                  <c:v>1.80622938048029</c:v>
                </c:pt>
                <c:pt idx="134">
                  <c:v>1.8998487661233801</c:v>
                </c:pt>
                <c:pt idx="135">
                  <c:v>1.88181625961322</c:v>
                </c:pt>
                <c:pt idx="136">
                  <c:v>1.7588582350633599</c:v>
                </c:pt>
                <c:pt idx="137">
                  <c:v>2.0656274437509801</c:v>
                </c:pt>
                <c:pt idx="138">
                  <c:v>1.74680051640028</c:v>
                </c:pt>
                <c:pt idx="139">
                  <c:v>1.83843890021457</c:v>
                </c:pt>
                <c:pt idx="140">
                  <c:v>2.04975500026806</c:v>
                </c:pt>
                <c:pt idx="141">
                  <c:v>1.80504541417125</c:v>
                </c:pt>
                <c:pt idx="142">
                  <c:v>1.71181531061667</c:v>
                </c:pt>
                <c:pt idx="143">
                  <c:v>1.83495407387293</c:v>
                </c:pt>
                <c:pt idx="144">
                  <c:v>2.0722159079888698</c:v>
                </c:pt>
                <c:pt idx="145">
                  <c:v>1.7605271816341901</c:v>
                </c:pt>
                <c:pt idx="146">
                  <c:v>1.8385540749679099</c:v>
                </c:pt>
                <c:pt idx="147">
                  <c:v>1.9395523269391901</c:v>
                </c:pt>
                <c:pt idx="148">
                  <c:v>1.8817466502612401</c:v>
                </c:pt>
                <c:pt idx="149">
                  <c:v>2.0029700837291999</c:v>
                </c:pt>
                <c:pt idx="150">
                  <c:v>1.9169942760041201</c:v>
                </c:pt>
                <c:pt idx="151">
                  <c:v>1.6762651550901599</c:v>
                </c:pt>
                <c:pt idx="152">
                  <c:v>2.1285714460797398</c:v>
                </c:pt>
                <c:pt idx="153">
                  <c:v>1.7557952660652001</c:v>
                </c:pt>
                <c:pt idx="154">
                  <c:v>2.0232374929163002</c:v>
                </c:pt>
                <c:pt idx="155">
                  <c:v>1.82994438662389</c:v>
                </c:pt>
                <c:pt idx="156">
                  <c:v>1.8705402302183001</c:v>
                </c:pt>
                <c:pt idx="157">
                  <c:v>1.7611456611028999</c:v>
                </c:pt>
                <c:pt idx="158">
                  <c:v>2.05372745205996</c:v>
                </c:pt>
                <c:pt idx="159">
                  <c:v>1.9017550743064999</c:v>
                </c:pt>
                <c:pt idx="160">
                  <c:v>2.0110820211154099</c:v>
                </c:pt>
                <c:pt idx="161">
                  <c:v>1.8343554947538201</c:v>
                </c:pt>
                <c:pt idx="162">
                  <c:v>2.1105719032409702</c:v>
                </c:pt>
                <c:pt idx="163">
                  <c:v>1.9954984073872799</c:v>
                </c:pt>
                <c:pt idx="164">
                  <c:v>2.0009946215227399</c:v>
                </c:pt>
                <c:pt idx="165">
                  <c:v>1.92880344740633</c:v>
                </c:pt>
                <c:pt idx="166">
                  <c:v>1.89736600471564</c:v>
                </c:pt>
                <c:pt idx="167">
                  <c:v>1.8123375442362</c:v>
                </c:pt>
                <c:pt idx="168">
                  <c:v>1.90535740428956</c:v>
                </c:pt>
                <c:pt idx="169">
                  <c:v>2.0293945647387499</c:v>
                </c:pt>
                <c:pt idx="170">
                  <c:v>1.8160173519824001</c:v>
                </c:pt>
                <c:pt idx="171">
                  <c:v>1.9047849530200001</c:v>
                </c:pt>
                <c:pt idx="172">
                  <c:v>2.0431395588657</c:v>
                </c:pt>
                <c:pt idx="173">
                  <c:v>1.7178993474386099</c:v>
                </c:pt>
                <c:pt idx="174">
                  <c:v>2.1159657033002701</c:v>
                </c:pt>
                <c:pt idx="175">
                  <c:v>1.7784014888759201</c:v>
                </c:pt>
                <c:pt idx="176">
                  <c:v>1.9641738847207</c:v>
                </c:pt>
                <c:pt idx="177">
                  <c:v>2.0603620852267301</c:v>
                </c:pt>
                <c:pt idx="178">
                  <c:v>1.9078319004727999</c:v>
                </c:pt>
                <c:pt idx="179">
                  <c:v>2.0263851619531201</c:v>
                </c:pt>
                <c:pt idx="180">
                  <c:v>1.7492483408722299</c:v>
                </c:pt>
                <c:pt idx="181">
                  <c:v>1.8963033586356299</c:v>
                </c:pt>
                <c:pt idx="182">
                  <c:v>1.9995072884313501</c:v>
                </c:pt>
                <c:pt idx="183">
                  <c:v>1.2967169220466801</c:v>
                </c:pt>
                <c:pt idx="184">
                  <c:v>1.8705032032067299</c:v>
                </c:pt>
                <c:pt idx="185">
                  <c:v>2.0026024710650101</c:v>
                </c:pt>
                <c:pt idx="186">
                  <c:v>1.84165645054547</c:v>
                </c:pt>
                <c:pt idx="187">
                  <c:v>1.84581562839867</c:v>
                </c:pt>
                <c:pt idx="188">
                  <c:v>1.9227544130660099</c:v>
                </c:pt>
                <c:pt idx="189">
                  <c:v>1.78451786911008</c:v>
                </c:pt>
                <c:pt idx="190">
                  <c:v>2.0308863829397001</c:v>
                </c:pt>
                <c:pt idx="191">
                  <c:v>1.89316111103239</c:v>
                </c:pt>
                <c:pt idx="192">
                  <c:v>2.02192072798305</c:v>
                </c:pt>
                <c:pt idx="193">
                  <c:v>1.83587347058192</c:v>
                </c:pt>
                <c:pt idx="194">
                  <c:v>1.81327506146267</c:v>
                </c:pt>
                <c:pt idx="195">
                  <c:v>1.7666305339452499</c:v>
                </c:pt>
                <c:pt idx="196">
                  <c:v>1.9386963108447599</c:v>
                </c:pt>
                <c:pt idx="197">
                  <c:v>1.69206729806667</c:v>
                </c:pt>
                <c:pt idx="198">
                  <c:v>2.0964519539264002</c:v>
                </c:pt>
                <c:pt idx="199">
                  <c:v>2.0331410105095098</c:v>
                </c:pt>
                <c:pt idx="200">
                  <c:v>1.56557649917865</c:v>
                </c:pt>
                <c:pt idx="201">
                  <c:v>2.04949843112637</c:v>
                </c:pt>
                <c:pt idx="202">
                  <c:v>1.98968399443474</c:v>
                </c:pt>
                <c:pt idx="203">
                  <c:v>1.7207614442752599</c:v>
                </c:pt>
                <c:pt idx="204">
                  <c:v>1.92846881011894</c:v>
                </c:pt>
                <c:pt idx="205">
                  <c:v>1.6152261506626</c:v>
                </c:pt>
                <c:pt idx="206">
                  <c:v>1.85115105255594</c:v>
                </c:pt>
                <c:pt idx="207">
                  <c:v>1.63387878412081</c:v>
                </c:pt>
                <c:pt idx="208">
                  <c:v>1.8438179652618301</c:v>
                </c:pt>
                <c:pt idx="209">
                  <c:v>1.89484566997314</c:v>
                </c:pt>
                <c:pt idx="210">
                  <c:v>1.9865993164556499</c:v>
                </c:pt>
                <c:pt idx="211">
                  <c:v>1.7483882426872901</c:v>
                </c:pt>
                <c:pt idx="212">
                  <c:v>1.74818788569742</c:v>
                </c:pt>
                <c:pt idx="213">
                  <c:v>1.66274981953871</c:v>
                </c:pt>
                <c:pt idx="214">
                  <c:v>1.8222893183608599</c:v>
                </c:pt>
                <c:pt idx="215">
                  <c:v>1.8347759789095901</c:v>
                </c:pt>
                <c:pt idx="216">
                  <c:v>1.4655991734287701</c:v>
                </c:pt>
                <c:pt idx="217">
                  <c:v>1.6710813222850101</c:v>
                </c:pt>
                <c:pt idx="218">
                  <c:v>1.79584784202351</c:v>
                </c:pt>
                <c:pt idx="219">
                  <c:v>2.0321395383008798</c:v>
                </c:pt>
                <c:pt idx="220">
                  <c:v>1.51667224468178</c:v>
                </c:pt>
                <c:pt idx="221">
                  <c:v>1.80780377748353</c:v>
                </c:pt>
                <c:pt idx="222">
                  <c:v>1.8491045434621001</c:v>
                </c:pt>
                <c:pt idx="223">
                  <c:v>1.7224500188835099</c:v>
                </c:pt>
                <c:pt idx="224">
                  <c:v>1.73361541073546</c:v>
                </c:pt>
                <c:pt idx="225">
                  <c:v>2.0648569317980701</c:v>
                </c:pt>
                <c:pt idx="226">
                  <c:v>1.71716665127659</c:v>
                </c:pt>
                <c:pt idx="227">
                  <c:v>1.5575791254609599</c:v>
                </c:pt>
                <c:pt idx="228">
                  <c:v>2.0160771873971099</c:v>
                </c:pt>
                <c:pt idx="229">
                  <c:v>1.6682010515193</c:v>
                </c:pt>
                <c:pt idx="230">
                  <c:v>1.99624289820921</c:v>
                </c:pt>
                <c:pt idx="231">
                  <c:v>1.8207474692000101</c:v>
                </c:pt>
                <c:pt idx="232">
                  <c:v>1.91393758443303</c:v>
                </c:pt>
                <c:pt idx="233">
                  <c:v>1.9612567304653501</c:v>
                </c:pt>
                <c:pt idx="234">
                  <c:v>1.8192173759960599</c:v>
                </c:pt>
                <c:pt idx="235">
                  <c:v>1.6287341345744499</c:v>
                </c:pt>
                <c:pt idx="236">
                  <c:v>1.95880630997821</c:v>
                </c:pt>
                <c:pt idx="237">
                  <c:v>1.5845034643087701</c:v>
                </c:pt>
                <c:pt idx="238">
                  <c:v>1.77052118504248</c:v>
                </c:pt>
                <c:pt idx="239">
                  <c:v>1.6861945370770299</c:v>
                </c:pt>
                <c:pt idx="240">
                  <c:v>1.9363633693542399</c:v>
                </c:pt>
                <c:pt idx="241">
                  <c:v>1.7536272647534099</c:v>
                </c:pt>
                <c:pt idx="242">
                  <c:v>1.96119386978914</c:v>
                </c:pt>
                <c:pt idx="243">
                  <c:v>1.8670787046066899</c:v>
                </c:pt>
                <c:pt idx="244">
                  <c:v>1.74470987917522</c:v>
                </c:pt>
                <c:pt idx="245">
                  <c:v>1.9605057274994799</c:v>
                </c:pt>
                <c:pt idx="246">
                  <c:v>1.96464804287387</c:v>
                </c:pt>
                <c:pt idx="247">
                  <c:v>1.40422308864165</c:v>
                </c:pt>
                <c:pt idx="248">
                  <c:v>1.8347387843102401</c:v>
                </c:pt>
                <c:pt idx="249">
                  <c:v>1.7984646969976099</c:v>
                </c:pt>
                <c:pt idx="250">
                  <c:v>1.96619735132191</c:v>
                </c:pt>
                <c:pt idx="251">
                  <c:v>1.75434557079863</c:v>
                </c:pt>
                <c:pt idx="252">
                  <c:v>1.82045710447247</c:v>
                </c:pt>
                <c:pt idx="253">
                  <c:v>1.94903801877234</c:v>
                </c:pt>
                <c:pt idx="254">
                  <c:v>2.0043504555535399</c:v>
                </c:pt>
                <c:pt idx="255">
                  <c:v>1.56037665971854</c:v>
                </c:pt>
                <c:pt idx="256">
                  <c:v>1.7576389317523899</c:v>
                </c:pt>
                <c:pt idx="257">
                  <c:v>1.97411228781906</c:v>
                </c:pt>
                <c:pt idx="258">
                  <c:v>1.9766549588786</c:v>
                </c:pt>
                <c:pt idx="259">
                  <c:v>1.86792093179035</c:v>
                </c:pt>
                <c:pt idx="260">
                  <c:v>1.83693143131001</c:v>
                </c:pt>
                <c:pt idx="261">
                  <c:v>1.91488475301322</c:v>
                </c:pt>
                <c:pt idx="262">
                  <c:v>1.8964733533067899</c:v>
                </c:pt>
                <c:pt idx="263">
                  <c:v>1.81581212663165</c:v>
                </c:pt>
                <c:pt idx="264">
                  <c:v>1.6350413624758799</c:v>
                </c:pt>
                <c:pt idx="265">
                  <c:v>1.9244485522607899</c:v>
                </c:pt>
                <c:pt idx="266">
                  <c:v>1.75993954253745</c:v>
                </c:pt>
                <c:pt idx="267">
                  <c:v>1.8332230097981499</c:v>
                </c:pt>
                <c:pt idx="268">
                  <c:v>1.6639081857401501</c:v>
                </c:pt>
                <c:pt idx="269">
                  <c:v>1.8755048526335401</c:v>
                </c:pt>
                <c:pt idx="270">
                  <c:v>1.85929257147018</c:v>
                </c:pt>
                <c:pt idx="271">
                  <c:v>2.0299604639491799</c:v>
                </c:pt>
                <c:pt idx="272">
                  <c:v>1.4749739045100501</c:v>
                </c:pt>
                <c:pt idx="273">
                  <c:v>1.59744381852798</c:v>
                </c:pt>
                <c:pt idx="274">
                  <c:v>2.01830251295149</c:v>
                </c:pt>
                <c:pt idx="275">
                  <c:v>1.9251095118739501</c:v>
                </c:pt>
                <c:pt idx="276">
                  <c:v>1.6885688746563201</c:v>
                </c:pt>
                <c:pt idx="277">
                  <c:v>2.04915188784569</c:v>
                </c:pt>
                <c:pt idx="278">
                  <c:v>1.65099717075435</c:v>
                </c:pt>
                <c:pt idx="279">
                  <c:v>1.9120645506204801</c:v>
                </c:pt>
                <c:pt idx="280">
                  <c:v>1.6074680918879001</c:v>
                </c:pt>
                <c:pt idx="281">
                  <c:v>1.8172396762765599</c:v>
                </c:pt>
                <c:pt idx="282">
                  <c:v>1.8881917197834801</c:v>
                </c:pt>
                <c:pt idx="283">
                  <c:v>2.0334864797066099</c:v>
                </c:pt>
                <c:pt idx="284">
                  <c:v>1.9377642943962201</c:v>
                </c:pt>
                <c:pt idx="285">
                  <c:v>1.89764127371243</c:v>
                </c:pt>
                <c:pt idx="286">
                  <c:v>1.74817238640756</c:v>
                </c:pt>
                <c:pt idx="287">
                  <c:v>2.13857986510398</c:v>
                </c:pt>
                <c:pt idx="288">
                  <c:v>2.00437446713936</c:v>
                </c:pt>
                <c:pt idx="289">
                  <c:v>1.9162917026595301</c:v>
                </c:pt>
                <c:pt idx="290">
                  <c:v>1.91550380524889</c:v>
                </c:pt>
                <c:pt idx="291">
                  <c:v>1.8842830457023501</c:v>
                </c:pt>
              </c:numCache>
            </c:numRef>
          </c:xVal>
          <c:yVal>
            <c:numRef>
              <c:f>'292RIL'!$K$2:$K$295</c:f>
              <c:numCache>
                <c:formatCode>0.00</c:formatCode>
                <c:ptCount val="294"/>
                <c:pt idx="0">
                  <c:v>62.228763290178101</c:v>
                </c:pt>
                <c:pt idx="1">
                  <c:v>58.398647092707797</c:v>
                </c:pt>
                <c:pt idx="2">
                  <c:v>67.938251841318902</c:v>
                </c:pt>
                <c:pt idx="3">
                  <c:v>77.704187246374104</c:v>
                </c:pt>
                <c:pt idx="4">
                  <c:v>56.936607797670803</c:v>
                </c:pt>
                <c:pt idx="5">
                  <c:v>58.6647073822975</c:v>
                </c:pt>
                <c:pt idx="6">
                  <c:v>72.223810597963293</c:v>
                </c:pt>
                <c:pt idx="7">
                  <c:v>67.243567647199598</c:v>
                </c:pt>
                <c:pt idx="8">
                  <c:v>47.9022004663384</c:v>
                </c:pt>
                <c:pt idx="9">
                  <c:v>62.425342227148498</c:v>
                </c:pt>
                <c:pt idx="10">
                  <c:v>58.003269178974499</c:v>
                </c:pt>
                <c:pt idx="11">
                  <c:v>55.729957707818201</c:v>
                </c:pt>
                <c:pt idx="12">
                  <c:v>68.929132899682799</c:v>
                </c:pt>
                <c:pt idx="13">
                  <c:v>69.467349869445997</c:v>
                </c:pt>
                <c:pt idx="14">
                  <c:v>43.955886393952802</c:v>
                </c:pt>
                <c:pt idx="15">
                  <c:v>48.3969850559291</c:v>
                </c:pt>
                <c:pt idx="16">
                  <c:v>47.734581566811499</c:v>
                </c:pt>
                <c:pt idx="17">
                  <c:v>53.963149336327</c:v>
                </c:pt>
                <c:pt idx="18">
                  <c:v>60.474570657113397</c:v>
                </c:pt>
                <c:pt idx="19">
                  <c:v>52.714785172957697</c:v>
                </c:pt>
                <c:pt idx="20">
                  <c:v>50.551641525222799</c:v>
                </c:pt>
                <c:pt idx="21">
                  <c:v>44.936317781137397</c:v>
                </c:pt>
                <c:pt idx="22">
                  <c:v>67.180766436604998</c:v>
                </c:pt>
                <c:pt idx="23">
                  <c:v>43.189913444553198</c:v>
                </c:pt>
                <c:pt idx="24">
                  <c:v>60.411170331965799</c:v>
                </c:pt>
                <c:pt idx="25">
                  <c:v>14.947028411218801</c:v>
                </c:pt>
                <c:pt idx="26">
                  <c:v>61.254846791595099</c:v>
                </c:pt>
                <c:pt idx="27">
                  <c:v>60.001715008676399</c:v>
                </c:pt>
                <c:pt idx="28">
                  <c:v>55.673661293305898</c:v>
                </c:pt>
                <c:pt idx="29">
                  <c:v>42.747807207142202</c:v>
                </c:pt>
                <c:pt idx="30">
                  <c:v>59.312503195903602</c:v>
                </c:pt>
                <c:pt idx="31">
                  <c:v>47.9983750350425</c:v>
                </c:pt>
                <c:pt idx="32">
                  <c:v>77.322276540066696</c:v>
                </c:pt>
                <c:pt idx="33">
                  <c:v>62.775785928698298</c:v>
                </c:pt>
                <c:pt idx="34">
                  <c:v>50.822938767402597</c:v>
                </c:pt>
                <c:pt idx="35">
                  <c:v>42.887768697559103</c:v>
                </c:pt>
                <c:pt idx="36">
                  <c:v>69.030662323876797</c:v>
                </c:pt>
                <c:pt idx="37">
                  <c:v>55.334032984598799</c:v>
                </c:pt>
                <c:pt idx="38">
                  <c:v>49.673041508934098</c:v>
                </c:pt>
                <c:pt idx="39">
                  <c:v>65.713870125904194</c:v>
                </c:pt>
                <c:pt idx="40">
                  <c:v>67.514002975373003</c:v>
                </c:pt>
                <c:pt idx="41">
                  <c:v>63.167526608214402</c:v>
                </c:pt>
                <c:pt idx="42">
                  <c:v>50.186291154217301</c:v>
                </c:pt>
                <c:pt idx="43">
                  <c:v>34.023256329648902</c:v>
                </c:pt>
                <c:pt idx="44">
                  <c:v>66.426277180282995</c:v>
                </c:pt>
                <c:pt idx="45">
                  <c:v>37.049953932151901</c:v>
                </c:pt>
                <c:pt idx="46">
                  <c:v>23.130219489150502</c:v>
                </c:pt>
                <c:pt idx="47">
                  <c:v>62.599536814255003</c:v>
                </c:pt>
                <c:pt idx="48">
                  <c:v>63.951103420073203</c:v>
                </c:pt>
                <c:pt idx="49">
                  <c:v>45.035331177826997</c:v>
                </c:pt>
                <c:pt idx="50">
                  <c:v>59.989490169730601</c:v>
                </c:pt>
                <c:pt idx="51">
                  <c:v>44.920242687760599</c:v>
                </c:pt>
                <c:pt idx="52">
                  <c:v>73.190256658584403</c:v>
                </c:pt>
                <c:pt idx="53">
                  <c:v>69.259823719268496</c:v>
                </c:pt>
                <c:pt idx="54">
                  <c:v>70.106101221638397</c:v>
                </c:pt>
                <c:pt idx="55">
                  <c:v>53.128841810669499</c:v>
                </c:pt>
                <c:pt idx="56">
                  <c:v>57.182594448297699</c:v>
                </c:pt>
                <c:pt idx="57">
                  <c:v>45.185689781243902</c:v>
                </c:pt>
                <c:pt idx="58">
                  <c:v>48.567972620586097</c:v>
                </c:pt>
                <c:pt idx="59">
                  <c:v>33.939468697867902</c:v>
                </c:pt>
                <c:pt idx="60">
                  <c:v>72.375143850000796</c:v>
                </c:pt>
                <c:pt idx="61">
                  <c:v>65.615017756812307</c:v>
                </c:pt>
                <c:pt idx="62">
                  <c:v>67.267258905588804</c:v>
                </c:pt>
                <c:pt idx="63">
                  <c:v>33.415359570950301</c:v>
                </c:pt>
                <c:pt idx="64">
                  <c:v>54.817736838917902</c:v>
                </c:pt>
                <c:pt idx="65">
                  <c:v>54.9046756138464</c:v>
                </c:pt>
                <c:pt idx="66">
                  <c:v>63.3775490974256</c:v>
                </c:pt>
                <c:pt idx="67">
                  <c:v>57.305730991656603</c:v>
                </c:pt>
                <c:pt idx="68">
                  <c:v>43.762730952829003</c:v>
                </c:pt>
                <c:pt idx="69">
                  <c:v>47.346116856653602</c:v>
                </c:pt>
                <c:pt idx="70">
                  <c:v>26.117868609791302</c:v>
                </c:pt>
                <c:pt idx="71">
                  <c:v>31.070496911565801</c:v>
                </c:pt>
                <c:pt idx="72">
                  <c:v>55.4780246612479</c:v>
                </c:pt>
                <c:pt idx="73">
                  <c:v>43.838755589278101</c:v>
                </c:pt>
                <c:pt idx="74">
                  <c:v>68.231644802832903</c:v>
                </c:pt>
                <c:pt idx="75">
                  <c:v>69.388084225036195</c:v>
                </c:pt>
                <c:pt idx="76">
                  <c:v>68.083686893998504</c:v>
                </c:pt>
                <c:pt idx="77">
                  <c:v>57.362631083849102</c:v>
                </c:pt>
                <c:pt idx="78">
                  <c:v>69.581218258306194</c:v>
                </c:pt>
                <c:pt idx="79">
                  <c:v>38.525775575964502</c:v>
                </c:pt>
                <c:pt idx="80">
                  <c:v>49.919442690220897</c:v>
                </c:pt>
                <c:pt idx="81">
                  <c:v>89.761608279646296</c:v>
                </c:pt>
                <c:pt idx="82">
                  <c:v>51.340608176601698</c:v>
                </c:pt>
                <c:pt idx="83">
                  <c:v>62.142554170048399</c:v>
                </c:pt>
                <c:pt idx="84">
                  <c:v>49.124964017840199</c:v>
                </c:pt>
                <c:pt idx="85">
                  <c:v>45.430878908599098</c:v>
                </c:pt>
                <c:pt idx="86">
                  <c:v>47.049721019486</c:v>
                </c:pt>
                <c:pt idx="87">
                  <c:v>40.076064527809898</c:v>
                </c:pt>
                <c:pt idx="88">
                  <c:v>30.7061183580327</c:v>
                </c:pt>
                <c:pt idx="89">
                  <c:v>53.6896236086492</c:v>
                </c:pt>
                <c:pt idx="90">
                  <c:v>45.262596811130699</c:v>
                </c:pt>
                <c:pt idx="91">
                  <c:v>49.722699699847801</c:v>
                </c:pt>
                <c:pt idx="92">
                  <c:v>68.268541944572405</c:v>
                </c:pt>
                <c:pt idx="93">
                  <c:v>56.943895381656198</c:v>
                </c:pt>
                <c:pt idx="94">
                  <c:v>64.804536499389002</c:v>
                </c:pt>
                <c:pt idx="95">
                  <c:v>49.906490528587199</c:v>
                </c:pt>
                <c:pt idx="96">
                  <c:v>41.599505592842704</c:v>
                </c:pt>
                <c:pt idx="97">
                  <c:v>55.2793148864179</c:v>
                </c:pt>
                <c:pt idx="98">
                  <c:v>67.831219248816097</c:v>
                </c:pt>
                <c:pt idx="99">
                  <c:v>71.852658229553597</c:v>
                </c:pt>
                <c:pt idx="100">
                  <c:v>62.1780589325164</c:v>
                </c:pt>
                <c:pt idx="101">
                  <c:v>44.665967511131598</c:v>
                </c:pt>
                <c:pt idx="102">
                  <c:v>73.896059301193006</c:v>
                </c:pt>
                <c:pt idx="103">
                  <c:v>51.969808160613098</c:v>
                </c:pt>
                <c:pt idx="104">
                  <c:v>59.393827564406998</c:v>
                </c:pt>
                <c:pt idx="105">
                  <c:v>46.437239872607002</c:v>
                </c:pt>
                <c:pt idx="106">
                  <c:v>59.838093580451797</c:v>
                </c:pt>
                <c:pt idx="107">
                  <c:v>61.675437469304299</c:v>
                </c:pt>
                <c:pt idx="108">
                  <c:v>64.873179933953097</c:v>
                </c:pt>
                <c:pt idx="109">
                  <c:v>60.998117668349103</c:v>
                </c:pt>
                <c:pt idx="110">
                  <c:v>57.776651778437802</c:v>
                </c:pt>
                <c:pt idx="111">
                  <c:v>53.749096416363997</c:v>
                </c:pt>
                <c:pt idx="112">
                  <c:v>40.455178520760398</c:v>
                </c:pt>
                <c:pt idx="113">
                  <c:v>64.979086326752693</c:v>
                </c:pt>
                <c:pt idx="114">
                  <c:v>54.117925526048801</c:v>
                </c:pt>
                <c:pt idx="115">
                  <c:v>69.756545713984494</c:v>
                </c:pt>
                <c:pt idx="116">
                  <c:v>68.937362637230194</c:v>
                </c:pt>
                <c:pt idx="117">
                  <c:v>53.086813767324202</c:v>
                </c:pt>
                <c:pt idx="118">
                  <c:v>68.747217221871495</c:v>
                </c:pt>
                <c:pt idx="119">
                  <c:v>53.652322233267</c:v>
                </c:pt>
                <c:pt idx="120">
                  <c:v>65.406771279427005</c:v>
                </c:pt>
                <c:pt idx="121">
                  <c:v>45.3188378110587</c:v>
                </c:pt>
                <c:pt idx="122">
                  <c:v>51.962019015966298</c:v>
                </c:pt>
                <c:pt idx="123">
                  <c:v>70.548300095799306</c:v>
                </c:pt>
                <c:pt idx="124">
                  <c:v>66.433985291178004</c:v>
                </c:pt>
                <c:pt idx="125">
                  <c:v>52.698567142806802</c:v>
                </c:pt>
                <c:pt idx="126">
                  <c:v>74.992422026640895</c:v>
                </c:pt>
                <c:pt idx="127">
                  <c:v>74.9687675728199</c:v>
                </c:pt>
                <c:pt idx="128">
                  <c:v>71.390415778272697</c:v>
                </c:pt>
                <c:pt idx="129">
                  <c:v>57.8144598550194</c:v>
                </c:pt>
                <c:pt idx="130">
                  <c:v>60.8634070558237</c:v>
                </c:pt>
                <c:pt idx="131">
                  <c:v>67.151010397833105</c:v>
                </c:pt>
                <c:pt idx="132">
                  <c:v>47.760218798772101</c:v>
                </c:pt>
                <c:pt idx="133">
                  <c:v>54.723426478951602</c:v>
                </c:pt>
                <c:pt idx="134">
                  <c:v>53.324767312468303</c:v>
                </c:pt>
                <c:pt idx="135">
                  <c:v>68.716062737809693</c:v>
                </c:pt>
                <c:pt idx="136">
                  <c:v>60.690622176783499</c:v>
                </c:pt>
                <c:pt idx="137">
                  <c:v>73.2726824605584</c:v>
                </c:pt>
                <c:pt idx="138">
                  <c:v>48.907363720225497</c:v>
                </c:pt>
                <c:pt idx="139">
                  <c:v>56.5282803310741</c:v>
                </c:pt>
                <c:pt idx="140">
                  <c:v>60.494691742409699</c:v>
                </c:pt>
                <c:pt idx="141">
                  <c:v>52.182556029250598</c:v>
                </c:pt>
                <c:pt idx="142">
                  <c:v>54.684124062309102</c:v>
                </c:pt>
                <c:pt idx="143">
                  <c:v>67.619307090393207</c:v>
                </c:pt>
                <c:pt idx="144">
                  <c:v>81.526557176821697</c:v>
                </c:pt>
                <c:pt idx="145">
                  <c:v>68.515192646184104</c:v>
                </c:pt>
                <c:pt idx="146">
                  <c:v>58.534088171506497</c:v>
                </c:pt>
                <c:pt idx="147">
                  <c:v>71.400439720775196</c:v>
                </c:pt>
                <c:pt idx="148">
                  <c:v>75.839446066971306</c:v>
                </c:pt>
                <c:pt idx="149">
                  <c:v>53.143145413158202</c:v>
                </c:pt>
                <c:pt idx="150">
                  <c:v>77.876863084471594</c:v>
                </c:pt>
                <c:pt idx="151">
                  <c:v>47.682791215634801</c:v>
                </c:pt>
                <c:pt idx="152">
                  <c:v>76.746646656122493</c:v>
                </c:pt>
                <c:pt idx="153">
                  <c:v>39.852888155989397</c:v>
                </c:pt>
                <c:pt idx="154">
                  <c:v>53.453998817307202</c:v>
                </c:pt>
                <c:pt idx="155">
                  <c:v>57.708977902140496</c:v>
                </c:pt>
                <c:pt idx="156">
                  <c:v>46.9863920382953</c:v>
                </c:pt>
                <c:pt idx="157">
                  <c:v>55.051136690148702</c:v>
                </c:pt>
                <c:pt idx="158">
                  <c:v>76.917340308128104</c:v>
                </c:pt>
                <c:pt idx="159">
                  <c:v>54.586982260412398</c:v>
                </c:pt>
                <c:pt idx="160">
                  <c:v>72.523284204896996</c:v>
                </c:pt>
                <c:pt idx="161">
                  <c:v>55.345648018814998</c:v>
                </c:pt>
                <c:pt idx="162">
                  <c:v>68.170838633156194</c:v>
                </c:pt>
                <c:pt idx="163">
                  <c:v>78.481274906535901</c:v>
                </c:pt>
                <c:pt idx="164">
                  <c:v>65.587733497379702</c:v>
                </c:pt>
                <c:pt idx="165">
                  <c:v>66.265035589739995</c:v>
                </c:pt>
                <c:pt idx="166">
                  <c:v>50.801745052524197</c:v>
                </c:pt>
                <c:pt idx="167">
                  <c:v>42.737939090985897</c:v>
                </c:pt>
                <c:pt idx="168">
                  <c:v>76.994456563937703</c:v>
                </c:pt>
                <c:pt idx="169">
                  <c:v>67.865986734055994</c:v>
                </c:pt>
                <c:pt idx="170">
                  <c:v>61.558470737030298</c:v>
                </c:pt>
                <c:pt idx="171">
                  <c:v>49.603164956258297</c:v>
                </c:pt>
                <c:pt idx="172">
                  <c:v>55.945418222928602</c:v>
                </c:pt>
                <c:pt idx="173">
                  <c:v>53.7932613890356</c:v>
                </c:pt>
                <c:pt idx="174">
                  <c:v>62.649828718977702</c:v>
                </c:pt>
                <c:pt idx="175">
                  <c:v>57.636055591277703</c:v>
                </c:pt>
                <c:pt idx="176">
                  <c:v>52.636521659307903</c:v>
                </c:pt>
                <c:pt idx="177">
                  <c:v>74.939789527598506</c:v>
                </c:pt>
                <c:pt idx="178">
                  <c:v>61.9327308905781</c:v>
                </c:pt>
                <c:pt idx="179">
                  <c:v>73.705330053414301</c:v>
                </c:pt>
                <c:pt idx="180">
                  <c:v>53.455930775373602</c:v>
                </c:pt>
                <c:pt idx="181">
                  <c:v>55.319810916211601</c:v>
                </c:pt>
                <c:pt idx="182">
                  <c:v>66.918111511030503</c:v>
                </c:pt>
                <c:pt idx="183">
                  <c:v>34.500168144843798</c:v>
                </c:pt>
                <c:pt idx="184">
                  <c:v>59.8671515487977</c:v>
                </c:pt>
                <c:pt idx="185">
                  <c:v>60.272865517870599</c:v>
                </c:pt>
                <c:pt idx="186">
                  <c:v>58.519176591984497</c:v>
                </c:pt>
                <c:pt idx="187">
                  <c:v>68.522972826877904</c:v>
                </c:pt>
                <c:pt idx="188">
                  <c:v>64.822843823809706</c:v>
                </c:pt>
                <c:pt idx="189">
                  <c:v>54.522125727556102</c:v>
                </c:pt>
                <c:pt idx="190">
                  <c:v>52.424747538961</c:v>
                </c:pt>
                <c:pt idx="191">
                  <c:v>52.471069252183</c:v>
                </c:pt>
                <c:pt idx="192">
                  <c:v>63.076170525134003</c:v>
                </c:pt>
                <c:pt idx="193">
                  <c:v>51.943395406610598</c:v>
                </c:pt>
                <c:pt idx="194">
                  <c:v>49.5141927031774</c:v>
                </c:pt>
                <c:pt idx="195">
                  <c:v>50.661701913418703</c:v>
                </c:pt>
                <c:pt idx="196">
                  <c:v>73.346381089243394</c:v>
                </c:pt>
                <c:pt idx="197">
                  <c:v>68.126170211203103</c:v>
                </c:pt>
                <c:pt idx="198">
                  <c:v>48.661076108408203</c:v>
                </c:pt>
                <c:pt idx="199">
                  <c:v>77.443033621398598</c:v>
                </c:pt>
                <c:pt idx="200">
                  <c:v>39.594267115784298</c:v>
                </c:pt>
                <c:pt idx="201">
                  <c:v>55.441086830721098</c:v>
                </c:pt>
                <c:pt idx="202">
                  <c:v>66.357265447804295</c:v>
                </c:pt>
                <c:pt idx="203">
                  <c:v>48.799422674181201</c:v>
                </c:pt>
                <c:pt idx="204">
                  <c:v>57.315104505564399</c:v>
                </c:pt>
                <c:pt idx="205">
                  <c:v>39.572211267588997</c:v>
                </c:pt>
                <c:pt idx="206">
                  <c:v>64.57069229679</c:v>
                </c:pt>
                <c:pt idx="207">
                  <c:v>44.3883794588074</c:v>
                </c:pt>
                <c:pt idx="208">
                  <c:v>55.7383861014887</c:v>
                </c:pt>
                <c:pt idx="209">
                  <c:v>55.409576347470797</c:v>
                </c:pt>
                <c:pt idx="210">
                  <c:v>59.578954766288497</c:v>
                </c:pt>
                <c:pt idx="211">
                  <c:v>49.5773399118832</c:v>
                </c:pt>
                <c:pt idx="212">
                  <c:v>52.4861316331965</c:v>
                </c:pt>
                <c:pt idx="213">
                  <c:v>42.7484113559183</c:v>
                </c:pt>
                <c:pt idx="214">
                  <c:v>57.747543127763599</c:v>
                </c:pt>
                <c:pt idx="215">
                  <c:v>71.176194423315494</c:v>
                </c:pt>
                <c:pt idx="216">
                  <c:v>30.479741215353101</c:v>
                </c:pt>
                <c:pt idx="217">
                  <c:v>44.804707868781101</c:v>
                </c:pt>
                <c:pt idx="218">
                  <c:v>50.571895257805103</c:v>
                </c:pt>
                <c:pt idx="219">
                  <c:v>59.285973094934299</c:v>
                </c:pt>
                <c:pt idx="220">
                  <c:v>34.4449869989771</c:v>
                </c:pt>
                <c:pt idx="221">
                  <c:v>53.147252028784997</c:v>
                </c:pt>
                <c:pt idx="222">
                  <c:v>61.872547565668597</c:v>
                </c:pt>
                <c:pt idx="223">
                  <c:v>38.349082435517801</c:v>
                </c:pt>
                <c:pt idx="224">
                  <c:v>57.994836855047197</c:v>
                </c:pt>
                <c:pt idx="225">
                  <c:v>77.542772529837293</c:v>
                </c:pt>
                <c:pt idx="226">
                  <c:v>48.5024956142043</c:v>
                </c:pt>
                <c:pt idx="227">
                  <c:v>36.675650741849701</c:v>
                </c:pt>
                <c:pt idx="228">
                  <c:v>68.841882979556701</c:v>
                </c:pt>
                <c:pt idx="229">
                  <c:v>53.469246146117101</c:v>
                </c:pt>
                <c:pt idx="230">
                  <c:v>77.146725226679294</c:v>
                </c:pt>
                <c:pt idx="231">
                  <c:v>49.714573677847703</c:v>
                </c:pt>
                <c:pt idx="232">
                  <c:v>72.1452047833872</c:v>
                </c:pt>
                <c:pt idx="233">
                  <c:v>61.224105229271203</c:v>
                </c:pt>
                <c:pt idx="234">
                  <c:v>54.831143955502</c:v>
                </c:pt>
                <c:pt idx="235">
                  <c:v>58.123288810507901</c:v>
                </c:pt>
                <c:pt idx="236">
                  <c:v>65.820666996051798</c:v>
                </c:pt>
                <c:pt idx="237">
                  <c:v>27.862315334933701</c:v>
                </c:pt>
                <c:pt idx="238">
                  <c:v>50.547663718224797</c:v>
                </c:pt>
                <c:pt idx="239">
                  <c:v>53.347964102649797</c:v>
                </c:pt>
                <c:pt idx="240">
                  <c:v>55.738785724877097</c:v>
                </c:pt>
                <c:pt idx="241">
                  <c:v>53.761862205532097</c:v>
                </c:pt>
                <c:pt idx="242">
                  <c:v>51.165547311828398</c:v>
                </c:pt>
                <c:pt idx="243">
                  <c:v>76.583561700425193</c:v>
                </c:pt>
                <c:pt idx="244">
                  <c:v>62.539253290501101</c:v>
                </c:pt>
                <c:pt idx="245">
                  <c:v>70.309604939792905</c:v>
                </c:pt>
                <c:pt idx="246">
                  <c:v>72.008993369485907</c:v>
                </c:pt>
                <c:pt idx="247">
                  <c:v>29.874157925509301</c:v>
                </c:pt>
                <c:pt idx="248">
                  <c:v>60.495269391364801</c:v>
                </c:pt>
                <c:pt idx="249">
                  <c:v>60.543312396194999</c:v>
                </c:pt>
                <c:pt idx="250">
                  <c:v>62.362950559233902</c:v>
                </c:pt>
                <c:pt idx="251">
                  <c:v>67.532916617211797</c:v>
                </c:pt>
                <c:pt idx="252">
                  <c:v>53.786248051335001</c:v>
                </c:pt>
                <c:pt idx="253">
                  <c:v>58.5799537320067</c:v>
                </c:pt>
                <c:pt idx="254">
                  <c:v>69.264165765486098</c:v>
                </c:pt>
                <c:pt idx="255">
                  <c:v>27.713639524670601</c:v>
                </c:pt>
                <c:pt idx="256">
                  <c:v>53.027540574231402</c:v>
                </c:pt>
                <c:pt idx="257">
                  <c:v>83.361283792046606</c:v>
                </c:pt>
                <c:pt idx="258">
                  <c:v>77.931575273137895</c:v>
                </c:pt>
                <c:pt idx="259">
                  <c:v>48.180574824539903</c:v>
                </c:pt>
                <c:pt idx="260">
                  <c:v>51.215350383177402</c:v>
                </c:pt>
                <c:pt idx="261">
                  <c:v>44.552763670319301</c:v>
                </c:pt>
                <c:pt idx="262">
                  <c:v>61.1035534093742</c:v>
                </c:pt>
                <c:pt idx="263">
                  <c:v>49.198506324979697</c:v>
                </c:pt>
                <c:pt idx="264">
                  <c:v>36.801757472518297</c:v>
                </c:pt>
                <c:pt idx="265">
                  <c:v>71.016905651463802</c:v>
                </c:pt>
                <c:pt idx="266">
                  <c:v>47.6072970072114</c:v>
                </c:pt>
                <c:pt idx="267">
                  <c:v>55.4324021030192</c:v>
                </c:pt>
                <c:pt idx="268">
                  <c:v>48.766033523268902</c:v>
                </c:pt>
                <c:pt idx="269">
                  <c:v>49.140031317307802</c:v>
                </c:pt>
                <c:pt idx="270">
                  <c:v>66.858853322077593</c:v>
                </c:pt>
                <c:pt idx="271">
                  <c:v>60.467448171316903</c:v>
                </c:pt>
                <c:pt idx="272">
                  <c:v>39.241608323173502</c:v>
                </c:pt>
                <c:pt idx="273">
                  <c:v>41.818266881949498</c:v>
                </c:pt>
                <c:pt idx="274">
                  <c:v>58.091084461038399</c:v>
                </c:pt>
                <c:pt idx="275">
                  <c:v>62.854990909693399</c:v>
                </c:pt>
                <c:pt idx="276">
                  <c:v>39.847641213764199</c:v>
                </c:pt>
                <c:pt idx="277">
                  <c:v>63.513116823478398</c:v>
                </c:pt>
                <c:pt idx="278">
                  <c:v>35.207650996949397</c:v>
                </c:pt>
                <c:pt idx="279">
                  <c:v>52.631130256452003</c:v>
                </c:pt>
                <c:pt idx="280">
                  <c:v>76.321613906962199</c:v>
                </c:pt>
                <c:pt idx="281">
                  <c:v>65.082131950152899</c:v>
                </c:pt>
                <c:pt idx="282">
                  <c:v>68.501584184559505</c:v>
                </c:pt>
                <c:pt idx="283">
                  <c:v>61.216488254482499</c:v>
                </c:pt>
                <c:pt idx="284">
                  <c:v>56.987558978432901</c:v>
                </c:pt>
                <c:pt idx="285">
                  <c:v>52.278126909927103</c:v>
                </c:pt>
                <c:pt idx="286">
                  <c:v>53.778379130412603</c:v>
                </c:pt>
                <c:pt idx="287">
                  <c:v>67.783022260063902</c:v>
                </c:pt>
                <c:pt idx="288">
                  <c:v>63.898588497955402</c:v>
                </c:pt>
                <c:pt idx="289">
                  <c:v>59.685049188367898</c:v>
                </c:pt>
                <c:pt idx="290">
                  <c:v>65.661661952138004</c:v>
                </c:pt>
                <c:pt idx="291">
                  <c:v>48.958639774978302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26E4-4D60-8C51-F1E77AF0B5B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987833599"/>
        <c:axId val="1987522735"/>
      </c:scatterChart>
      <c:valAx>
        <c:axId val="1987833599"/>
        <c:scaling>
          <c:orientation val="minMax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.00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en-US" sz="1197" b="0" i="0" u="none" strike="noStrike" kern="1200" baseline="0">
                <a:solidFill>
                  <a:schemeClr val="dk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987522735"/>
        <c:crosses val="autoZero"/>
        <c:crossBetween val="midCat"/>
      </c:valAx>
      <c:valAx>
        <c:axId val="1987522735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.00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en-US" sz="1197" b="0" i="0" u="none" strike="noStrike" kern="1200" baseline="0">
                <a:solidFill>
                  <a:schemeClr val="dk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987833599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lang="en-US" sz="1197" b="0" i="0" u="none" strike="noStrike" kern="1200" baseline="0">
          <a:solidFill>
            <a:schemeClr val="dk1"/>
          </a:solidFill>
          <a:latin typeface="+mn-lt"/>
          <a:ea typeface="+mn-ea"/>
          <a:cs typeface="+mn-cs"/>
        </a:defRPr>
      </a:pPr>
      <a:endParaRPr lang="en-US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 algn="ctr" rtl="0">
              <a:defRPr lang="en-US" sz="2000" b="0" i="0" u="none" strike="noStrike" kern="1200" spc="70" baseline="0">
                <a:solidFill>
                  <a:prstClr val="black">
                    <a:lumMod val="50000"/>
                    <a:lumOff val="50000"/>
                  </a:prst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US" sz="2000" b="1" i="0" u="none" strike="noStrike" kern="1200" spc="70" baseline="0" dirty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FPod-GY</a:t>
            </a:r>
          </a:p>
        </c:rich>
      </c:tx>
      <c:layout>
        <c:manualLayout>
          <c:xMode val="edge"/>
          <c:yMode val="edge"/>
          <c:x val="0.38722523525693381"/>
          <c:y val="3.7037037037037035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 algn="ctr" rtl="0">
            <a:defRPr lang="en-US" sz="2000" b="0" i="0" u="none" strike="noStrike" kern="1200" spc="70" baseline="0">
              <a:solidFill>
                <a:prstClr val="black">
                  <a:lumMod val="50000"/>
                  <a:lumOff val="50000"/>
                </a:prstClr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title>
    <c:autoTitleDeleted val="0"/>
    <c:plotArea>
      <c:layout/>
      <c:scatterChart>
        <c:scatterStyle val="lineMarker"/>
        <c:varyColors val="0"/>
        <c:ser>
          <c:idx val="0"/>
          <c:order val="0"/>
          <c:tx>
            <c:strRef>
              <c:f>'292RIL'!$K$1</c:f>
              <c:strCache>
                <c:ptCount val="1"/>
                <c:pt idx="0">
                  <c:v>GY</c:v>
                </c:pt>
              </c:strCache>
            </c:strRef>
          </c:tx>
          <c:spPr>
            <a:ln w="1905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trendline>
            <c:spPr>
              <a:ln w="19050" cap="rnd">
                <a:solidFill>
                  <a:schemeClr val="accent1"/>
                </a:solidFill>
                <a:prstDash val="sysDot"/>
              </a:ln>
              <a:effectLst/>
            </c:spPr>
            <c:trendlineType val="linear"/>
            <c:dispRSqr val="1"/>
            <c:dispEq val="1"/>
            <c:trendlineLbl>
              <c:layout>
                <c:manualLayout>
                  <c:x val="0.17714722293662075"/>
                  <c:y val="-0.22222222222222221"/>
                </c:manualLayout>
              </c:layout>
              <c:tx>
                <c:rich>
                  <a:bodyPr rot="0" spcFirstLastPara="1" vertOverflow="ellipsis" vert="horz" wrap="square" anchor="ctr" anchorCtr="1"/>
                  <a:lstStyle/>
                  <a:p>
                    <a:pPr algn="ctr" rtl="0">
                      <a:defRPr lang="en-US" sz="1197" b="0" i="0" u="none" strike="noStrike" kern="1200" baseline="0">
                        <a:solidFill>
                          <a:prstClr val="black">
                            <a:lumMod val="50000"/>
                            <a:lumOff val="50000"/>
                          </a:prstClr>
                        </a:solidFill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defRPr>
                    </a:pPr>
                    <a:r>
                      <a:rPr lang="en-US" sz="1197" b="1" i="0" u="none" strike="noStrike" kern="1200" baseline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rPr>
                      <a:t>y = 0.1282x + 15.581</a:t>
                    </a:r>
                    <a:br>
                      <a:rPr lang="en-US" sz="1197" b="1" i="0" u="none" strike="noStrike" kern="1200" baseline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rPr>
                    </a:br>
                    <a:r>
                      <a:rPr lang="en-US" sz="1197" b="1" i="0" u="none" strike="noStrike" kern="1200" baseline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rPr>
                      <a:t>R² = 0.7823</a:t>
                    </a:r>
                  </a:p>
                </c:rich>
              </c:tx>
              <c:numFmt formatCode="General" sourceLinked="0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anchor="ctr" anchorCtr="1"/>
                <a:lstStyle/>
                <a:p>
                  <a:pPr algn="ctr" rtl="0">
                    <a:defRPr lang="en-US" sz="1197" b="0" i="0" u="none" strike="noStrike" kern="1200" baseline="0">
                      <a:solidFill>
                        <a:prstClr val="black">
                          <a:lumMod val="50000"/>
                          <a:lumOff val="50000"/>
                        </a:prstClr>
                      </a:solidFill>
                      <a:latin typeface="Arial" panose="020B0604020202020204" pitchFamily="34" charset="0"/>
                      <a:ea typeface="+mn-ea"/>
                      <a:cs typeface="Arial" panose="020B0604020202020204" pitchFamily="34" charset="0"/>
                    </a:defRPr>
                  </a:pPr>
                  <a:endParaRPr lang="en-US"/>
                </a:p>
              </c:txPr>
            </c:trendlineLbl>
          </c:trendline>
          <c:xVal>
            <c:numRef>
              <c:f>'292RIL'!$E$2:$E$295</c:f>
              <c:numCache>
                <c:formatCode>0.00</c:formatCode>
                <c:ptCount val="294"/>
                <c:pt idx="0">
                  <c:v>345.58580000000001</c:v>
                </c:pt>
                <c:pt idx="1">
                  <c:v>321.36520000000002</c:v>
                </c:pt>
                <c:pt idx="2">
                  <c:v>383.15539999999999</c:v>
                </c:pt>
                <c:pt idx="3">
                  <c:v>510.97</c:v>
                </c:pt>
                <c:pt idx="4">
                  <c:v>336.57479999999998</c:v>
                </c:pt>
                <c:pt idx="5">
                  <c:v>408.77229999999997</c:v>
                </c:pt>
                <c:pt idx="6">
                  <c:v>391.53660000000002</c:v>
                </c:pt>
                <c:pt idx="7">
                  <c:v>366.95659999999998</c:v>
                </c:pt>
                <c:pt idx="8">
                  <c:v>222.91</c:v>
                </c:pt>
                <c:pt idx="9">
                  <c:v>304.97679999999997</c:v>
                </c:pt>
                <c:pt idx="10">
                  <c:v>303.2038</c:v>
                </c:pt>
                <c:pt idx="11">
                  <c:v>343.0138</c:v>
                </c:pt>
                <c:pt idx="12">
                  <c:v>357.05919999999998</c:v>
                </c:pt>
                <c:pt idx="13">
                  <c:v>377.28469999999999</c:v>
                </c:pt>
                <c:pt idx="14">
                  <c:v>195.87</c:v>
                </c:pt>
                <c:pt idx="15">
                  <c:v>255.98669999999998</c:v>
                </c:pt>
                <c:pt idx="16">
                  <c:v>292.21659999999997</c:v>
                </c:pt>
                <c:pt idx="17">
                  <c:v>315.30860000000001</c:v>
                </c:pt>
                <c:pt idx="18">
                  <c:v>293.3261</c:v>
                </c:pt>
                <c:pt idx="19">
                  <c:v>352.76929999999999</c:v>
                </c:pt>
                <c:pt idx="20">
                  <c:v>248.7208</c:v>
                </c:pt>
                <c:pt idx="21">
                  <c:v>248.93969999999999</c:v>
                </c:pt>
                <c:pt idx="22">
                  <c:v>403.87369999999999</c:v>
                </c:pt>
                <c:pt idx="23">
                  <c:v>270.6345</c:v>
                </c:pt>
                <c:pt idx="24">
                  <c:v>305.65249999999997</c:v>
                </c:pt>
                <c:pt idx="25">
                  <c:v>70.489999999999981</c:v>
                </c:pt>
                <c:pt idx="26">
                  <c:v>325.08679999999998</c:v>
                </c:pt>
                <c:pt idx="27">
                  <c:v>303.86289999999997</c:v>
                </c:pt>
                <c:pt idx="28">
                  <c:v>314.43610000000001</c:v>
                </c:pt>
                <c:pt idx="29">
                  <c:v>276.48570000000001</c:v>
                </c:pt>
                <c:pt idx="30">
                  <c:v>302.13389999999998</c:v>
                </c:pt>
                <c:pt idx="31">
                  <c:v>287.03249999999997</c:v>
                </c:pt>
                <c:pt idx="32">
                  <c:v>424.13</c:v>
                </c:pt>
                <c:pt idx="33">
                  <c:v>421.91120000000001</c:v>
                </c:pt>
                <c:pt idx="34">
                  <c:v>239.91300000000001</c:v>
                </c:pt>
                <c:pt idx="35">
                  <c:v>238.10339999999999</c:v>
                </c:pt>
                <c:pt idx="36">
                  <c:v>432.71</c:v>
                </c:pt>
                <c:pt idx="37">
                  <c:v>305.86750000000001</c:v>
                </c:pt>
                <c:pt idx="38">
                  <c:v>238.44139999999999</c:v>
                </c:pt>
                <c:pt idx="39">
                  <c:v>443.44</c:v>
                </c:pt>
                <c:pt idx="40">
                  <c:v>371.75020000000001</c:v>
                </c:pt>
                <c:pt idx="41">
                  <c:v>353.32920000000001</c:v>
                </c:pt>
                <c:pt idx="42">
                  <c:v>232.30969999999999</c:v>
                </c:pt>
                <c:pt idx="43">
                  <c:v>167.26999999999998</c:v>
                </c:pt>
                <c:pt idx="44">
                  <c:v>446.32</c:v>
                </c:pt>
                <c:pt idx="45">
                  <c:v>199.70999999999998</c:v>
                </c:pt>
                <c:pt idx="46">
                  <c:v>115.1</c:v>
                </c:pt>
                <c:pt idx="47">
                  <c:v>273.98160000000001</c:v>
                </c:pt>
                <c:pt idx="48">
                  <c:v>423.73</c:v>
                </c:pt>
                <c:pt idx="49">
                  <c:v>256.25540000000001</c:v>
                </c:pt>
                <c:pt idx="50">
                  <c:v>253.16800000000001</c:v>
                </c:pt>
                <c:pt idx="51">
                  <c:v>226.53769999999997</c:v>
                </c:pt>
                <c:pt idx="52">
                  <c:v>470.6</c:v>
                </c:pt>
                <c:pt idx="53">
                  <c:v>369.98579999999998</c:v>
                </c:pt>
                <c:pt idx="54">
                  <c:v>409.15170000000001</c:v>
                </c:pt>
                <c:pt idx="55">
                  <c:v>349.48430000000002</c:v>
                </c:pt>
                <c:pt idx="56">
                  <c:v>348.97429999999997</c:v>
                </c:pt>
                <c:pt idx="57">
                  <c:v>230.11989999999997</c:v>
                </c:pt>
                <c:pt idx="58">
                  <c:v>274.37889999999999</c:v>
                </c:pt>
                <c:pt idx="59">
                  <c:v>170.70999999999998</c:v>
                </c:pt>
                <c:pt idx="60">
                  <c:v>431.16999999999996</c:v>
                </c:pt>
                <c:pt idx="61">
                  <c:v>404.66859999999997</c:v>
                </c:pt>
                <c:pt idx="62">
                  <c:v>353.08119999999997</c:v>
                </c:pt>
                <c:pt idx="63">
                  <c:v>169.5</c:v>
                </c:pt>
                <c:pt idx="64">
                  <c:v>348.18649999999997</c:v>
                </c:pt>
                <c:pt idx="65">
                  <c:v>312.66109999999998</c:v>
                </c:pt>
                <c:pt idx="66">
                  <c:v>320.96269999999998</c:v>
                </c:pt>
                <c:pt idx="67">
                  <c:v>305.83629999999999</c:v>
                </c:pt>
                <c:pt idx="68">
                  <c:v>269.59910000000002</c:v>
                </c:pt>
                <c:pt idx="69">
                  <c:v>266.61410000000001</c:v>
                </c:pt>
                <c:pt idx="70">
                  <c:v>128.94999999999999</c:v>
                </c:pt>
                <c:pt idx="71">
                  <c:v>158.48999999999998</c:v>
                </c:pt>
                <c:pt idx="72">
                  <c:v>361.8587</c:v>
                </c:pt>
                <c:pt idx="73">
                  <c:v>263.55399999999997</c:v>
                </c:pt>
                <c:pt idx="74">
                  <c:v>381.50509999999997</c:v>
                </c:pt>
                <c:pt idx="75">
                  <c:v>370.12610000000001</c:v>
                </c:pt>
                <c:pt idx="76">
                  <c:v>374.55020000000002</c:v>
                </c:pt>
                <c:pt idx="77">
                  <c:v>301.87889999999999</c:v>
                </c:pt>
                <c:pt idx="78">
                  <c:v>398.82029999999997</c:v>
                </c:pt>
                <c:pt idx="79">
                  <c:v>209.08999999999997</c:v>
                </c:pt>
                <c:pt idx="80">
                  <c:v>326.27389999999997</c:v>
                </c:pt>
                <c:pt idx="81">
                  <c:v>556.6</c:v>
                </c:pt>
                <c:pt idx="82">
                  <c:v>300.9282</c:v>
                </c:pt>
                <c:pt idx="83">
                  <c:v>336.01560000000001</c:v>
                </c:pt>
                <c:pt idx="84">
                  <c:v>233.6465</c:v>
                </c:pt>
                <c:pt idx="85">
                  <c:v>257.51959999999997</c:v>
                </c:pt>
                <c:pt idx="86">
                  <c:v>227.8279</c:v>
                </c:pt>
                <c:pt idx="87">
                  <c:v>220.99</c:v>
                </c:pt>
                <c:pt idx="88">
                  <c:v>168.97</c:v>
                </c:pt>
                <c:pt idx="89">
                  <c:v>267.48820000000001</c:v>
                </c:pt>
                <c:pt idx="90">
                  <c:v>263.3492</c:v>
                </c:pt>
                <c:pt idx="91">
                  <c:v>224.85910000000001</c:v>
                </c:pt>
                <c:pt idx="92">
                  <c:v>387.33139999999997</c:v>
                </c:pt>
                <c:pt idx="93">
                  <c:v>316.25040000000001</c:v>
                </c:pt>
                <c:pt idx="94">
                  <c:v>428.46</c:v>
                </c:pt>
                <c:pt idx="95">
                  <c:v>238.2319</c:v>
                </c:pt>
                <c:pt idx="96">
                  <c:v>228.78649999999999</c:v>
                </c:pt>
                <c:pt idx="97">
                  <c:v>346.09440000000001</c:v>
                </c:pt>
                <c:pt idx="98">
                  <c:v>386.05419999999998</c:v>
                </c:pt>
                <c:pt idx="99">
                  <c:v>302.74950000000001</c:v>
                </c:pt>
                <c:pt idx="100">
                  <c:v>353.02389999999997</c:v>
                </c:pt>
                <c:pt idx="101">
                  <c:v>293.577</c:v>
                </c:pt>
                <c:pt idx="102">
                  <c:v>410.43539999999996</c:v>
                </c:pt>
                <c:pt idx="103">
                  <c:v>292.9169</c:v>
                </c:pt>
                <c:pt idx="104">
                  <c:v>268.69689999999997</c:v>
                </c:pt>
                <c:pt idx="105">
                  <c:v>282.64</c:v>
                </c:pt>
                <c:pt idx="106">
                  <c:v>374.31169999999997</c:v>
                </c:pt>
                <c:pt idx="107">
                  <c:v>374.57040000000001</c:v>
                </c:pt>
                <c:pt idx="108">
                  <c:v>376.1105</c:v>
                </c:pt>
                <c:pt idx="109">
                  <c:v>310.0591</c:v>
                </c:pt>
                <c:pt idx="110">
                  <c:v>417.19889999999998</c:v>
                </c:pt>
                <c:pt idx="111">
                  <c:v>282.94319999999999</c:v>
                </c:pt>
                <c:pt idx="112">
                  <c:v>216.43</c:v>
                </c:pt>
                <c:pt idx="113">
                  <c:v>446.11</c:v>
                </c:pt>
                <c:pt idx="114">
                  <c:v>317.16730000000001</c:v>
                </c:pt>
                <c:pt idx="115">
                  <c:v>394.33940000000001</c:v>
                </c:pt>
                <c:pt idx="116">
                  <c:v>379.02690000000001</c:v>
                </c:pt>
                <c:pt idx="117">
                  <c:v>251.30629999999999</c:v>
                </c:pt>
                <c:pt idx="118">
                  <c:v>466.56</c:v>
                </c:pt>
                <c:pt idx="119">
                  <c:v>272.3202</c:v>
                </c:pt>
                <c:pt idx="120">
                  <c:v>318.55189999999999</c:v>
                </c:pt>
                <c:pt idx="121">
                  <c:v>267.4742</c:v>
                </c:pt>
                <c:pt idx="122">
                  <c:v>340.92719999999997</c:v>
                </c:pt>
                <c:pt idx="123">
                  <c:v>368.39150000000001</c:v>
                </c:pt>
                <c:pt idx="124">
                  <c:v>425.74</c:v>
                </c:pt>
                <c:pt idx="125">
                  <c:v>257.32470000000001</c:v>
                </c:pt>
                <c:pt idx="126">
                  <c:v>476.71</c:v>
                </c:pt>
                <c:pt idx="127">
                  <c:v>403.40530000000001</c:v>
                </c:pt>
                <c:pt idx="128">
                  <c:v>373.92750000000001</c:v>
                </c:pt>
                <c:pt idx="129">
                  <c:v>317.9554</c:v>
                </c:pt>
                <c:pt idx="130">
                  <c:v>333.44979999999998</c:v>
                </c:pt>
                <c:pt idx="131">
                  <c:v>346.4332</c:v>
                </c:pt>
                <c:pt idx="132">
                  <c:v>284.44499999999999</c:v>
                </c:pt>
                <c:pt idx="133">
                  <c:v>270.1703</c:v>
                </c:pt>
                <c:pt idx="134">
                  <c:v>282.30009999999999</c:v>
                </c:pt>
                <c:pt idx="135">
                  <c:v>420.82529999999997</c:v>
                </c:pt>
                <c:pt idx="136">
                  <c:v>343.84120000000001</c:v>
                </c:pt>
                <c:pt idx="137">
                  <c:v>498.24</c:v>
                </c:pt>
                <c:pt idx="138">
                  <c:v>267.82119999999998</c:v>
                </c:pt>
                <c:pt idx="139">
                  <c:v>310.51139999999998</c:v>
                </c:pt>
                <c:pt idx="140">
                  <c:v>413.73309999999998</c:v>
                </c:pt>
                <c:pt idx="141">
                  <c:v>335.19599999999997</c:v>
                </c:pt>
                <c:pt idx="142">
                  <c:v>252.92099999999999</c:v>
                </c:pt>
                <c:pt idx="143">
                  <c:v>344.536</c:v>
                </c:pt>
                <c:pt idx="144">
                  <c:v>389.9545</c:v>
                </c:pt>
                <c:pt idx="145">
                  <c:v>342.47679999999997</c:v>
                </c:pt>
                <c:pt idx="146">
                  <c:v>313.79079999999999</c:v>
                </c:pt>
                <c:pt idx="147">
                  <c:v>396.62520000000001</c:v>
                </c:pt>
                <c:pt idx="148">
                  <c:v>487.25</c:v>
                </c:pt>
                <c:pt idx="149">
                  <c:v>354.48770000000002</c:v>
                </c:pt>
                <c:pt idx="150">
                  <c:v>412.30939999999998</c:v>
                </c:pt>
                <c:pt idx="151">
                  <c:v>268.01279999999997</c:v>
                </c:pt>
                <c:pt idx="152">
                  <c:v>421.98789999999997</c:v>
                </c:pt>
                <c:pt idx="153">
                  <c:v>243.9375</c:v>
                </c:pt>
                <c:pt idx="154">
                  <c:v>290.40960000000001</c:v>
                </c:pt>
                <c:pt idx="155">
                  <c:v>324.238</c:v>
                </c:pt>
                <c:pt idx="156">
                  <c:v>284.2783</c:v>
                </c:pt>
                <c:pt idx="157">
                  <c:v>309.24739999999997</c:v>
                </c:pt>
                <c:pt idx="158">
                  <c:v>415.49900000000002</c:v>
                </c:pt>
                <c:pt idx="159">
                  <c:v>281.21969999999999</c:v>
                </c:pt>
                <c:pt idx="160">
                  <c:v>481.48</c:v>
                </c:pt>
                <c:pt idx="161">
                  <c:v>364.54379999999998</c:v>
                </c:pt>
                <c:pt idx="162">
                  <c:v>377.03589999999997</c:v>
                </c:pt>
                <c:pt idx="163">
                  <c:v>440.02</c:v>
                </c:pt>
                <c:pt idx="164">
                  <c:v>408.49360000000001</c:v>
                </c:pt>
                <c:pt idx="165">
                  <c:v>396.90859999999998</c:v>
                </c:pt>
                <c:pt idx="166">
                  <c:v>281.60230000000001</c:v>
                </c:pt>
                <c:pt idx="167">
                  <c:v>232.06630000000001</c:v>
                </c:pt>
                <c:pt idx="168">
                  <c:v>456.15999999999997</c:v>
                </c:pt>
                <c:pt idx="169">
                  <c:v>394.20619999999997</c:v>
                </c:pt>
                <c:pt idx="170">
                  <c:v>365.32939999999996</c:v>
                </c:pt>
                <c:pt idx="171">
                  <c:v>298.51</c:v>
                </c:pt>
                <c:pt idx="172">
                  <c:v>337.03719999999998</c:v>
                </c:pt>
                <c:pt idx="173">
                  <c:v>302.87810000000002</c:v>
                </c:pt>
                <c:pt idx="174">
                  <c:v>331.26830000000001</c:v>
                </c:pt>
                <c:pt idx="175">
                  <c:v>302.51049999999998</c:v>
                </c:pt>
                <c:pt idx="176">
                  <c:v>301.45350000000002</c:v>
                </c:pt>
                <c:pt idx="177">
                  <c:v>432.86</c:v>
                </c:pt>
                <c:pt idx="178">
                  <c:v>324.4402</c:v>
                </c:pt>
                <c:pt idx="179">
                  <c:v>398.86250000000001</c:v>
                </c:pt>
                <c:pt idx="180">
                  <c:v>344.26369999999997</c:v>
                </c:pt>
                <c:pt idx="181">
                  <c:v>272.25169999999997</c:v>
                </c:pt>
                <c:pt idx="182">
                  <c:v>429.58</c:v>
                </c:pt>
                <c:pt idx="183">
                  <c:v>151.32999999999998</c:v>
                </c:pt>
                <c:pt idx="184">
                  <c:v>375.07900000000001</c:v>
                </c:pt>
                <c:pt idx="185">
                  <c:v>384.13170000000002</c:v>
                </c:pt>
                <c:pt idx="186">
                  <c:v>371.19650000000001</c:v>
                </c:pt>
                <c:pt idx="187">
                  <c:v>301.012</c:v>
                </c:pt>
                <c:pt idx="188">
                  <c:v>345.64269999999999</c:v>
                </c:pt>
                <c:pt idx="189">
                  <c:v>377.42559999999997</c:v>
                </c:pt>
                <c:pt idx="190">
                  <c:v>315.72059999999999</c:v>
                </c:pt>
                <c:pt idx="191">
                  <c:v>348.28069999999997</c:v>
                </c:pt>
                <c:pt idx="192">
                  <c:v>371.6574</c:v>
                </c:pt>
                <c:pt idx="193">
                  <c:v>253.29</c:v>
                </c:pt>
                <c:pt idx="194">
                  <c:v>271.75509999999997</c:v>
                </c:pt>
                <c:pt idx="195">
                  <c:v>282.03480000000002</c:v>
                </c:pt>
                <c:pt idx="196">
                  <c:v>444.65</c:v>
                </c:pt>
                <c:pt idx="197">
                  <c:v>318.84690000000001</c:v>
                </c:pt>
                <c:pt idx="198">
                  <c:v>295.94279999999998</c:v>
                </c:pt>
                <c:pt idx="199">
                  <c:v>452</c:v>
                </c:pt>
                <c:pt idx="200">
                  <c:v>218.25</c:v>
                </c:pt>
                <c:pt idx="201">
                  <c:v>288.8331</c:v>
                </c:pt>
                <c:pt idx="202">
                  <c:v>338.65839999999997</c:v>
                </c:pt>
                <c:pt idx="203">
                  <c:v>247.57319999999999</c:v>
                </c:pt>
                <c:pt idx="204">
                  <c:v>370.42250000000001</c:v>
                </c:pt>
                <c:pt idx="205">
                  <c:v>199.76</c:v>
                </c:pt>
                <c:pt idx="206">
                  <c:v>339.81380000000001</c:v>
                </c:pt>
                <c:pt idx="207">
                  <c:v>270.2398</c:v>
                </c:pt>
                <c:pt idx="208">
                  <c:v>295.06220000000002</c:v>
                </c:pt>
                <c:pt idx="209">
                  <c:v>357.43169999999998</c:v>
                </c:pt>
                <c:pt idx="210">
                  <c:v>328.73919999999998</c:v>
                </c:pt>
                <c:pt idx="211">
                  <c:v>358.92869999999999</c:v>
                </c:pt>
                <c:pt idx="212">
                  <c:v>336.07709999999997</c:v>
                </c:pt>
                <c:pt idx="213">
                  <c:v>261.33029999999997</c:v>
                </c:pt>
                <c:pt idx="214">
                  <c:v>346.69810000000001</c:v>
                </c:pt>
                <c:pt idx="215">
                  <c:v>393.30349999999999</c:v>
                </c:pt>
                <c:pt idx="216">
                  <c:v>158.51</c:v>
                </c:pt>
                <c:pt idx="217">
                  <c:v>225.2287</c:v>
                </c:pt>
                <c:pt idx="218">
                  <c:v>222.1</c:v>
                </c:pt>
                <c:pt idx="219">
                  <c:v>382.40039999999999</c:v>
                </c:pt>
                <c:pt idx="220">
                  <c:v>181.85</c:v>
                </c:pt>
                <c:pt idx="221">
                  <c:v>338.37669999999997</c:v>
                </c:pt>
                <c:pt idx="222">
                  <c:v>361.96640000000002</c:v>
                </c:pt>
                <c:pt idx="223">
                  <c:v>200.98</c:v>
                </c:pt>
                <c:pt idx="224">
                  <c:v>295.10949999999997</c:v>
                </c:pt>
                <c:pt idx="225">
                  <c:v>465.29999999999995</c:v>
                </c:pt>
                <c:pt idx="226">
                  <c:v>222.01999999999998</c:v>
                </c:pt>
                <c:pt idx="227">
                  <c:v>181.75</c:v>
                </c:pt>
                <c:pt idx="228">
                  <c:v>465.15</c:v>
                </c:pt>
                <c:pt idx="229">
                  <c:v>235.95429999999999</c:v>
                </c:pt>
                <c:pt idx="230">
                  <c:v>448.61</c:v>
                </c:pt>
                <c:pt idx="231">
                  <c:v>260.47249999999997</c:v>
                </c:pt>
                <c:pt idx="232">
                  <c:v>337.79109999999997</c:v>
                </c:pt>
                <c:pt idx="233">
                  <c:v>299.75239999999997</c:v>
                </c:pt>
                <c:pt idx="234">
                  <c:v>239.58619999999999</c:v>
                </c:pt>
                <c:pt idx="235">
                  <c:v>266.65100000000001</c:v>
                </c:pt>
                <c:pt idx="236">
                  <c:v>391.95259999999996</c:v>
                </c:pt>
                <c:pt idx="237">
                  <c:v>127.63999999999999</c:v>
                </c:pt>
                <c:pt idx="238">
                  <c:v>309.81569999999999</c:v>
                </c:pt>
                <c:pt idx="239">
                  <c:v>287.44069999999999</c:v>
                </c:pt>
                <c:pt idx="240">
                  <c:v>385.63369999999998</c:v>
                </c:pt>
                <c:pt idx="241">
                  <c:v>291.45029999999997</c:v>
                </c:pt>
                <c:pt idx="242">
                  <c:v>285.11930000000001</c:v>
                </c:pt>
                <c:pt idx="243">
                  <c:v>578.30999999999995</c:v>
                </c:pt>
                <c:pt idx="244">
                  <c:v>354.83760000000001</c:v>
                </c:pt>
                <c:pt idx="245">
                  <c:v>463.4</c:v>
                </c:pt>
                <c:pt idx="246">
                  <c:v>395.6524</c:v>
                </c:pt>
                <c:pt idx="247">
                  <c:v>142.94999999999999</c:v>
                </c:pt>
                <c:pt idx="248">
                  <c:v>424.7</c:v>
                </c:pt>
                <c:pt idx="249">
                  <c:v>285.48939999999999</c:v>
                </c:pt>
                <c:pt idx="250">
                  <c:v>422.94669999999996</c:v>
                </c:pt>
                <c:pt idx="251">
                  <c:v>364.14609999999999</c:v>
                </c:pt>
                <c:pt idx="252">
                  <c:v>288.60429999999997</c:v>
                </c:pt>
                <c:pt idx="253">
                  <c:v>357.78050000000002</c:v>
                </c:pt>
                <c:pt idx="254">
                  <c:v>374.69939999999997</c:v>
                </c:pt>
                <c:pt idx="255">
                  <c:v>135.22999999999999</c:v>
                </c:pt>
                <c:pt idx="256">
                  <c:v>269.00310000000002</c:v>
                </c:pt>
                <c:pt idx="257">
                  <c:v>493.24</c:v>
                </c:pt>
                <c:pt idx="258">
                  <c:v>371.93549999999999</c:v>
                </c:pt>
                <c:pt idx="259">
                  <c:v>245.08920000000001</c:v>
                </c:pt>
                <c:pt idx="260">
                  <c:v>300.70029999999997</c:v>
                </c:pt>
                <c:pt idx="261">
                  <c:v>221.07999999999998</c:v>
                </c:pt>
                <c:pt idx="262">
                  <c:v>402.2704</c:v>
                </c:pt>
                <c:pt idx="263">
                  <c:v>317.13009999999997</c:v>
                </c:pt>
                <c:pt idx="264">
                  <c:v>181.43</c:v>
                </c:pt>
                <c:pt idx="265">
                  <c:v>431.44</c:v>
                </c:pt>
                <c:pt idx="266">
                  <c:v>256.4742</c:v>
                </c:pt>
                <c:pt idx="267">
                  <c:v>276.7294</c:v>
                </c:pt>
                <c:pt idx="268">
                  <c:v>232.69579999999999</c:v>
                </c:pt>
                <c:pt idx="269">
                  <c:v>361.9</c:v>
                </c:pt>
                <c:pt idx="270">
                  <c:v>380.29910000000001</c:v>
                </c:pt>
                <c:pt idx="271">
                  <c:v>397.03629999999998</c:v>
                </c:pt>
                <c:pt idx="272">
                  <c:v>222.37</c:v>
                </c:pt>
                <c:pt idx="273">
                  <c:v>235.8306</c:v>
                </c:pt>
                <c:pt idx="274">
                  <c:v>393.08670000000001</c:v>
                </c:pt>
                <c:pt idx="275">
                  <c:v>348.37099999999998</c:v>
                </c:pt>
                <c:pt idx="276">
                  <c:v>220.01999999999998</c:v>
                </c:pt>
                <c:pt idx="277">
                  <c:v>408.452</c:v>
                </c:pt>
                <c:pt idx="278">
                  <c:v>196</c:v>
                </c:pt>
                <c:pt idx="279">
                  <c:v>289.01580000000001</c:v>
                </c:pt>
                <c:pt idx="280">
                  <c:v>342.78960000000001</c:v>
                </c:pt>
                <c:pt idx="281">
                  <c:v>391.7679</c:v>
                </c:pt>
                <c:pt idx="282">
                  <c:v>468.5</c:v>
                </c:pt>
                <c:pt idx="283">
                  <c:v>409.4973</c:v>
                </c:pt>
                <c:pt idx="284">
                  <c:v>294.9606</c:v>
                </c:pt>
                <c:pt idx="285">
                  <c:v>280.7432</c:v>
                </c:pt>
                <c:pt idx="286">
                  <c:v>359.15589999999997</c:v>
                </c:pt>
                <c:pt idx="287">
                  <c:v>355.4033</c:v>
                </c:pt>
                <c:pt idx="288">
                  <c:v>414.82209999999998</c:v>
                </c:pt>
                <c:pt idx="289">
                  <c:v>330.05799999999999</c:v>
                </c:pt>
                <c:pt idx="290">
                  <c:v>377.42689999999999</c:v>
                </c:pt>
                <c:pt idx="291">
                  <c:v>322.19200000000001</c:v>
                </c:pt>
              </c:numCache>
            </c:numRef>
          </c:xVal>
          <c:yVal>
            <c:numRef>
              <c:f>'292RIL'!$K$2:$K$295</c:f>
              <c:numCache>
                <c:formatCode>0.00</c:formatCode>
                <c:ptCount val="294"/>
                <c:pt idx="0">
                  <c:v>62.228763290178101</c:v>
                </c:pt>
                <c:pt idx="1">
                  <c:v>58.398647092707797</c:v>
                </c:pt>
                <c:pt idx="2">
                  <c:v>67.938251841318902</c:v>
                </c:pt>
                <c:pt idx="3">
                  <c:v>77.704187246374104</c:v>
                </c:pt>
                <c:pt idx="4">
                  <c:v>56.936607797670803</c:v>
                </c:pt>
                <c:pt idx="5">
                  <c:v>58.6647073822975</c:v>
                </c:pt>
                <c:pt idx="6">
                  <c:v>72.223810597963293</c:v>
                </c:pt>
                <c:pt idx="7">
                  <c:v>67.243567647199598</c:v>
                </c:pt>
                <c:pt idx="8">
                  <c:v>47.9022004663384</c:v>
                </c:pt>
                <c:pt idx="9">
                  <c:v>62.425342227148498</c:v>
                </c:pt>
                <c:pt idx="10">
                  <c:v>58.003269178974499</c:v>
                </c:pt>
                <c:pt idx="11">
                  <c:v>55.729957707818201</c:v>
                </c:pt>
                <c:pt idx="12">
                  <c:v>68.929132899682799</c:v>
                </c:pt>
                <c:pt idx="13">
                  <c:v>69.467349869445997</c:v>
                </c:pt>
                <c:pt idx="14">
                  <c:v>43.955886393952802</c:v>
                </c:pt>
                <c:pt idx="15">
                  <c:v>48.3969850559291</c:v>
                </c:pt>
                <c:pt idx="16">
                  <c:v>47.734581566811499</c:v>
                </c:pt>
                <c:pt idx="17">
                  <c:v>53.963149336327</c:v>
                </c:pt>
                <c:pt idx="18">
                  <c:v>60.474570657113397</c:v>
                </c:pt>
                <c:pt idx="19">
                  <c:v>52.714785172957697</c:v>
                </c:pt>
                <c:pt idx="20">
                  <c:v>50.551641525222799</c:v>
                </c:pt>
                <c:pt idx="21">
                  <c:v>44.936317781137397</c:v>
                </c:pt>
                <c:pt idx="22">
                  <c:v>67.180766436604998</c:v>
                </c:pt>
                <c:pt idx="23">
                  <c:v>43.189913444553198</c:v>
                </c:pt>
                <c:pt idx="24">
                  <c:v>60.411170331965799</c:v>
                </c:pt>
                <c:pt idx="25">
                  <c:v>14.947028411218801</c:v>
                </c:pt>
                <c:pt idx="26">
                  <c:v>61.254846791595099</c:v>
                </c:pt>
                <c:pt idx="27">
                  <c:v>60.001715008676399</c:v>
                </c:pt>
                <c:pt idx="28">
                  <c:v>55.673661293305898</c:v>
                </c:pt>
                <c:pt idx="29">
                  <c:v>42.747807207142202</c:v>
                </c:pt>
                <c:pt idx="30">
                  <c:v>59.312503195903602</c:v>
                </c:pt>
                <c:pt idx="31">
                  <c:v>47.9983750350425</c:v>
                </c:pt>
                <c:pt idx="32">
                  <c:v>77.322276540066696</c:v>
                </c:pt>
                <c:pt idx="33">
                  <c:v>62.775785928698298</c:v>
                </c:pt>
                <c:pt idx="34">
                  <c:v>50.822938767402597</c:v>
                </c:pt>
                <c:pt idx="35">
                  <c:v>42.887768697559103</c:v>
                </c:pt>
                <c:pt idx="36">
                  <c:v>69.030662323876797</c:v>
                </c:pt>
                <c:pt idx="37">
                  <c:v>55.334032984598799</c:v>
                </c:pt>
                <c:pt idx="38">
                  <c:v>49.673041508934098</c:v>
                </c:pt>
                <c:pt idx="39">
                  <c:v>65.713870125904194</c:v>
                </c:pt>
                <c:pt idx="40">
                  <c:v>67.514002975373003</c:v>
                </c:pt>
                <c:pt idx="41">
                  <c:v>63.167526608214402</c:v>
                </c:pt>
                <c:pt idx="42">
                  <c:v>50.186291154217301</c:v>
                </c:pt>
                <c:pt idx="43">
                  <c:v>34.023256329648902</c:v>
                </c:pt>
                <c:pt idx="44">
                  <c:v>66.426277180282995</c:v>
                </c:pt>
                <c:pt idx="45">
                  <c:v>37.049953932151901</c:v>
                </c:pt>
                <c:pt idx="46">
                  <c:v>23.130219489150502</c:v>
                </c:pt>
                <c:pt idx="47">
                  <c:v>62.599536814255003</c:v>
                </c:pt>
                <c:pt idx="48">
                  <c:v>63.951103420073203</c:v>
                </c:pt>
                <c:pt idx="49">
                  <c:v>45.035331177826997</c:v>
                </c:pt>
                <c:pt idx="50">
                  <c:v>59.989490169730601</c:v>
                </c:pt>
                <c:pt idx="51">
                  <c:v>44.920242687760599</c:v>
                </c:pt>
                <c:pt idx="52">
                  <c:v>73.190256658584403</c:v>
                </c:pt>
                <c:pt idx="53">
                  <c:v>69.259823719268496</c:v>
                </c:pt>
                <c:pt idx="54">
                  <c:v>70.106101221638397</c:v>
                </c:pt>
                <c:pt idx="55">
                  <c:v>53.128841810669499</c:v>
                </c:pt>
                <c:pt idx="56">
                  <c:v>57.182594448297699</c:v>
                </c:pt>
                <c:pt idx="57">
                  <c:v>45.185689781243902</c:v>
                </c:pt>
                <c:pt idx="58">
                  <c:v>48.567972620586097</c:v>
                </c:pt>
                <c:pt idx="59">
                  <c:v>33.939468697867902</c:v>
                </c:pt>
                <c:pt idx="60">
                  <c:v>72.375143850000796</c:v>
                </c:pt>
                <c:pt idx="61">
                  <c:v>65.615017756812307</c:v>
                </c:pt>
                <c:pt idx="62">
                  <c:v>67.267258905588804</c:v>
                </c:pt>
                <c:pt idx="63">
                  <c:v>33.415359570950301</c:v>
                </c:pt>
                <c:pt idx="64">
                  <c:v>54.817736838917902</c:v>
                </c:pt>
                <c:pt idx="65">
                  <c:v>54.9046756138464</c:v>
                </c:pt>
                <c:pt idx="66">
                  <c:v>63.3775490974256</c:v>
                </c:pt>
                <c:pt idx="67">
                  <c:v>57.305730991656603</c:v>
                </c:pt>
                <c:pt idx="68">
                  <c:v>43.762730952829003</c:v>
                </c:pt>
                <c:pt idx="69">
                  <c:v>47.346116856653602</c:v>
                </c:pt>
                <c:pt idx="70">
                  <c:v>26.117868609791302</c:v>
                </c:pt>
                <c:pt idx="71">
                  <c:v>31.070496911565801</c:v>
                </c:pt>
                <c:pt idx="72">
                  <c:v>55.4780246612479</c:v>
                </c:pt>
                <c:pt idx="73">
                  <c:v>43.838755589278101</c:v>
                </c:pt>
                <c:pt idx="74">
                  <c:v>68.231644802832903</c:v>
                </c:pt>
                <c:pt idx="75">
                  <c:v>69.388084225036195</c:v>
                </c:pt>
                <c:pt idx="76">
                  <c:v>68.083686893998504</c:v>
                </c:pt>
                <c:pt idx="77">
                  <c:v>57.362631083849102</c:v>
                </c:pt>
                <c:pt idx="78">
                  <c:v>69.581218258306194</c:v>
                </c:pt>
                <c:pt idx="79">
                  <c:v>38.525775575964502</c:v>
                </c:pt>
                <c:pt idx="80">
                  <c:v>49.919442690220897</c:v>
                </c:pt>
                <c:pt idx="81">
                  <c:v>89.761608279646296</c:v>
                </c:pt>
                <c:pt idx="82">
                  <c:v>51.340608176601698</c:v>
                </c:pt>
                <c:pt idx="83">
                  <c:v>62.142554170048399</c:v>
                </c:pt>
                <c:pt idx="84">
                  <c:v>49.124964017840199</c:v>
                </c:pt>
                <c:pt idx="85">
                  <c:v>45.430878908599098</c:v>
                </c:pt>
                <c:pt idx="86">
                  <c:v>47.049721019486</c:v>
                </c:pt>
                <c:pt idx="87">
                  <c:v>40.076064527809898</c:v>
                </c:pt>
                <c:pt idx="88">
                  <c:v>30.7061183580327</c:v>
                </c:pt>
                <c:pt idx="89">
                  <c:v>53.6896236086492</c:v>
                </c:pt>
                <c:pt idx="90">
                  <c:v>45.262596811130699</c:v>
                </c:pt>
                <c:pt idx="91">
                  <c:v>49.722699699847801</c:v>
                </c:pt>
                <c:pt idx="92">
                  <c:v>68.268541944572405</c:v>
                </c:pt>
                <c:pt idx="93">
                  <c:v>56.943895381656198</c:v>
                </c:pt>
                <c:pt idx="94">
                  <c:v>64.804536499389002</c:v>
                </c:pt>
                <c:pt idx="95">
                  <c:v>49.906490528587199</c:v>
                </c:pt>
                <c:pt idx="96">
                  <c:v>41.599505592842704</c:v>
                </c:pt>
                <c:pt idx="97">
                  <c:v>55.2793148864179</c:v>
                </c:pt>
                <c:pt idx="98">
                  <c:v>67.831219248816097</c:v>
                </c:pt>
                <c:pt idx="99">
                  <c:v>71.852658229553597</c:v>
                </c:pt>
                <c:pt idx="100">
                  <c:v>62.1780589325164</c:v>
                </c:pt>
                <c:pt idx="101">
                  <c:v>44.665967511131598</c:v>
                </c:pt>
                <c:pt idx="102">
                  <c:v>73.896059301193006</c:v>
                </c:pt>
                <c:pt idx="103">
                  <c:v>51.969808160613098</c:v>
                </c:pt>
                <c:pt idx="104">
                  <c:v>59.393827564406998</c:v>
                </c:pt>
                <c:pt idx="105">
                  <c:v>46.437239872607002</c:v>
                </c:pt>
                <c:pt idx="106">
                  <c:v>59.838093580451797</c:v>
                </c:pt>
                <c:pt idx="107">
                  <c:v>61.675437469304299</c:v>
                </c:pt>
                <c:pt idx="108">
                  <c:v>64.873179933953097</c:v>
                </c:pt>
                <c:pt idx="109">
                  <c:v>60.998117668349103</c:v>
                </c:pt>
                <c:pt idx="110">
                  <c:v>57.776651778437802</c:v>
                </c:pt>
                <c:pt idx="111">
                  <c:v>53.749096416363997</c:v>
                </c:pt>
                <c:pt idx="112">
                  <c:v>40.455178520760398</c:v>
                </c:pt>
                <c:pt idx="113">
                  <c:v>64.979086326752693</c:v>
                </c:pt>
                <c:pt idx="114">
                  <c:v>54.117925526048801</c:v>
                </c:pt>
                <c:pt idx="115">
                  <c:v>69.756545713984494</c:v>
                </c:pt>
                <c:pt idx="116">
                  <c:v>68.937362637230194</c:v>
                </c:pt>
                <c:pt idx="117">
                  <c:v>53.086813767324202</c:v>
                </c:pt>
                <c:pt idx="118">
                  <c:v>68.747217221871495</c:v>
                </c:pt>
                <c:pt idx="119">
                  <c:v>53.652322233267</c:v>
                </c:pt>
                <c:pt idx="120">
                  <c:v>65.406771279427005</c:v>
                </c:pt>
                <c:pt idx="121">
                  <c:v>45.3188378110587</c:v>
                </c:pt>
                <c:pt idx="122">
                  <c:v>51.962019015966298</c:v>
                </c:pt>
                <c:pt idx="123">
                  <c:v>70.548300095799306</c:v>
                </c:pt>
                <c:pt idx="124">
                  <c:v>66.433985291178004</c:v>
                </c:pt>
                <c:pt idx="125">
                  <c:v>52.698567142806802</c:v>
                </c:pt>
                <c:pt idx="126">
                  <c:v>74.992422026640895</c:v>
                </c:pt>
                <c:pt idx="127">
                  <c:v>74.9687675728199</c:v>
                </c:pt>
                <c:pt idx="128">
                  <c:v>71.390415778272697</c:v>
                </c:pt>
                <c:pt idx="129">
                  <c:v>57.8144598550194</c:v>
                </c:pt>
                <c:pt idx="130">
                  <c:v>60.8634070558237</c:v>
                </c:pt>
                <c:pt idx="131">
                  <c:v>67.151010397833105</c:v>
                </c:pt>
                <c:pt idx="132">
                  <c:v>47.760218798772101</c:v>
                </c:pt>
                <c:pt idx="133">
                  <c:v>54.723426478951602</c:v>
                </c:pt>
                <c:pt idx="134">
                  <c:v>53.324767312468303</c:v>
                </c:pt>
                <c:pt idx="135">
                  <c:v>68.716062737809693</c:v>
                </c:pt>
                <c:pt idx="136">
                  <c:v>60.690622176783499</c:v>
                </c:pt>
                <c:pt idx="137">
                  <c:v>73.2726824605584</c:v>
                </c:pt>
                <c:pt idx="138">
                  <c:v>48.907363720225497</c:v>
                </c:pt>
                <c:pt idx="139">
                  <c:v>56.5282803310741</c:v>
                </c:pt>
                <c:pt idx="140">
                  <c:v>60.494691742409699</c:v>
                </c:pt>
                <c:pt idx="141">
                  <c:v>52.182556029250598</c:v>
                </c:pt>
                <c:pt idx="142">
                  <c:v>54.684124062309102</c:v>
                </c:pt>
                <c:pt idx="143">
                  <c:v>67.619307090393207</c:v>
                </c:pt>
                <c:pt idx="144">
                  <c:v>81.526557176821697</c:v>
                </c:pt>
                <c:pt idx="145">
                  <c:v>68.515192646184104</c:v>
                </c:pt>
                <c:pt idx="146">
                  <c:v>58.534088171506497</c:v>
                </c:pt>
                <c:pt idx="147">
                  <c:v>71.400439720775196</c:v>
                </c:pt>
                <c:pt idx="148">
                  <c:v>75.839446066971306</c:v>
                </c:pt>
                <c:pt idx="149">
                  <c:v>53.143145413158202</c:v>
                </c:pt>
                <c:pt idx="150">
                  <c:v>77.876863084471594</c:v>
                </c:pt>
                <c:pt idx="151">
                  <c:v>47.682791215634801</c:v>
                </c:pt>
                <c:pt idx="152">
                  <c:v>76.746646656122493</c:v>
                </c:pt>
                <c:pt idx="153">
                  <c:v>39.852888155989397</c:v>
                </c:pt>
                <c:pt idx="154">
                  <c:v>53.453998817307202</c:v>
                </c:pt>
                <c:pt idx="155">
                  <c:v>57.708977902140496</c:v>
                </c:pt>
                <c:pt idx="156">
                  <c:v>46.9863920382953</c:v>
                </c:pt>
                <c:pt idx="157">
                  <c:v>55.051136690148702</c:v>
                </c:pt>
                <c:pt idx="158">
                  <c:v>76.917340308128104</c:v>
                </c:pt>
                <c:pt idx="159">
                  <c:v>54.586982260412398</c:v>
                </c:pt>
                <c:pt idx="160">
                  <c:v>72.523284204896996</c:v>
                </c:pt>
                <c:pt idx="161">
                  <c:v>55.345648018814998</c:v>
                </c:pt>
                <c:pt idx="162">
                  <c:v>68.170838633156194</c:v>
                </c:pt>
                <c:pt idx="163">
                  <c:v>78.481274906535901</c:v>
                </c:pt>
                <c:pt idx="164">
                  <c:v>65.587733497379702</c:v>
                </c:pt>
                <c:pt idx="165">
                  <c:v>66.265035589739995</c:v>
                </c:pt>
                <c:pt idx="166">
                  <c:v>50.801745052524197</c:v>
                </c:pt>
                <c:pt idx="167">
                  <c:v>42.737939090985897</c:v>
                </c:pt>
                <c:pt idx="168">
                  <c:v>76.994456563937703</c:v>
                </c:pt>
                <c:pt idx="169">
                  <c:v>67.865986734055994</c:v>
                </c:pt>
                <c:pt idx="170">
                  <c:v>61.558470737030298</c:v>
                </c:pt>
                <c:pt idx="171">
                  <c:v>49.603164956258297</c:v>
                </c:pt>
                <c:pt idx="172">
                  <c:v>55.945418222928602</c:v>
                </c:pt>
                <c:pt idx="173">
                  <c:v>53.7932613890356</c:v>
                </c:pt>
                <c:pt idx="174">
                  <c:v>62.649828718977702</c:v>
                </c:pt>
                <c:pt idx="175">
                  <c:v>57.636055591277703</c:v>
                </c:pt>
                <c:pt idx="176">
                  <c:v>52.636521659307903</c:v>
                </c:pt>
                <c:pt idx="177">
                  <c:v>74.939789527598506</c:v>
                </c:pt>
                <c:pt idx="178">
                  <c:v>61.9327308905781</c:v>
                </c:pt>
                <c:pt idx="179">
                  <c:v>73.705330053414301</c:v>
                </c:pt>
                <c:pt idx="180">
                  <c:v>53.455930775373602</c:v>
                </c:pt>
                <c:pt idx="181">
                  <c:v>55.319810916211601</c:v>
                </c:pt>
                <c:pt idx="182">
                  <c:v>66.918111511030503</c:v>
                </c:pt>
                <c:pt idx="183">
                  <c:v>34.500168144843798</c:v>
                </c:pt>
                <c:pt idx="184">
                  <c:v>59.8671515487977</c:v>
                </c:pt>
                <c:pt idx="185">
                  <c:v>60.272865517870599</c:v>
                </c:pt>
                <c:pt idx="186">
                  <c:v>58.519176591984497</c:v>
                </c:pt>
                <c:pt idx="187">
                  <c:v>68.522972826877904</c:v>
                </c:pt>
                <c:pt idx="188">
                  <c:v>64.822843823809706</c:v>
                </c:pt>
                <c:pt idx="189">
                  <c:v>54.522125727556102</c:v>
                </c:pt>
                <c:pt idx="190">
                  <c:v>52.424747538961</c:v>
                </c:pt>
                <c:pt idx="191">
                  <c:v>52.471069252183</c:v>
                </c:pt>
                <c:pt idx="192">
                  <c:v>63.076170525134003</c:v>
                </c:pt>
                <c:pt idx="193">
                  <c:v>51.943395406610598</c:v>
                </c:pt>
                <c:pt idx="194">
                  <c:v>49.5141927031774</c:v>
                </c:pt>
                <c:pt idx="195">
                  <c:v>50.661701913418703</c:v>
                </c:pt>
                <c:pt idx="196">
                  <c:v>73.346381089243394</c:v>
                </c:pt>
                <c:pt idx="197">
                  <c:v>68.126170211203103</c:v>
                </c:pt>
                <c:pt idx="198">
                  <c:v>48.661076108408203</c:v>
                </c:pt>
                <c:pt idx="199">
                  <c:v>77.443033621398598</c:v>
                </c:pt>
                <c:pt idx="200">
                  <c:v>39.594267115784298</c:v>
                </c:pt>
                <c:pt idx="201">
                  <c:v>55.441086830721098</c:v>
                </c:pt>
                <c:pt idx="202">
                  <c:v>66.357265447804295</c:v>
                </c:pt>
                <c:pt idx="203">
                  <c:v>48.799422674181201</c:v>
                </c:pt>
                <c:pt idx="204">
                  <c:v>57.315104505564399</c:v>
                </c:pt>
                <c:pt idx="205">
                  <c:v>39.572211267588997</c:v>
                </c:pt>
                <c:pt idx="206">
                  <c:v>64.57069229679</c:v>
                </c:pt>
                <c:pt idx="207">
                  <c:v>44.3883794588074</c:v>
                </c:pt>
                <c:pt idx="208">
                  <c:v>55.7383861014887</c:v>
                </c:pt>
                <c:pt idx="209">
                  <c:v>55.409576347470797</c:v>
                </c:pt>
                <c:pt idx="210">
                  <c:v>59.578954766288497</c:v>
                </c:pt>
                <c:pt idx="211">
                  <c:v>49.5773399118832</c:v>
                </c:pt>
                <c:pt idx="212">
                  <c:v>52.4861316331965</c:v>
                </c:pt>
                <c:pt idx="213">
                  <c:v>42.7484113559183</c:v>
                </c:pt>
                <c:pt idx="214">
                  <c:v>57.747543127763599</c:v>
                </c:pt>
                <c:pt idx="215">
                  <c:v>71.176194423315494</c:v>
                </c:pt>
                <c:pt idx="216">
                  <c:v>30.479741215353101</c:v>
                </c:pt>
                <c:pt idx="217">
                  <c:v>44.804707868781101</c:v>
                </c:pt>
                <c:pt idx="218">
                  <c:v>50.571895257805103</c:v>
                </c:pt>
                <c:pt idx="219">
                  <c:v>59.285973094934299</c:v>
                </c:pt>
                <c:pt idx="220">
                  <c:v>34.4449869989771</c:v>
                </c:pt>
                <c:pt idx="221">
                  <c:v>53.147252028784997</c:v>
                </c:pt>
                <c:pt idx="222">
                  <c:v>61.872547565668597</c:v>
                </c:pt>
                <c:pt idx="223">
                  <c:v>38.349082435517801</c:v>
                </c:pt>
                <c:pt idx="224">
                  <c:v>57.994836855047197</c:v>
                </c:pt>
                <c:pt idx="225">
                  <c:v>77.542772529837293</c:v>
                </c:pt>
                <c:pt idx="226">
                  <c:v>48.5024956142043</c:v>
                </c:pt>
                <c:pt idx="227">
                  <c:v>36.675650741849701</c:v>
                </c:pt>
                <c:pt idx="228">
                  <c:v>68.841882979556701</c:v>
                </c:pt>
                <c:pt idx="229">
                  <c:v>53.469246146117101</c:v>
                </c:pt>
                <c:pt idx="230">
                  <c:v>77.146725226679294</c:v>
                </c:pt>
                <c:pt idx="231">
                  <c:v>49.714573677847703</c:v>
                </c:pt>
                <c:pt idx="232">
                  <c:v>72.1452047833872</c:v>
                </c:pt>
                <c:pt idx="233">
                  <c:v>61.224105229271203</c:v>
                </c:pt>
                <c:pt idx="234">
                  <c:v>54.831143955502</c:v>
                </c:pt>
                <c:pt idx="235">
                  <c:v>58.123288810507901</c:v>
                </c:pt>
                <c:pt idx="236">
                  <c:v>65.820666996051798</c:v>
                </c:pt>
                <c:pt idx="237">
                  <c:v>27.862315334933701</c:v>
                </c:pt>
                <c:pt idx="238">
                  <c:v>50.547663718224797</c:v>
                </c:pt>
                <c:pt idx="239">
                  <c:v>53.347964102649797</c:v>
                </c:pt>
                <c:pt idx="240">
                  <c:v>55.738785724877097</c:v>
                </c:pt>
                <c:pt idx="241">
                  <c:v>53.761862205532097</c:v>
                </c:pt>
                <c:pt idx="242">
                  <c:v>51.165547311828398</c:v>
                </c:pt>
                <c:pt idx="243">
                  <c:v>76.583561700425193</c:v>
                </c:pt>
                <c:pt idx="244">
                  <c:v>62.539253290501101</c:v>
                </c:pt>
                <c:pt idx="245">
                  <c:v>70.309604939792905</c:v>
                </c:pt>
                <c:pt idx="246">
                  <c:v>72.008993369485907</c:v>
                </c:pt>
                <c:pt idx="247">
                  <c:v>29.874157925509301</c:v>
                </c:pt>
                <c:pt idx="248">
                  <c:v>60.495269391364801</c:v>
                </c:pt>
                <c:pt idx="249">
                  <c:v>60.543312396194999</c:v>
                </c:pt>
                <c:pt idx="250">
                  <c:v>62.362950559233902</c:v>
                </c:pt>
                <c:pt idx="251">
                  <c:v>67.532916617211797</c:v>
                </c:pt>
                <c:pt idx="252">
                  <c:v>53.786248051335001</c:v>
                </c:pt>
                <c:pt idx="253">
                  <c:v>58.5799537320067</c:v>
                </c:pt>
                <c:pt idx="254">
                  <c:v>69.264165765486098</c:v>
                </c:pt>
                <c:pt idx="255">
                  <c:v>27.713639524670601</c:v>
                </c:pt>
                <c:pt idx="256">
                  <c:v>53.027540574231402</c:v>
                </c:pt>
                <c:pt idx="257">
                  <c:v>83.361283792046606</c:v>
                </c:pt>
                <c:pt idx="258">
                  <c:v>77.931575273137895</c:v>
                </c:pt>
                <c:pt idx="259">
                  <c:v>48.180574824539903</c:v>
                </c:pt>
                <c:pt idx="260">
                  <c:v>51.215350383177402</c:v>
                </c:pt>
                <c:pt idx="261">
                  <c:v>44.552763670319301</c:v>
                </c:pt>
                <c:pt idx="262">
                  <c:v>61.1035534093742</c:v>
                </c:pt>
                <c:pt idx="263">
                  <c:v>49.198506324979697</c:v>
                </c:pt>
                <c:pt idx="264">
                  <c:v>36.801757472518297</c:v>
                </c:pt>
                <c:pt idx="265">
                  <c:v>71.016905651463802</c:v>
                </c:pt>
                <c:pt idx="266">
                  <c:v>47.6072970072114</c:v>
                </c:pt>
                <c:pt idx="267">
                  <c:v>55.4324021030192</c:v>
                </c:pt>
                <c:pt idx="268">
                  <c:v>48.766033523268902</c:v>
                </c:pt>
                <c:pt idx="269">
                  <c:v>49.140031317307802</c:v>
                </c:pt>
                <c:pt idx="270">
                  <c:v>66.858853322077593</c:v>
                </c:pt>
                <c:pt idx="271">
                  <c:v>60.467448171316903</c:v>
                </c:pt>
                <c:pt idx="272">
                  <c:v>39.241608323173502</c:v>
                </c:pt>
                <c:pt idx="273">
                  <c:v>41.818266881949498</c:v>
                </c:pt>
                <c:pt idx="274">
                  <c:v>58.091084461038399</c:v>
                </c:pt>
                <c:pt idx="275">
                  <c:v>62.854990909693399</c:v>
                </c:pt>
                <c:pt idx="276">
                  <c:v>39.847641213764199</c:v>
                </c:pt>
                <c:pt idx="277">
                  <c:v>63.513116823478398</c:v>
                </c:pt>
                <c:pt idx="278">
                  <c:v>35.207650996949397</c:v>
                </c:pt>
                <c:pt idx="279">
                  <c:v>52.631130256452003</c:v>
                </c:pt>
                <c:pt idx="280">
                  <c:v>76.321613906962199</c:v>
                </c:pt>
                <c:pt idx="281">
                  <c:v>65.082131950152899</c:v>
                </c:pt>
                <c:pt idx="282">
                  <c:v>68.501584184559505</c:v>
                </c:pt>
                <c:pt idx="283">
                  <c:v>61.216488254482499</c:v>
                </c:pt>
                <c:pt idx="284">
                  <c:v>56.987558978432901</c:v>
                </c:pt>
                <c:pt idx="285">
                  <c:v>52.278126909927103</c:v>
                </c:pt>
                <c:pt idx="286">
                  <c:v>53.778379130412603</c:v>
                </c:pt>
                <c:pt idx="287">
                  <c:v>67.783022260063902</c:v>
                </c:pt>
                <c:pt idx="288">
                  <c:v>63.898588497955402</c:v>
                </c:pt>
                <c:pt idx="289">
                  <c:v>59.685049188367898</c:v>
                </c:pt>
                <c:pt idx="290">
                  <c:v>65.661661952138004</c:v>
                </c:pt>
                <c:pt idx="291">
                  <c:v>48.958639774978302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3F2A-42B3-A74E-FE6F01282CB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987833599"/>
        <c:axId val="1987522735"/>
      </c:scatterChart>
      <c:valAx>
        <c:axId val="1987833599"/>
        <c:scaling>
          <c:orientation val="minMax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.00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987522735"/>
        <c:crosses val="autoZero"/>
        <c:crossBetween val="midCat"/>
      </c:valAx>
      <c:valAx>
        <c:axId val="1987522735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.00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987833599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 algn="ctr" rtl="0">
              <a:defRPr lang="en-US" sz="2000" b="0" i="0" u="none" strike="noStrike" kern="1200" spc="70" baseline="0">
                <a:solidFill>
                  <a:prstClr val="black">
                    <a:lumMod val="50000"/>
                    <a:lumOff val="50000"/>
                  </a:prst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US" sz="2000" b="1" i="0" u="none" strike="noStrike" kern="1200" spc="70" baseline="0" dirty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TS-GY</a:t>
            </a:r>
          </a:p>
        </c:rich>
      </c:tx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 algn="ctr" rtl="0">
            <a:defRPr lang="en-US" sz="2000" b="0" i="0" u="none" strike="noStrike" kern="1200" spc="70" baseline="0">
              <a:solidFill>
                <a:prstClr val="black">
                  <a:lumMod val="50000"/>
                  <a:lumOff val="50000"/>
                </a:prstClr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title>
    <c:autoTitleDeleted val="0"/>
    <c:plotArea>
      <c:layout/>
      <c:scatterChart>
        <c:scatterStyle val="lineMarker"/>
        <c:varyColors val="0"/>
        <c:ser>
          <c:idx val="0"/>
          <c:order val="0"/>
          <c:tx>
            <c:strRef>
              <c:f>'292RIL'!$K$1</c:f>
              <c:strCache>
                <c:ptCount val="1"/>
                <c:pt idx="0">
                  <c:v>GY</c:v>
                </c:pt>
              </c:strCache>
            </c:strRef>
          </c:tx>
          <c:spPr>
            <a:ln w="1905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trendline>
            <c:spPr>
              <a:ln w="19050" cap="rnd">
                <a:solidFill>
                  <a:schemeClr val="accent1"/>
                </a:solidFill>
                <a:prstDash val="sysDot"/>
              </a:ln>
              <a:effectLst/>
            </c:spPr>
            <c:trendlineType val="linear"/>
            <c:dispRSqr val="1"/>
            <c:dispEq val="1"/>
            <c:trendlineLbl>
              <c:layout>
                <c:manualLayout>
                  <c:x val="0.19542570846073481"/>
                  <c:y val="-0.21437518226888305"/>
                </c:manualLayout>
              </c:layout>
              <c:tx>
                <c:rich>
                  <a:bodyPr rot="0" spcFirstLastPara="1" vertOverflow="ellipsis" vert="horz" wrap="square" anchor="ctr" anchorCtr="1"/>
                  <a:lstStyle/>
                  <a:p>
                    <a:pPr algn="ctr" rtl="0">
                      <a:defRPr lang="en-US" sz="1197" b="0" i="0" u="none" strike="noStrike" kern="1200" baseline="0">
                        <a:solidFill>
                          <a:prstClr val="black">
                            <a:lumMod val="50000"/>
                            <a:lumOff val="50000"/>
                          </a:prstClr>
                        </a:solidFill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defRPr>
                    </a:pPr>
                    <a:r>
                      <a:rPr lang="en-US" sz="1197" b="1" i="0" u="none" strike="noStrike" kern="1200" baseline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rPr>
                      <a:t>y = 0.099x + 15.411</a:t>
                    </a:r>
                    <a:br>
                      <a:rPr lang="en-US" sz="1197" b="1" i="0" u="none" strike="noStrike" kern="1200" baseline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rPr>
                    </a:br>
                    <a:r>
                      <a:rPr lang="en-US" sz="1197" b="1" i="0" u="none" strike="noStrike" kern="1200" baseline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rPr>
                      <a:t>R² = 0.7889</a:t>
                    </a:r>
                  </a:p>
                </c:rich>
              </c:tx>
              <c:numFmt formatCode="General" sourceLinked="0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anchor="ctr" anchorCtr="1"/>
                <a:lstStyle/>
                <a:p>
                  <a:pPr algn="ctr" rtl="0">
                    <a:defRPr lang="en-US" sz="1197" b="0" i="0" u="none" strike="noStrike" kern="1200" baseline="0">
                      <a:solidFill>
                        <a:prstClr val="black">
                          <a:lumMod val="50000"/>
                          <a:lumOff val="50000"/>
                        </a:prstClr>
                      </a:solidFill>
                      <a:latin typeface="Arial" panose="020B0604020202020204" pitchFamily="34" charset="0"/>
                      <a:ea typeface="+mn-ea"/>
                      <a:cs typeface="Arial" panose="020B0604020202020204" pitchFamily="34" charset="0"/>
                    </a:defRPr>
                  </a:pPr>
                  <a:endParaRPr lang="en-US"/>
                </a:p>
              </c:txPr>
            </c:trendlineLbl>
          </c:trendline>
          <c:xVal>
            <c:numRef>
              <c:f>'292RIL'!$F$2:$F$295</c:f>
              <c:numCache>
                <c:formatCode>0.00</c:formatCode>
                <c:ptCount val="294"/>
                <c:pt idx="0">
                  <c:v>473.34390000000002</c:v>
                </c:pt>
                <c:pt idx="1">
                  <c:v>423.00310000000002</c:v>
                </c:pt>
                <c:pt idx="2">
                  <c:v>481.75060000000002</c:v>
                </c:pt>
                <c:pt idx="3">
                  <c:v>626.45000000000005</c:v>
                </c:pt>
                <c:pt idx="4">
                  <c:v>472.77020000000005</c:v>
                </c:pt>
                <c:pt idx="5">
                  <c:v>537.18000000000006</c:v>
                </c:pt>
                <c:pt idx="6">
                  <c:v>525.86</c:v>
                </c:pt>
                <c:pt idx="7">
                  <c:v>535.06000000000006</c:v>
                </c:pt>
                <c:pt idx="8">
                  <c:v>275.79000000000002</c:v>
                </c:pt>
                <c:pt idx="9">
                  <c:v>393.49940000000004</c:v>
                </c:pt>
                <c:pt idx="10">
                  <c:v>403.91360000000003</c:v>
                </c:pt>
                <c:pt idx="11">
                  <c:v>435.39480000000003</c:v>
                </c:pt>
                <c:pt idx="12">
                  <c:v>483.74810000000002</c:v>
                </c:pt>
                <c:pt idx="13">
                  <c:v>481.67900000000003</c:v>
                </c:pt>
                <c:pt idx="14">
                  <c:v>253.92000000000002</c:v>
                </c:pt>
                <c:pt idx="15">
                  <c:v>361.45940000000002</c:v>
                </c:pt>
                <c:pt idx="16">
                  <c:v>346.29590000000002</c:v>
                </c:pt>
                <c:pt idx="17">
                  <c:v>454.77890000000002</c:v>
                </c:pt>
                <c:pt idx="18">
                  <c:v>420.93980000000005</c:v>
                </c:pt>
                <c:pt idx="19">
                  <c:v>454.29270000000002</c:v>
                </c:pt>
                <c:pt idx="20">
                  <c:v>306.06</c:v>
                </c:pt>
                <c:pt idx="21">
                  <c:v>319.14</c:v>
                </c:pt>
                <c:pt idx="22">
                  <c:v>533.55000000000007</c:v>
                </c:pt>
                <c:pt idx="23">
                  <c:v>373.87010000000004</c:v>
                </c:pt>
                <c:pt idx="24">
                  <c:v>433.1671</c:v>
                </c:pt>
                <c:pt idx="25">
                  <c:v>91.850000000000023</c:v>
                </c:pt>
                <c:pt idx="26">
                  <c:v>429.67090000000002</c:v>
                </c:pt>
                <c:pt idx="27">
                  <c:v>372.88460000000003</c:v>
                </c:pt>
                <c:pt idx="28">
                  <c:v>421.65610000000004</c:v>
                </c:pt>
                <c:pt idx="29">
                  <c:v>350.66970000000003</c:v>
                </c:pt>
                <c:pt idx="30">
                  <c:v>417.72180000000003</c:v>
                </c:pt>
                <c:pt idx="31">
                  <c:v>397.2081</c:v>
                </c:pt>
                <c:pt idx="32">
                  <c:v>625.90000000000009</c:v>
                </c:pt>
                <c:pt idx="33">
                  <c:v>615.29</c:v>
                </c:pt>
                <c:pt idx="34">
                  <c:v>343.69760000000002</c:v>
                </c:pt>
                <c:pt idx="35">
                  <c:v>299.21000000000004</c:v>
                </c:pt>
                <c:pt idx="36">
                  <c:v>504.9101</c:v>
                </c:pt>
                <c:pt idx="37">
                  <c:v>419.65309999999999</c:v>
                </c:pt>
                <c:pt idx="38">
                  <c:v>363.25060000000002</c:v>
                </c:pt>
                <c:pt idx="39">
                  <c:v>608.78</c:v>
                </c:pt>
                <c:pt idx="40">
                  <c:v>504.87260000000003</c:v>
                </c:pt>
                <c:pt idx="41">
                  <c:v>467.27360000000004</c:v>
                </c:pt>
                <c:pt idx="42">
                  <c:v>280.86</c:v>
                </c:pt>
                <c:pt idx="43">
                  <c:v>223.18</c:v>
                </c:pt>
                <c:pt idx="44">
                  <c:v>566.57000000000005</c:v>
                </c:pt>
                <c:pt idx="45">
                  <c:v>272.83000000000004</c:v>
                </c:pt>
                <c:pt idx="46">
                  <c:v>137.79000000000002</c:v>
                </c:pt>
                <c:pt idx="47">
                  <c:v>388.66730000000001</c:v>
                </c:pt>
                <c:pt idx="48">
                  <c:v>573.47</c:v>
                </c:pt>
                <c:pt idx="49">
                  <c:v>327.43299999999999</c:v>
                </c:pt>
                <c:pt idx="50">
                  <c:v>395.00260000000003</c:v>
                </c:pt>
                <c:pt idx="51">
                  <c:v>282.08000000000004</c:v>
                </c:pt>
                <c:pt idx="52">
                  <c:v>607.54999999999995</c:v>
                </c:pt>
                <c:pt idx="53">
                  <c:v>439.55620000000005</c:v>
                </c:pt>
                <c:pt idx="54">
                  <c:v>501.88820000000004</c:v>
                </c:pt>
                <c:pt idx="55">
                  <c:v>385.36560000000003</c:v>
                </c:pt>
                <c:pt idx="56">
                  <c:v>428.33280000000002</c:v>
                </c:pt>
                <c:pt idx="57">
                  <c:v>309.31</c:v>
                </c:pt>
                <c:pt idx="58">
                  <c:v>339.08300000000003</c:v>
                </c:pt>
                <c:pt idx="59">
                  <c:v>238.79000000000002</c:v>
                </c:pt>
                <c:pt idx="60">
                  <c:v>542.98</c:v>
                </c:pt>
                <c:pt idx="61">
                  <c:v>498.95600000000002</c:v>
                </c:pt>
                <c:pt idx="62">
                  <c:v>469.9649</c:v>
                </c:pt>
                <c:pt idx="63">
                  <c:v>214.83</c:v>
                </c:pt>
                <c:pt idx="64">
                  <c:v>484.03720000000004</c:v>
                </c:pt>
                <c:pt idx="65">
                  <c:v>394.65620000000001</c:v>
                </c:pt>
                <c:pt idx="66">
                  <c:v>438.01859999999999</c:v>
                </c:pt>
                <c:pt idx="67">
                  <c:v>412.68260000000004</c:v>
                </c:pt>
                <c:pt idx="68">
                  <c:v>338.33230000000003</c:v>
                </c:pt>
                <c:pt idx="69">
                  <c:v>399.6771</c:v>
                </c:pt>
                <c:pt idx="70">
                  <c:v>152.68</c:v>
                </c:pt>
                <c:pt idx="71">
                  <c:v>195.93</c:v>
                </c:pt>
                <c:pt idx="72">
                  <c:v>456.17630000000003</c:v>
                </c:pt>
                <c:pt idx="73">
                  <c:v>320.43</c:v>
                </c:pt>
                <c:pt idx="74">
                  <c:v>509.08000000000004</c:v>
                </c:pt>
                <c:pt idx="75">
                  <c:v>477.14600000000002</c:v>
                </c:pt>
                <c:pt idx="76">
                  <c:v>481.72820000000002</c:v>
                </c:pt>
                <c:pt idx="77">
                  <c:v>407.5881</c:v>
                </c:pt>
                <c:pt idx="78">
                  <c:v>474.23530000000005</c:v>
                </c:pt>
                <c:pt idx="79">
                  <c:v>262.05</c:v>
                </c:pt>
                <c:pt idx="80">
                  <c:v>415.33500000000004</c:v>
                </c:pt>
                <c:pt idx="81">
                  <c:v>772.44</c:v>
                </c:pt>
                <c:pt idx="82">
                  <c:v>355.33340000000004</c:v>
                </c:pt>
                <c:pt idx="83">
                  <c:v>376.97670000000005</c:v>
                </c:pt>
                <c:pt idx="84">
                  <c:v>293.34000000000003</c:v>
                </c:pt>
                <c:pt idx="85">
                  <c:v>334.13010000000003</c:v>
                </c:pt>
                <c:pt idx="86">
                  <c:v>276.28000000000003</c:v>
                </c:pt>
                <c:pt idx="87">
                  <c:v>263.83000000000004</c:v>
                </c:pt>
                <c:pt idx="88">
                  <c:v>206.23000000000002</c:v>
                </c:pt>
                <c:pt idx="89">
                  <c:v>381.62760000000003</c:v>
                </c:pt>
                <c:pt idx="90">
                  <c:v>328.73940000000005</c:v>
                </c:pt>
                <c:pt idx="91">
                  <c:v>293.63</c:v>
                </c:pt>
                <c:pt idx="92">
                  <c:v>498.8836</c:v>
                </c:pt>
                <c:pt idx="93">
                  <c:v>438.8236</c:v>
                </c:pt>
                <c:pt idx="94">
                  <c:v>497.27480000000003</c:v>
                </c:pt>
                <c:pt idx="95">
                  <c:v>356.16340000000002</c:v>
                </c:pt>
                <c:pt idx="96">
                  <c:v>277.02</c:v>
                </c:pt>
                <c:pt idx="97">
                  <c:v>460.03710000000001</c:v>
                </c:pt>
                <c:pt idx="98">
                  <c:v>478.09500000000003</c:v>
                </c:pt>
                <c:pt idx="99">
                  <c:v>415.91140000000001</c:v>
                </c:pt>
                <c:pt idx="100">
                  <c:v>444.51350000000002</c:v>
                </c:pt>
                <c:pt idx="101">
                  <c:v>342.86220000000003</c:v>
                </c:pt>
                <c:pt idx="102">
                  <c:v>516.05590000000007</c:v>
                </c:pt>
                <c:pt idx="103">
                  <c:v>367.99340000000001</c:v>
                </c:pt>
                <c:pt idx="104">
                  <c:v>347.17930000000001</c:v>
                </c:pt>
                <c:pt idx="105">
                  <c:v>366.4957</c:v>
                </c:pt>
                <c:pt idx="106">
                  <c:v>460.88690000000003</c:v>
                </c:pt>
                <c:pt idx="107">
                  <c:v>497.68870000000004</c:v>
                </c:pt>
                <c:pt idx="108">
                  <c:v>463.35840000000002</c:v>
                </c:pt>
                <c:pt idx="109">
                  <c:v>440.25670000000002</c:v>
                </c:pt>
                <c:pt idx="110">
                  <c:v>478.66410000000002</c:v>
                </c:pt>
                <c:pt idx="111">
                  <c:v>363.78470000000004</c:v>
                </c:pt>
                <c:pt idx="112">
                  <c:v>283.04000000000002</c:v>
                </c:pt>
                <c:pt idx="113">
                  <c:v>573</c:v>
                </c:pt>
                <c:pt idx="114">
                  <c:v>416.52090000000004</c:v>
                </c:pt>
                <c:pt idx="115">
                  <c:v>557.97</c:v>
                </c:pt>
                <c:pt idx="116">
                  <c:v>503.47750000000002</c:v>
                </c:pt>
                <c:pt idx="117">
                  <c:v>325.01490000000001</c:v>
                </c:pt>
                <c:pt idx="118">
                  <c:v>572.89</c:v>
                </c:pt>
                <c:pt idx="119">
                  <c:v>336.55510000000004</c:v>
                </c:pt>
                <c:pt idx="120">
                  <c:v>393.62120000000004</c:v>
                </c:pt>
                <c:pt idx="121">
                  <c:v>357.36850000000004</c:v>
                </c:pt>
                <c:pt idx="122">
                  <c:v>434.56790000000001</c:v>
                </c:pt>
                <c:pt idx="123">
                  <c:v>531.33000000000004</c:v>
                </c:pt>
                <c:pt idx="124">
                  <c:v>613.95000000000005</c:v>
                </c:pt>
                <c:pt idx="125">
                  <c:v>366.53770000000003</c:v>
                </c:pt>
                <c:pt idx="126">
                  <c:v>603.54999999999995</c:v>
                </c:pt>
                <c:pt idx="127">
                  <c:v>495.14910000000003</c:v>
                </c:pt>
                <c:pt idx="128">
                  <c:v>482.07990000000001</c:v>
                </c:pt>
                <c:pt idx="129">
                  <c:v>393.82560000000001</c:v>
                </c:pt>
                <c:pt idx="130">
                  <c:v>439.85550000000001</c:v>
                </c:pt>
                <c:pt idx="131">
                  <c:v>461.19490000000002</c:v>
                </c:pt>
                <c:pt idx="132">
                  <c:v>322.83570000000003</c:v>
                </c:pt>
                <c:pt idx="133">
                  <c:v>396.61290000000002</c:v>
                </c:pt>
                <c:pt idx="134">
                  <c:v>369.37760000000003</c:v>
                </c:pt>
                <c:pt idx="135">
                  <c:v>486.6533</c:v>
                </c:pt>
                <c:pt idx="136">
                  <c:v>427.49420000000003</c:v>
                </c:pt>
                <c:pt idx="137">
                  <c:v>603</c:v>
                </c:pt>
                <c:pt idx="138">
                  <c:v>326.77680000000004</c:v>
                </c:pt>
                <c:pt idx="139">
                  <c:v>422.03530000000001</c:v>
                </c:pt>
                <c:pt idx="140">
                  <c:v>488.47900000000004</c:v>
                </c:pt>
                <c:pt idx="141">
                  <c:v>402.6397</c:v>
                </c:pt>
                <c:pt idx="142">
                  <c:v>372.78480000000002</c:v>
                </c:pt>
                <c:pt idx="143">
                  <c:v>443.49110000000002</c:v>
                </c:pt>
                <c:pt idx="144">
                  <c:v>531.04</c:v>
                </c:pt>
                <c:pt idx="145">
                  <c:v>459.19310000000002</c:v>
                </c:pt>
                <c:pt idx="146">
                  <c:v>415.97950000000003</c:v>
                </c:pt>
                <c:pt idx="147">
                  <c:v>550.31000000000006</c:v>
                </c:pt>
                <c:pt idx="148">
                  <c:v>551.57000000000005</c:v>
                </c:pt>
                <c:pt idx="149">
                  <c:v>454.40090000000004</c:v>
                </c:pt>
                <c:pt idx="150">
                  <c:v>535.83000000000004</c:v>
                </c:pt>
                <c:pt idx="151">
                  <c:v>366.3691</c:v>
                </c:pt>
                <c:pt idx="152">
                  <c:v>557.24</c:v>
                </c:pt>
                <c:pt idx="153">
                  <c:v>323.58720000000005</c:v>
                </c:pt>
                <c:pt idx="154">
                  <c:v>370.89179999999999</c:v>
                </c:pt>
                <c:pt idx="155">
                  <c:v>391.8759</c:v>
                </c:pt>
                <c:pt idx="156">
                  <c:v>353.44040000000001</c:v>
                </c:pt>
                <c:pt idx="157">
                  <c:v>453.22720000000004</c:v>
                </c:pt>
                <c:pt idx="158">
                  <c:v>548.15</c:v>
                </c:pt>
                <c:pt idx="159">
                  <c:v>373.58969999999999</c:v>
                </c:pt>
                <c:pt idx="160">
                  <c:v>606.22</c:v>
                </c:pt>
                <c:pt idx="161">
                  <c:v>469.55020000000002</c:v>
                </c:pt>
                <c:pt idx="162">
                  <c:v>483.18650000000002</c:v>
                </c:pt>
                <c:pt idx="163">
                  <c:v>563.29999999999995</c:v>
                </c:pt>
                <c:pt idx="164">
                  <c:v>548.17000000000007</c:v>
                </c:pt>
                <c:pt idx="165">
                  <c:v>530.71</c:v>
                </c:pt>
                <c:pt idx="166">
                  <c:v>370.2473</c:v>
                </c:pt>
                <c:pt idx="167">
                  <c:v>288.35000000000002</c:v>
                </c:pt>
                <c:pt idx="168">
                  <c:v>569.85</c:v>
                </c:pt>
                <c:pt idx="169">
                  <c:v>525.74</c:v>
                </c:pt>
                <c:pt idx="170">
                  <c:v>492.65840000000003</c:v>
                </c:pt>
                <c:pt idx="171">
                  <c:v>431.08190000000002</c:v>
                </c:pt>
                <c:pt idx="172">
                  <c:v>464.52360000000004</c:v>
                </c:pt>
                <c:pt idx="173">
                  <c:v>418.36970000000002</c:v>
                </c:pt>
                <c:pt idx="174">
                  <c:v>418.44330000000002</c:v>
                </c:pt>
                <c:pt idx="175">
                  <c:v>450.77660000000003</c:v>
                </c:pt>
                <c:pt idx="176">
                  <c:v>420.03919999999999</c:v>
                </c:pt>
                <c:pt idx="177">
                  <c:v>629.34</c:v>
                </c:pt>
                <c:pt idx="178">
                  <c:v>449.93470000000002</c:v>
                </c:pt>
                <c:pt idx="179">
                  <c:v>519.76510000000007</c:v>
                </c:pt>
                <c:pt idx="180">
                  <c:v>444.69060000000002</c:v>
                </c:pt>
                <c:pt idx="181">
                  <c:v>335.59700000000004</c:v>
                </c:pt>
                <c:pt idx="182">
                  <c:v>557.67000000000007</c:v>
                </c:pt>
                <c:pt idx="183">
                  <c:v>191.71</c:v>
                </c:pt>
                <c:pt idx="184">
                  <c:v>432.1345</c:v>
                </c:pt>
                <c:pt idx="185">
                  <c:v>490.69820000000004</c:v>
                </c:pt>
                <c:pt idx="186">
                  <c:v>430.90550000000002</c:v>
                </c:pt>
                <c:pt idx="187">
                  <c:v>440.43420000000003</c:v>
                </c:pt>
                <c:pt idx="188">
                  <c:v>526.53</c:v>
                </c:pt>
                <c:pt idx="189">
                  <c:v>481.33480000000003</c:v>
                </c:pt>
                <c:pt idx="190">
                  <c:v>398.55860000000001</c:v>
                </c:pt>
                <c:pt idx="191">
                  <c:v>442.94140000000004</c:v>
                </c:pt>
                <c:pt idx="192">
                  <c:v>431.83920000000001</c:v>
                </c:pt>
                <c:pt idx="193">
                  <c:v>310.75</c:v>
                </c:pt>
                <c:pt idx="194">
                  <c:v>344.46620000000001</c:v>
                </c:pt>
                <c:pt idx="195">
                  <c:v>407.97900000000004</c:v>
                </c:pt>
                <c:pt idx="196">
                  <c:v>556.83000000000004</c:v>
                </c:pt>
                <c:pt idx="197">
                  <c:v>458.0838</c:v>
                </c:pt>
                <c:pt idx="198">
                  <c:v>381.88150000000002</c:v>
                </c:pt>
                <c:pt idx="199">
                  <c:v>575.09</c:v>
                </c:pt>
                <c:pt idx="200">
                  <c:v>274.03000000000003</c:v>
                </c:pt>
                <c:pt idx="201">
                  <c:v>345.8263</c:v>
                </c:pt>
                <c:pt idx="202">
                  <c:v>469.21930000000003</c:v>
                </c:pt>
                <c:pt idx="203">
                  <c:v>333.3152</c:v>
                </c:pt>
                <c:pt idx="204">
                  <c:v>537.31000000000006</c:v>
                </c:pt>
                <c:pt idx="205">
                  <c:v>259.13</c:v>
                </c:pt>
                <c:pt idx="206">
                  <c:v>447.68550000000005</c:v>
                </c:pt>
                <c:pt idx="207">
                  <c:v>336.12110000000001</c:v>
                </c:pt>
                <c:pt idx="208">
                  <c:v>371.80080000000004</c:v>
                </c:pt>
                <c:pt idx="209">
                  <c:v>414.0018</c:v>
                </c:pt>
                <c:pt idx="210">
                  <c:v>435.0367</c:v>
                </c:pt>
                <c:pt idx="211">
                  <c:v>441.51370000000003</c:v>
                </c:pt>
                <c:pt idx="212">
                  <c:v>425.70230000000004</c:v>
                </c:pt>
                <c:pt idx="213">
                  <c:v>330.15520000000004</c:v>
                </c:pt>
                <c:pt idx="214">
                  <c:v>436.83010000000002</c:v>
                </c:pt>
                <c:pt idx="215">
                  <c:v>480.46180000000004</c:v>
                </c:pt>
                <c:pt idx="216">
                  <c:v>200.57000000000002</c:v>
                </c:pt>
                <c:pt idx="217">
                  <c:v>289.5</c:v>
                </c:pt>
                <c:pt idx="218">
                  <c:v>298.40000000000003</c:v>
                </c:pt>
                <c:pt idx="219">
                  <c:v>518.88750000000005</c:v>
                </c:pt>
                <c:pt idx="220">
                  <c:v>239.24</c:v>
                </c:pt>
                <c:pt idx="221">
                  <c:v>444.67330000000004</c:v>
                </c:pt>
                <c:pt idx="222">
                  <c:v>481.33430000000004</c:v>
                </c:pt>
                <c:pt idx="223">
                  <c:v>251.62000000000003</c:v>
                </c:pt>
                <c:pt idx="224">
                  <c:v>377.38240000000002</c:v>
                </c:pt>
                <c:pt idx="225">
                  <c:v>551.79999999999995</c:v>
                </c:pt>
                <c:pt idx="226">
                  <c:v>291.05</c:v>
                </c:pt>
                <c:pt idx="227">
                  <c:v>222.36</c:v>
                </c:pt>
                <c:pt idx="228">
                  <c:v>553.94000000000005</c:v>
                </c:pt>
                <c:pt idx="229">
                  <c:v>298.47000000000003</c:v>
                </c:pt>
                <c:pt idx="230">
                  <c:v>543.94000000000005</c:v>
                </c:pt>
                <c:pt idx="231">
                  <c:v>370.5566</c:v>
                </c:pt>
                <c:pt idx="232">
                  <c:v>442.8766</c:v>
                </c:pt>
                <c:pt idx="233">
                  <c:v>393.99150000000003</c:v>
                </c:pt>
                <c:pt idx="234">
                  <c:v>325.93230000000005</c:v>
                </c:pt>
                <c:pt idx="235">
                  <c:v>352.61099999999999</c:v>
                </c:pt>
                <c:pt idx="236">
                  <c:v>488.87210000000005</c:v>
                </c:pt>
                <c:pt idx="237">
                  <c:v>205.14000000000001</c:v>
                </c:pt>
                <c:pt idx="238">
                  <c:v>387.38560000000001</c:v>
                </c:pt>
                <c:pt idx="239">
                  <c:v>386.8775</c:v>
                </c:pt>
                <c:pt idx="240">
                  <c:v>483.5231</c:v>
                </c:pt>
                <c:pt idx="241">
                  <c:v>356.71960000000001</c:v>
                </c:pt>
                <c:pt idx="242">
                  <c:v>377.71610000000004</c:v>
                </c:pt>
                <c:pt idx="243">
                  <c:v>765.06</c:v>
                </c:pt>
                <c:pt idx="244">
                  <c:v>470.23390000000001</c:v>
                </c:pt>
                <c:pt idx="245">
                  <c:v>603.63</c:v>
                </c:pt>
                <c:pt idx="246">
                  <c:v>493.09880000000004</c:v>
                </c:pt>
                <c:pt idx="247">
                  <c:v>187.51000000000002</c:v>
                </c:pt>
                <c:pt idx="248">
                  <c:v>535.94000000000005</c:v>
                </c:pt>
                <c:pt idx="249">
                  <c:v>378.09380000000004</c:v>
                </c:pt>
                <c:pt idx="250">
                  <c:v>565.64</c:v>
                </c:pt>
                <c:pt idx="251">
                  <c:v>456.04220000000004</c:v>
                </c:pt>
                <c:pt idx="252">
                  <c:v>365.21590000000003</c:v>
                </c:pt>
                <c:pt idx="253">
                  <c:v>563.76</c:v>
                </c:pt>
                <c:pt idx="254">
                  <c:v>458.27680000000004</c:v>
                </c:pt>
                <c:pt idx="255">
                  <c:v>176.84000000000003</c:v>
                </c:pt>
                <c:pt idx="256">
                  <c:v>339.63060000000002</c:v>
                </c:pt>
                <c:pt idx="257">
                  <c:v>587.38</c:v>
                </c:pt>
                <c:pt idx="258">
                  <c:v>534.14</c:v>
                </c:pt>
                <c:pt idx="259">
                  <c:v>307.32000000000005</c:v>
                </c:pt>
                <c:pt idx="260">
                  <c:v>424.89090000000004</c:v>
                </c:pt>
                <c:pt idx="261">
                  <c:v>282.3</c:v>
                </c:pt>
                <c:pt idx="262">
                  <c:v>469.8415</c:v>
                </c:pt>
                <c:pt idx="263">
                  <c:v>403.82480000000004</c:v>
                </c:pt>
                <c:pt idx="264">
                  <c:v>251.57000000000002</c:v>
                </c:pt>
                <c:pt idx="265">
                  <c:v>512.05000000000007</c:v>
                </c:pt>
                <c:pt idx="266">
                  <c:v>289.41000000000003</c:v>
                </c:pt>
                <c:pt idx="267">
                  <c:v>379.75200000000001</c:v>
                </c:pt>
                <c:pt idx="268">
                  <c:v>331.1232</c:v>
                </c:pt>
                <c:pt idx="269">
                  <c:v>454.4194</c:v>
                </c:pt>
                <c:pt idx="270">
                  <c:v>547.71</c:v>
                </c:pt>
                <c:pt idx="271">
                  <c:v>475.65470000000005</c:v>
                </c:pt>
                <c:pt idx="272">
                  <c:v>276.3</c:v>
                </c:pt>
                <c:pt idx="273">
                  <c:v>288.81000000000006</c:v>
                </c:pt>
                <c:pt idx="274">
                  <c:v>545.15</c:v>
                </c:pt>
                <c:pt idx="275">
                  <c:v>451.0949</c:v>
                </c:pt>
                <c:pt idx="276">
                  <c:v>266.58000000000004</c:v>
                </c:pt>
                <c:pt idx="277">
                  <c:v>529.22</c:v>
                </c:pt>
                <c:pt idx="278">
                  <c:v>247.04000000000002</c:v>
                </c:pt>
                <c:pt idx="279">
                  <c:v>387.57300000000004</c:v>
                </c:pt>
                <c:pt idx="280">
                  <c:v>446.48770000000002</c:v>
                </c:pt>
                <c:pt idx="281">
                  <c:v>523.52</c:v>
                </c:pt>
                <c:pt idx="282">
                  <c:v>605.65000000000009</c:v>
                </c:pt>
                <c:pt idx="283">
                  <c:v>529.11</c:v>
                </c:pt>
                <c:pt idx="284">
                  <c:v>416.65340000000003</c:v>
                </c:pt>
                <c:pt idx="285">
                  <c:v>362.72860000000003</c:v>
                </c:pt>
                <c:pt idx="286">
                  <c:v>460.49470000000002</c:v>
                </c:pt>
                <c:pt idx="287">
                  <c:v>455.57120000000003</c:v>
                </c:pt>
                <c:pt idx="288">
                  <c:v>551.97</c:v>
                </c:pt>
                <c:pt idx="289">
                  <c:v>485.12400000000002</c:v>
                </c:pt>
                <c:pt idx="290">
                  <c:v>495.34649999999999</c:v>
                </c:pt>
                <c:pt idx="291">
                  <c:v>398.45820000000003</c:v>
                </c:pt>
              </c:numCache>
            </c:numRef>
          </c:xVal>
          <c:yVal>
            <c:numRef>
              <c:f>'292RIL'!$K$2:$K$295</c:f>
              <c:numCache>
                <c:formatCode>0.00</c:formatCode>
                <c:ptCount val="294"/>
                <c:pt idx="0">
                  <c:v>62.228763290178101</c:v>
                </c:pt>
                <c:pt idx="1">
                  <c:v>58.398647092707797</c:v>
                </c:pt>
                <c:pt idx="2">
                  <c:v>67.938251841318902</c:v>
                </c:pt>
                <c:pt idx="3">
                  <c:v>77.704187246374104</c:v>
                </c:pt>
                <c:pt idx="4">
                  <c:v>56.936607797670803</c:v>
                </c:pt>
                <c:pt idx="5">
                  <c:v>58.6647073822975</c:v>
                </c:pt>
                <c:pt idx="6">
                  <c:v>72.223810597963293</c:v>
                </c:pt>
                <c:pt idx="7">
                  <c:v>67.243567647199598</c:v>
                </c:pt>
                <c:pt idx="8">
                  <c:v>47.9022004663384</c:v>
                </c:pt>
                <c:pt idx="9">
                  <c:v>62.425342227148498</c:v>
                </c:pt>
                <c:pt idx="10">
                  <c:v>58.003269178974499</c:v>
                </c:pt>
                <c:pt idx="11">
                  <c:v>55.729957707818201</c:v>
                </c:pt>
                <c:pt idx="12">
                  <c:v>68.929132899682799</c:v>
                </c:pt>
                <c:pt idx="13">
                  <c:v>69.467349869445997</c:v>
                </c:pt>
                <c:pt idx="14">
                  <c:v>43.955886393952802</c:v>
                </c:pt>
                <c:pt idx="15">
                  <c:v>48.3969850559291</c:v>
                </c:pt>
                <c:pt idx="16">
                  <c:v>47.734581566811499</c:v>
                </c:pt>
                <c:pt idx="17">
                  <c:v>53.963149336327</c:v>
                </c:pt>
                <c:pt idx="18">
                  <c:v>60.474570657113397</c:v>
                </c:pt>
                <c:pt idx="19">
                  <c:v>52.714785172957697</c:v>
                </c:pt>
                <c:pt idx="20">
                  <c:v>50.551641525222799</c:v>
                </c:pt>
                <c:pt idx="21">
                  <c:v>44.936317781137397</c:v>
                </c:pt>
                <c:pt idx="22">
                  <c:v>67.180766436604998</c:v>
                </c:pt>
                <c:pt idx="23">
                  <c:v>43.189913444553198</c:v>
                </c:pt>
                <c:pt idx="24">
                  <c:v>60.411170331965799</c:v>
                </c:pt>
                <c:pt idx="25">
                  <c:v>14.947028411218801</c:v>
                </c:pt>
                <c:pt idx="26">
                  <c:v>61.254846791595099</c:v>
                </c:pt>
                <c:pt idx="27">
                  <c:v>60.001715008676399</c:v>
                </c:pt>
                <c:pt idx="28">
                  <c:v>55.673661293305898</c:v>
                </c:pt>
                <c:pt idx="29">
                  <c:v>42.747807207142202</c:v>
                </c:pt>
                <c:pt idx="30">
                  <c:v>59.312503195903602</c:v>
                </c:pt>
                <c:pt idx="31">
                  <c:v>47.9983750350425</c:v>
                </c:pt>
                <c:pt idx="32">
                  <c:v>77.322276540066696</c:v>
                </c:pt>
                <c:pt idx="33">
                  <c:v>62.775785928698298</c:v>
                </c:pt>
                <c:pt idx="34">
                  <c:v>50.822938767402597</c:v>
                </c:pt>
                <c:pt idx="35">
                  <c:v>42.887768697559103</c:v>
                </c:pt>
                <c:pt idx="36">
                  <c:v>69.030662323876797</c:v>
                </c:pt>
                <c:pt idx="37">
                  <c:v>55.334032984598799</c:v>
                </c:pt>
                <c:pt idx="38">
                  <c:v>49.673041508934098</c:v>
                </c:pt>
                <c:pt idx="39">
                  <c:v>65.713870125904194</c:v>
                </c:pt>
                <c:pt idx="40">
                  <c:v>67.514002975373003</c:v>
                </c:pt>
                <c:pt idx="41">
                  <c:v>63.167526608214402</c:v>
                </c:pt>
                <c:pt idx="42">
                  <c:v>50.186291154217301</c:v>
                </c:pt>
                <c:pt idx="43">
                  <c:v>34.023256329648902</c:v>
                </c:pt>
                <c:pt idx="44">
                  <c:v>66.426277180282995</c:v>
                </c:pt>
                <c:pt idx="45">
                  <c:v>37.049953932151901</c:v>
                </c:pt>
                <c:pt idx="46">
                  <c:v>23.130219489150502</c:v>
                </c:pt>
                <c:pt idx="47">
                  <c:v>62.599536814255003</c:v>
                </c:pt>
                <c:pt idx="48">
                  <c:v>63.951103420073203</c:v>
                </c:pt>
                <c:pt idx="49">
                  <c:v>45.035331177826997</c:v>
                </c:pt>
                <c:pt idx="50">
                  <c:v>59.989490169730601</c:v>
                </c:pt>
                <c:pt idx="51">
                  <c:v>44.920242687760599</c:v>
                </c:pt>
                <c:pt idx="52">
                  <c:v>73.190256658584403</c:v>
                </c:pt>
                <c:pt idx="53">
                  <c:v>69.259823719268496</c:v>
                </c:pt>
                <c:pt idx="54">
                  <c:v>70.106101221638397</c:v>
                </c:pt>
                <c:pt idx="55">
                  <c:v>53.128841810669499</c:v>
                </c:pt>
                <c:pt idx="56">
                  <c:v>57.182594448297699</c:v>
                </c:pt>
                <c:pt idx="57">
                  <c:v>45.185689781243902</c:v>
                </c:pt>
                <c:pt idx="58">
                  <c:v>48.567972620586097</c:v>
                </c:pt>
                <c:pt idx="59">
                  <c:v>33.939468697867902</c:v>
                </c:pt>
                <c:pt idx="60">
                  <c:v>72.375143850000796</c:v>
                </c:pt>
                <c:pt idx="61">
                  <c:v>65.615017756812307</c:v>
                </c:pt>
                <c:pt idx="62">
                  <c:v>67.267258905588804</c:v>
                </c:pt>
                <c:pt idx="63">
                  <c:v>33.415359570950301</c:v>
                </c:pt>
                <c:pt idx="64">
                  <c:v>54.817736838917902</c:v>
                </c:pt>
                <c:pt idx="65">
                  <c:v>54.9046756138464</c:v>
                </c:pt>
                <c:pt idx="66">
                  <c:v>63.3775490974256</c:v>
                </c:pt>
                <c:pt idx="67">
                  <c:v>57.305730991656603</c:v>
                </c:pt>
                <c:pt idx="68">
                  <c:v>43.762730952829003</c:v>
                </c:pt>
                <c:pt idx="69">
                  <c:v>47.346116856653602</c:v>
                </c:pt>
                <c:pt idx="70">
                  <c:v>26.117868609791302</c:v>
                </c:pt>
                <c:pt idx="71">
                  <c:v>31.070496911565801</c:v>
                </c:pt>
                <c:pt idx="72">
                  <c:v>55.4780246612479</c:v>
                </c:pt>
                <c:pt idx="73">
                  <c:v>43.838755589278101</c:v>
                </c:pt>
                <c:pt idx="74">
                  <c:v>68.231644802832903</c:v>
                </c:pt>
                <c:pt idx="75">
                  <c:v>69.388084225036195</c:v>
                </c:pt>
                <c:pt idx="76">
                  <c:v>68.083686893998504</c:v>
                </c:pt>
                <c:pt idx="77">
                  <c:v>57.362631083849102</c:v>
                </c:pt>
                <c:pt idx="78">
                  <c:v>69.581218258306194</c:v>
                </c:pt>
                <c:pt idx="79">
                  <c:v>38.525775575964502</c:v>
                </c:pt>
                <c:pt idx="80">
                  <c:v>49.919442690220897</c:v>
                </c:pt>
                <c:pt idx="81">
                  <c:v>89.761608279646296</c:v>
                </c:pt>
                <c:pt idx="82">
                  <c:v>51.340608176601698</c:v>
                </c:pt>
                <c:pt idx="83">
                  <c:v>62.142554170048399</c:v>
                </c:pt>
                <c:pt idx="84">
                  <c:v>49.124964017840199</c:v>
                </c:pt>
                <c:pt idx="85">
                  <c:v>45.430878908599098</c:v>
                </c:pt>
                <c:pt idx="86">
                  <c:v>47.049721019486</c:v>
                </c:pt>
                <c:pt idx="87">
                  <c:v>40.076064527809898</c:v>
                </c:pt>
                <c:pt idx="88">
                  <c:v>30.7061183580327</c:v>
                </c:pt>
                <c:pt idx="89">
                  <c:v>53.6896236086492</c:v>
                </c:pt>
                <c:pt idx="90">
                  <c:v>45.262596811130699</c:v>
                </c:pt>
                <c:pt idx="91">
                  <c:v>49.722699699847801</c:v>
                </c:pt>
                <c:pt idx="92">
                  <c:v>68.268541944572405</c:v>
                </c:pt>
                <c:pt idx="93">
                  <c:v>56.943895381656198</c:v>
                </c:pt>
                <c:pt idx="94">
                  <c:v>64.804536499389002</c:v>
                </c:pt>
                <c:pt idx="95">
                  <c:v>49.906490528587199</c:v>
                </c:pt>
                <c:pt idx="96">
                  <c:v>41.599505592842704</c:v>
                </c:pt>
                <c:pt idx="97">
                  <c:v>55.2793148864179</c:v>
                </c:pt>
                <c:pt idx="98">
                  <c:v>67.831219248816097</c:v>
                </c:pt>
                <c:pt idx="99">
                  <c:v>71.852658229553597</c:v>
                </c:pt>
                <c:pt idx="100">
                  <c:v>62.1780589325164</c:v>
                </c:pt>
                <c:pt idx="101">
                  <c:v>44.665967511131598</c:v>
                </c:pt>
                <c:pt idx="102">
                  <c:v>73.896059301193006</c:v>
                </c:pt>
                <c:pt idx="103">
                  <c:v>51.969808160613098</c:v>
                </c:pt>
                <c:pt idx="104">
                  <c:v>59.393827564406998</c:v>
                </c:pt>
                <c:pt idx="105">
                  <c:v>46.437239872607002</c:v>
                </c:pt>
                <c:pt idx="106">
                  <c:v>59.838093580451797</c:v>
                </c:pt>
                <c:pt idx="107">
                  <c:v>61.675437469304299</c:v>
                </c:pt>
                <c:pt idx="108">
                  <c:v>64.873179933953097</c:v>
                </c:pt>
                <c:pt idx="109">
                  <c:v>60.998117668349103</c:v>
                </c:pt>
                <c:pt idx="110">
                  <c:v>57.776651778437802</c:v>
                </c:pt>
                <c:pt idx="111">
                  <c:v>53.749096416363997</c:v>
                </c:pt>
                <c:pt idx="112">
                  <c:v>40.455178520760398</c:v>
                </c:pt>
                <c:pt idx="113">
                  <c:v>64.979086326752693</c:v>
                </c:pt>
                <c:pt idx="114">
                  <c:v>54.117925526048801</c:v>
                </c:pt>
                <c:pt idx="115">
                  <c:v>69.756545713984494</c:v>
                </c:pt>
                <c:pt idx="116">
                  <c:v>68.937362637230194</c:v>
                </c:pt>
                <c:pt idx="117">
                  <c:v>53.086813767324202</c:v>
                </c:pt>
                <c:pt idx="118">
                  <c:v>68.747217221871495</c:v>
                </c:pt>
                <c:pt idx="119">
                  <c:v>53.652322233267</c:v>
                </c:pt>
                <c:pt idx="120">
                  <c:v>65.406771279427005</c:v>
                </c:pt>
                <c:pt idx="121">
                  <c:v>45.3188378110587</c:v>
                </c:pt>
                <c:pt idx="122">
                  <c:v>51.962019015966298</c:v>
                </c:pt>
                <c:pt idx="123">
                  <c:v>70.548300095799306</c:v>
                </c:pt>
                <c:pt idx="124">
                  <c:v>66.433985291178004</c:v>
                </c:pt>
                <c:pt idx="125">
                  <c:v>52.698567142806802</c:v>
                </c:pt>
                <c:pt idx="126">
                  <c:v>74.992422026640895</c:v>
                </c:pt>
                <c:pt idx="127">
                  <c:v>74.9687675728199</c:v>
                </c:pt>
                <c:pt idx="128">
                  <c:v>71.390415778272697</c:v>
                </c:pt>
                <c:pt idx="129">
                  <c:v>57.8144598550194</c:v>
                </c:pt>
                <c:pt idx="130">
                  <c:v>60.8634070558237</c:v>
                </c:pt>
                <c:pt idx="131">
                  <c:v>67.151010397833105</c:v>
                </c:pt>
                <c:pt idx="132">
                  <c:v>47.760218798772101</c:v>
                </c:pt>
                <c:pt idx="133">
                  <c:v>54.723426478951602</c:v>
                </c:pt>
                <c:pt idx="134">
                  <c:v>53.324767312468303</c:v>
                </c:pt>
                <c:pt idx="135">
                  <c:v>68.716062737809693</c:v>
                </c:pt>
                <c:pt idx="136">
                  <c:v>60.690622176783499</c:v>
                </c:pt>
                <c:pt idx="137">
                  <c:v>73.2726824605584</c:v>
                </c:pt>
                <c:pt idx="138">
                  <c:v>48.907363720225497</c:v>
                </c:pt>
                <c:pt idx="139">
                  <c:v>56.5282803310741</c:v>
                </c:pt>
                <c:pt idx="140">
                  <c:v>60.494691742409699</c:v>
                </c:pt>
                <c:pt idx="141">
                  <c:v>52.182556029250598</c:v>
                </c:pt>
                <c:pt idx="142">
                  <c:v>54.684124062309102</c:v>
                </c:pt>
                <c:pt idx="143">
                  <c:v>67.619307090393207</c:v>
                </c:pt>
                <c:pt idx="144">
                  <c:v>81.526557176821697</c:v>
                </c:pt>
                <c:pt idx="145">
                  <c:v>68.515192646184104</c:v>
                </c:pt>
                <c:pt idx="146">
                  <c:v>58.534088171506497</c:v>
                </c:pt>
                <c:pt idx="147">
                  <c:v>71.400439720775196</c:v>
                </c:pt>
                <c:pt idx="148">
                  <c:v>75.839446066971306</c:v>
                </c:pt>
                <c:pt idx="149">
                  <c:v>53.143145413158202</c:v>
                </c:pt>
                <c:pt idx="150">
                  <c:v>77.876863084471594</c:v>
                </c:pt>
                <c:pt idx="151">
                  <c:v>47.682791215634801</c:v>
                </c:pt>
                <c:pt idx="152">
                  <c:v>76.746646656122493</c:v>
                </c:pt>
                <c:pt idx="153">
                  <c:v>39.852888155989397</c:v>
                </c:pt>
                <c:pt idx="154">
                  <c:v>53.453998817307202</c:v>
                </c:pt>
                <c:pt idx="155">
                  <c:v>57.708977902140496</c:v>
                </c:pt>
                <c:pt idx="156">
                  <c:v>46.9863920382953</c:v>
                </c:pt>
                <c:pt idx="157">
                  <c:v>55.051136690148702</c:v>
                </c:pt>
                <c:pt idx="158">
                  <c:v>76.917340308128104</c:v>
                </c:pt>
                <c:pt idx="159">
                  <c:v>54.586982260412398</c:v>
                </c:pt>
                <c:pt idx="160">
                  <c:v>72.523284204896996</c:v>
                </c:pt>
                <c:pt idx="161">
                  <c:v>55.345648018814998</c:v>
                </c:pt>
                <c:pt idx="162">
                  <c:v>68.170838633156194</c:v>
                </c:pt>
                <c:pt idx="163">
                  <c:v>78.481274906535901</c:v>
                </c:pt>
                <c:pt idx="164">
                  <c:v>65.587733497379702</c:v>
                </c:pt>
                <c:pt idx="165">
                  <c:v>66.265035589739995</c:v>
                </c:pt>
                <c:pt idx="166">
                  <c:v>50.801745052524197</c:v>
                </c:pt>
                <c:pt idx="167">
                  <c:v>42.737939090985897</c:v>
                </c:pt>
                <c:pt idx="168">
                  <c:v>76.994456563937703</c:v>
                </c:pt>
                <c:pt idx="169">
                  <c:v>67.865986734055994</c:v>
                </c:pt>
                <c:pt idx="170">
                  <c:v>61.558470737030298</c:v>
                </c:pt>
                <c:pt idx="171">
                  <c:v>49.603164956258297</c:v>
                </c:pt>
                <c:pt idx="172">
                  <c:v>55.945418222928602</c:v>
                </c:pt>
                <c:pt idx="173">
                  <c:v>53.7932613890356</c:v>
                </c:pt>
                <c:pt idx="174">
                  <c:v>62.649828718977702</c:v>
                </c:pt>
                <c:pt idx="175">
                  <c:v>57.636055591277703</c:v>
                </c:pt>
                <c:pt idx="176">
                  <c:v>52.636521659307903</c:v>
                </c:pt>
                <c:pt idx="177">
                  <c:v>74.939789527598506</c:v>
                </c:pt>
                <c:pt idx="178">
                  <c:v>61.9327308905781</c:v>
                </c:pt>
                <c:pt idx="179">
                  <c:v>73.705330053414301</c:v>
                </c:pt>
                <c:pt idx="180">
                  <c:v>53.455930775373602</c:v>
                </c:pt>
                <c:pt idx="181">
                  <c:v>55.319810916211601</c:v>
                </c:pt>
                <c:pt idx="182">
                  <c:v>66.918111511030503</c:v>
                </c:pt>
                <c:pt idx="183">
                  <c:v>34.500168144843798</c:v>
                </c:pt>
                <c:pt idx="184">
                  <c:v>59.8671515487977</c:v>
                </c:pt>
                <c:pt idx="185">
                  <c:v>60.272865517870599</c:v>
                </c:pt>
                <c:pt idx="186">
                  <c:v>58.519176591984497</c:v>
                </c:pt>
                <c:pt idx="187">
                  <c:v>68.522972826877904</c:v>
                </c:pt>
                <c:pt idx="188">
                  <c:v>64.822843823809706</c:v>
                </c:pt>
                <c:pt idx="189">
                  <c:v>54.522125727556102</c:v>
                </c:pt>
                <c:pt idx="190">
                  <c:v>52.424747538961</c:v>
                </c:pt>
                <c:pt idx="191">
                  <c:v>52.471069252183</c:v>
                </c:pt>
                <c:pt idx="192">
                  <c:v>63.076170525134003</c:v>
                </c:pt>
                <c:pt idx="193">
                  <c:v>51.943395406610598</c:v>
                </c:pt>
                <c:pt idx="194">
                  <c:v>49.5141927031774</c:v>
                </c:pt>
                <c:pt idx="195">
                  <c:v>50.661701913418703</c:v>
                </c:pt>
                <c:pt idx="196">
                  <c:v>73.346381089243394</c:v>
                </c:pt>
                <c:pt idx="197">
                  <c:v>68.126170211203103</c:v>
                </c:pt>
                <c:pt idx="198">
                  <c:v>48.661076108408203</c:v>
                </c:pt>
                <c:pt idx="199">
                  <c:v>77.443033621398598</c:v>
                </c:pt>
                <c:pt idx="200">
                  <c:v>39.594267115784298</c:v>
                </c:pt>
                <c:pt idx="201">
                  <c:v>55.441086830721098</c:v>
                </c:pt>
                <c:pt idx="202">
                  <c:v>66.357265447804295</c:v>
                </c:pt>
                <c:pt idx="203">
                  <c:v>48.799422674181201</c:v>
                </c:pt>
                <c:pt idx="204">
                  <c:v>57.315104505564399</c:v>
                </c:pt>
                <c:pt idx="205">
                  <c:v>39.572211267588997</c:v>
                </c:pt>
                <c:pt idx="206">
                  <c:v>64.57069229679</c:v>
                </c:pt>
                <c:pt idx="207">
                  <c:v>44.3883794588074</c:v>
                </c:pt>
                <c:pt idx="208">
                  <c:v>55.7383861014887</c:v>
                </c:pt>
                <c:pt idx="209">
                  <c:v>55.409576347470797</c:v>
                </c:pt>
                <c:pt idx="210">
                  <c:v>59.578954766288497</c:v>
                </c:pt>
                <c:pt idx="211">
                  <c:v>49.5773399118832</c:v>
                </c:pt>
                <c:pt idx="212">
                  <c:v>52.4861316331965</c:v>
                </c:pt>
                <c:pt idx="213">
                  <c:v>42.7484113559183</c:v>
                </c:pt>
                <c:pt idx="214">
                  <c:v>57.747543127763599</c:v>
                </c:pt>
                <c:pt idx="215">
                  <c:v>71.176194423315494</c:v>
                </c:pt>
                <c:pt idx="216">
                  <c:v>30.479741215353101</c:v>
                </c:pt>
                <c:pt idx="217">
                  <c:v>44.804707868781101</c:v>
                </c:pt>
                <c:pt idx="218">
                  <c:v>50.571895257805103</c:v>
                </c:pt>
                <c:pt idx="219">
                  <c:v>59.285973094934299</c:v>
                </c:pt>
                <c:pt idx="220">
                  <c:v>34.4449869989771</c:v>
                </c:pt>
                <c:pt idx="221">
                  <c:v>53.147252028784997</c:v>
                </c:pt>
                <c:pt idx="222">
                  <c:v>61.872547565668597</c:v>
                </c:pt>
                <c:pt idx="223">
                  <c:v>38.349082435517801</c:v>
                </c:pt>
                <c:pt idx="224">
                  <c:v>57.994836855047197</c:v>
                </c:pt>
                <c:pt idx="225">
                  <c:v>77.542772529837293</c:v>
                </c:pt>
                <c:pt idx="226">
                  <c:v>48.5024956142043</c:v>
                </c:pt>
                <c:pt idx="227">
                  <c:v>36.675650741849701</c:v>
                </c:pt>
                <c:pt idx="228">
                  <c:v>68.841882979556701</c:v>
                </c:pt>
                <c:pt idx="229">
                  <c:v>53.469246146117101</c:v>
                </c:pt>
                <c:pt idx="230">
                  <c:v>77.146725226679294</c:v>
                </c:pt>
                <c:pt idx="231">
                  <c:v>49.714573677847703</c:v>
                </c:pt>
                <c:pt idx="232">
                  <c:v>72.1452047833872</c:v>
                </c:pt>
                <c:pt idx="233">
                  <c:v>61.224105229271203</c:v>
                </c:pt>
                <c:pt idx="234">
                  <c:v>54.831143955502</c:v>
                </c:pt>
                <c:pt idx="235">
                  <c:v>58.123288810507901</c:v>
                </c:pt>
                <c:pt idx="236">
                  <c:v>65.820666996051798</c:v>
                </c:pt>
                <c:pt idx="237">
                  <c:v>27.862315334933701</c:v>
                </c:pt>
                <c:pt idx="238">
                  <c:v>50.547663718224797</c:v>
                </c:pt>
                <c:pt idx="239">
                  <c:v>53.347964102649797</c:v>
                </c:pt>
                <c:pt idx="240">
                  <c:v>55.738785724877097</c:v>
                </c:pt>
                <c:pt idx="241">
                  <c:v>53.761862205532097</c:v>
                </c:pt>
                <c:pt idx="242">
                  <c:v>51.165547311828398</c:v>
                </c:pt>
                <c:pt idx="243">
                  <c:v>76.583561700425193</c:v>
                </c:pt>
                <c:pt idx="244">
                  <c:v>62.539253290501101</c:v>
                </c:pt>
                <c:pt idx="245">
                  <c:v>70.309604939792905</c:v>
                </c:pt>
                <c:pt idx="246">
                  <c:v>72.008993369485907</c:v>
                </c:pt>
                <c:pt idx="247">
                  <c:v>29.874157925509301</c:v>
                </c:pt>
                <c:pt idx="248">
                  <c:v>60.495269391364801</c:v>
                </c:pt>
                <c:pt idx="249">
                  <c:v>60.543312396194999</c:v>
                </c:pt>
                <c:pt idx="250">
                  <c:v>62.362950559233902</c:v>
                </c:pt>
                <c:pt idx="251">
                  <c:v>67.532916617211797</c:v>
                </c:pt>
                <c:pt idx="252">
                  <c:v>53.786248051335001</c:v>
                </c:pt>
                <c:pt idx="253">
                  <c:v>58.5799537320067</c:v>
                </c:pt>
                <c:pt idx="254">
                  <c:v>69.264165765486098</c:v>
                </c:pt>
                <c:pt idx="255">
                  <c:v>27.713639524670601</c:v>
                </c:pt>
                <c:pt idx="256">
                  <c:v>53.027540574231402</c:v>
                </c:pt>
                <c:pt idx="257">
                  <c:v>83.361283792046606</c:v>
                </c:pt>
                <c:pt idx="258">
                  <c:v>77.931575273137895</c:v>
                </c:pt>
                <c:pt idx="259">
                  <c:v>48.180574824539903</c:v>
                </c:pt>
                <c:pt idx="260">
                  <c:v>51.215350383177402</c:v>
                </c:pt>
                <c:pt idx="261">
                  <c:v>44.552763670319301</c:v>
                </c:pt>
                <c:pt idx="262">
                  <c:v>61.1035534093742</c:v>
                </c:pt>
                <c:pt idx="263">
                  <c:v>49.198506324979697</c:v>
                </c:pt>
                <c:pt idx="264">
                  <c:v>36.801757472518297</c:v>
                </c:pt>
                <c:pt idx="265">
                  <c:v>71.016905651463802</c:v>
                </c:pt>
                <c:pt idx="266">
                  <c:v>47.6072970072114</c:v>
                </c:pt>
                <c:pt idx="267">
                  <c:v>55.4324021030192</c:v>
                </c:pt>
                <c:pt idx="268">
                  <c:v>48.766033523268902</c:v>
                </c:pt>
                <c:pt idx="269">
                  <c:v>49.140031317307802</c:v>
                </c:pt>
                <c:pt idx="270">
                  <c:v>66.858853322077593</c:v>
                </c:pt>
                <c:pt idx="271">
                  <c:v>60.467448171316903</c:v>
                </c:pt>
                <c:pt idx="272">
                  <c:v>39.241608323173502</c:v>
                </c:pt>
                <c:pt idx="273">
                  <c:v>41.818266881949498</c:v>
                </c:pt>
                <c:pt idx="274">
                  <c:v>58.091084461038399</c:v>
                </c:pt>
                <c:pt idx="275">
                  <c:v>62.854990909693399</c:v>
                </c:pt>
                <c:pt idx="276">
                  <c:v>39.847641213764199</c:v>
                </c:pt>
                <c:pt idx="277">
                  <c:v>63.513116823478398</c:v>
                </c:pt>
                <c:pt idx="278">
                  <c:v>35.207650996949397</c:v>
                </c:pt>
                <c:pt idx="279">
                  <c:v>52.631130256452003</c:v>
                </c:pt>
                <c:pt idx="280">
                  <c:v>76.321613906962199</c:v>
                </c:pt>
                <c:pt idx="281">
                  <c:v>65.082131950152899</c:v>
                </c:pt>
                <c:pt idx="282">
                  <c:v>68.501584184559505</c:v>
                </c:pt>
                <c:pt idx="283">
                  <c:v>61.216488254482499</c:v>
                </c:pt>
                <c:pt idx="284">
                  <c:v>56.987558978432901</c:v>
                </c:pt>
                <c:pt idx="285">
                  <c:v>52.278126909927103</c:v>
                </c:pt>
                <c:pt idx="286">
                  <c:v>53.778379130412603</c:v>
                </c:pt>
                <c:pt idx="287">
                  <c:v>67.783022260063902</c:v>
                </c:pt>
                <c:pt idx="288">
                  <c:v>63.898588497955402</c:v>
                </c:pt>
                <c:pt idx="289">
                  <c:v>59.685049188367898</c:v>
                </c:pt>
                <c:pt idx="290">
                  <c:v>65.661661952138004</c:v>
                </c:pt>
                <c:pt idx="291">
                  <c:v>48.958639774978302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5061-44B2-BBE5-9D7AF1F5D2C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987833599"/>
        <c:axId val="1987522735"/>
      </c:scatterChart>
      <c:valAx>
        <c:axId val="1987833599"/>
        <c:scaling>
          <c:orientation val="minMax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.00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en-US" sz="1197" b="0" i="0" u="none" strike="noStrike" kern="1200" baseline="0">
                <a:solidFill>
                  <a:schemeClr val="dk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987522735"/>
        <c:crosses val="autoZero"/>
        <c:crossBetween val="midCat"/>
      </c:valAx>
      <c:valAx>
        <c:axId val="1987522735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.00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en-US" sz="1197" b="0" i="0" u="none" strike="noStrike" kern="1200" baseline="0">
                <a:solidFill>
                  <a:schemeClr val="dk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987833599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lang="en-US" sz="1197" b="0" i="0" u="none" strike="noStrike" kern="1200" baseline="0">
          <a:solidFill>
            <a:schemeClr val="dk1"/>
          </a:solidFill>
          <a:latin typeface="+mn-lt"/>
          <a:ea typeface="+mn-ea"/>
          <a:cs typeface="+mn-cs"/>
        </a:defRPr>
      </a:pPr>
      <a:endParaRPr lang="en-US"/>
    </a:p>
  </c:txPr>
  <c:externalData r:id="rId3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 algn="ctr" rtl="0">
              <a:defRPr lang="en-US" sz="2000" b="0" i="0" u="none" strike="noStrike" kern="1200" spc="70" baseline="0">
                <a:solidFill>
                  <a:prstClr val="black">
                    <a:lumMod val="50000"/>
                    <a:lumOff val="50000"/>
                  </a:prst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US" sz="2000" b="1" i="0" u="none" strike="noStrike" kern="1200" spc="70" baseline="0" dirty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BM-GY</a:t>
            </a:r>
          </a:p>
        </c:rich>
      </c:tx>
      <c:layout>
        <c:manualLayout>
          <c:xMode val="edge"/>
          <c:yMode val="edge"/>
          <c:x val="0.41020251934387852"/>
          <c:y val="2.7777777777777776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 algn="ctr" rtl="0">
            <a:defRPr lang="en-US" sz="2000" b="0" i="0" u="none" strike="noStrike" kern="1200" spc="70" baseline="0">
              <a:solidFill>
                <a:prstClr val="black">
                  <a:lumMod val="50000"/>
                  <a:lumOff val="50000"/>
                </a:prstClr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title>
    <c:autoTitleDeleted val="0"/>
    <c:plotArea>
      <c:layout/>
      <c:scatterChart>
        <c:scatterStyle val="lineMarker"/>
        <c:varyColors val="0"/>
        <c:ser>
          <c:idx val="0"/>
          <c:order val="0"/>
          <c:tx>
            <c:strRef>
              <c:f>'292RIL'!$K$1</c:f>
              <c:strCache>
                <c:ptCount val="1"/>
                <c:pt idx="0">
                  <c:v>GY</c:v>
                </c:pt>
              </c:strCache>
            </c:strRef>
          </c:tx>
          <c:spPr>
            <a:ln w="1905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trendline>
            <c:spPr>
              <a:ln w="19050" cap="rnd">
                <a:solidFill>
                  <a:schemeClr val="accent1"/>
                </a:solidFill>
                <a:prstDash val="sysDot"/>
              </a:ln>
              <a:effectLst/>
            </c:spPr>
            <c:trendlineType val="linear"/>
            <c:dispRSqr val="1"/>
            <c:dispEq val="1"/>
            <c:trendlineLbl>
              <c:layout>
                <c:manualLayout>
                  <c:x val="5.2764654418197728E-2"/>
                  <c:y val="-0.28976596675415572"/>
                </c:manualLayout>
              </c:layout>
              <c:tx>
                <c:rich>
                  <a:bodyPr rot="0" spcFirstLastPara="1" vertOverflow="ellipsis" vert="horz" wrap="square" anchor="ctr" anchorCtr="1"/>
                  <a:lstStyle/>
                  <a:p>
                    <a:pPr algn="ctr" rtl="0">
                      <a:defRPr lang="en-US" sz="1197" b="0" i="0" u="none" strike="noStrike" kern="1200" baseline="0">
                        <a:solidFill>
                          <a:prstClr val="black">
                            <a:lumMod val="50000"/>
                            <a:lumOff val="50000"/>
                          </a:prstClr>
                        </a:solidFill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defRPr>
                    </a:pPr>
                    <a:r>
                      <a:rPr lang="en-US" sz="1197" b="1" i="0" u="none" strike="noStrike" kern="1200" baseline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rPr>
                      <a:t>y = 0.361x + 15.722</a:t>
                    </a:r>
                    <a:br>
                      <a:rPr lang="en-US" sz="1197" b="1" i="0" u="none" strike="noStrike" kern="1200" baseline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rPr>
                    </a:br>
                    <a:r>
                      <a:rPr lang="en-US" sz="1197" b="1" i="0" u="none" strike="noStrike" kern="1200" baseline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rPr>
                      <a:t>R² = 0.5448</a:t>
                    </a:r>
                  </a:p>
                </c:rich>
              </c:tx>
              <c:numFmt formatCode="General" sourceLinked="0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anchor="ctr" anchorCtr="1"/>
                <a:lstStyle/>
                <a:p>
                  <a:pPr algn="ctr" rtl="0">
                    <a:defRPr lang="en-US" sz="1197" b="0" i="0" u="none" strike="noStrike" kern="1200" baseline="0">
                      <a:solidFill>
                        <a:prstClr val="black">
                          <a:lumMod val="50000"/>
                          <a:lumOff val="50000"/>
                        </a:prstClr>
                      </a:solidFill>
                      <a:latin typeface="Arial" panose="020B0604020202020204" pitchFamily="34" charset="0"/>
                      <a:ea typeface="+mn-ea"/>
                      <a:cs typeface="Arial" panose="020B0604020202020204" pitchFamily="34" charset="0"/>
                    </a:defRPr>
                  </a:pPr>
                  <a:endParaRPr lang="en-US"/>
                </a:p>
              </c:txPr>
            </c:trendlineLbl>
          </c:trendline>
          <c:xVal>
            <c:numRef>
              <c:f>'292RIL'!$H$2:$H$295</c:f>
              <c:numCache>
                <c:formatCode>0.00</c:formatCode>
                <c:ptCount val="294"/>
                <c:pt idx="0">
                  <c:v>148.08933572022599</c:v>
                </c:pt>
                <c:pt idx="1">
                  <c:v>94.467130763687294</c:v>
                </c:pt>
                <c:pt idx="2">
                  <c:v>104.16884255812199</c:v>
                </c:pt>
                <c:pt idx="3">
                  <c:v>155.86420058438</c:v>
                </c:pt>
                <c:pt idx="4">
                  <c:v>113.741150395362</c:v>
                </c:pt>
                <c:pt idx="5">
                  <c:v>119.974820033643</c:v>
                </c:pt>
                <c:pt idx="6">
                  <c:v>136.74965645025799</c:v>
                </c:pt>
                <c:pt idx="7">
                  <c:v>131.96325492475401</c:v>
                </c:pt>
                <c:pt idx="8">
                  <c:v>88.326715872971207</c:v>
                </c:pt>
                <c:pt idx="9">
                  <c:v>111.035253983988</c:v>
                </c:pt>
                <c:pt idx="10">
                  <c:v>142.370812582132</c:v>
                </c:pt>
                <c:pt idx="11">
                  <c:v>101.14769969573101</c:v>
                </c:pt>
                <c:pt idx="12">
                  <c:v>113.682495695556</c:v>
                </c:pt>
                <c:pt idx="13">
                  <c:v>116.563775631589</c:v>
                </c:pt>
                <c:pt idx="14">
                  <c:v>92.640404115556606</c:v>
                </c:pt>
                <c:pt idx="15">
                  <c:v>88.384381609424807</c:v>
                </c:pt>
                <c:pt idx="16">
                  <c:v>108.413196592579</c:v>
                </c:pt>
                <c:pt idx="17">
                  <c:v>133.67049762961301</c:v>
                </c:pt>
                <c:pt idx="18">
                  <c:v>135.735916332187</c:v>
                </c:pt>
                <c:pt idx="19">
                  <c:v>103.525969662756</c:v>
                </c:pt>
                <c:pt idx="20">
                  <c:v>98.839580404809496</c:v>
                </c:pt>
                <c:pt idx="21">
                  <c:v>83.923769666637895</c:v>
                </c:pt>
                <c:pt idx="22">
                  <c:v>141.15518710355499</c:v>
                </c:pt>
                <c:pt idx="23">
                  <c:v>86.440579988416104</c:v>
                </c:pt>
                <c:pt idx="24">
                  <c:v>117.588570565786</c:v>
                </c:pt>
                <c:pt idx="25">
                  <c:v>32.948316632839301</c:v>
                </c:pt>
                <c:pt idx="26">
                  <c:v>140.11534300854501</c:v>
                </c:pt>
                <c:pt idx="27">
                  <c:v>109.51012879824</c:v>
                </c:pt>
                <c:pt idx="28">
                  <c:v>119.581910065061</c:v>
                </c:pt>
                <c:pt idx="29">
                  <c:v>78.730319622479499</c:v>
                </c:pt>
                <c:pt idx="30">
                  <c:v>113.09651808644399</c:v>
                </c:pt>
                <c:pt idx="31">
                  <c:v>112.294932367233</c:v>
                </c:pt>
                <c:pt idx="32">
                  <c:v>128.11897534071599</c:v>
                </c:pt>
                <c:pt idx="33">
                  <c:v>120.60148905109099</c:v>
                </c:pt>
                <c:pt idx="34">
                  <c:v>118.067159160816</c:v>
                </c:pt>
                <c:pt idx="35">
                  <c:v>99.329915231981104</c:v>
                </c:pt>
                <c:pt idx="36">
                  <c:v>136.52182219150399</c:v>
                </c:pt>
                <c:pt idx="37">
                  <c:v>119.704168761316</c:v>
                </c:pt>
                <c:pt idx="38">
                  <c:v>96.288308342810296</c:v>
                </c:pt>
                <c:pt idx="39">
                  <c:v>122.81406861041501</c:v>
                </c:pt>
                <c:pt idx="40">
                  <c:v>148.62206203085199</c:v>
                </c:pt>
                <c:pt idx="41">
                  <c:v>118.55714636135799</c:v>
                </c:pt>
                <c:pt idx="42">
                  <c:v>105.638847715401</c:v>
                </c:pt>
                <c:pt idx="43">
                  <c:v>65.537569721641404</c:v>
                </c:pt>
                <c:pt idx="44">
                  <c:v>129.94131956285301</c:v>
                </c:pt>
                <c:pt idx="45">
                  <c:v>80.535007449957106</c:v>
                </c:pt>
                <c:pt idx="46">
                  <c:v>45.095793577456703</c:v>
                </c:pt>
                <c:pt idx="47">
                  <c:v>132.95976702724101</c:v>
                </c:pt>
                <c:pt idx="48">
                  <c:v>143.43418423211901</c:v>
                </c:pt>
                <c:pt idx="49">
                  <c:v>105.886007688625</c:v>
                </c:pt>
                <c:pt idx="50">
                  <c:v>122.823346038089</c:v>
                </c:pt>
                <c:pt idx="51">
                  <c:v>85.801083097921307</c:v>
                </c:pt>
                <c:pt idx="52">
                  <c:v>149.090340777942</c:v>
                </c:pt>
                <c:pt idx="53">
                  <c:v>163.187956828712</c:v>
                </c:pt>
                <c:pt idx="54">
                  <c:v>134.002704717417</c:v>
                </c:pt>
                <c:pt idx="55">
                  <c:v>125.311517220433</c:v>
                </c:pt>
                <c:pt idx="56">
                  <c:v>130.418653321524</c:v>
                </c:pt>
                <c:pt idx="57">
                  <c:v>102.95961537906901</c:v>
                </c:pt>
                <c:pt idx="58">
                  <c:v>120.991314565678</c:v>
                </c:pt>
                <c:pt idx="59">
                  <c:v>63.755258828906697</c:v>
                </c:pt>
                <c:pt idx="60">
                  <c:v>127.500822837371</c:v>
                </c:pt>
                <c:pt idx="61">
                  <c:v>126.012021697297</c:v>
                </c:pt>
                <c:pt idx="62">
                  <c:v>112.55075539712399</c:v>
                </c:pt>
                <c:pt idx="63">
                  <c:v>84.1274423760415</c:v>
                </c:pt>
                <c:pt idx="64">
                  <c:v>152.54141568848701</c:v>
                </c:pt>
                <c:pt idx="65">
                  <c:v>121.871348210294</c:v>
                </c:pt>
                <c:pt idx="66">
                  <c:v>113.114155300523</c:v>
                </c:pt>
                <c:pt idx="67">
                  <c:v>128.50070678514899</c:v>
                </c:pt>
                <c:pt idx="68">
                  <c:v>108.822576740481</c:v>
                </c:pt>
                <c:pt idx="69">
                  <c:v>101.650434333457</c:v>
                </c:pt>
                <c:pt idx="70">
                  <c:v>45.054871647832002</c:v>
                </c:pt>
                <c:pt idx="71">
                  <c:v>54.928993028135899</c:v>
                </c:pt>
                <c:pt idx="72">
                  <c:v>124.41324144943199</c:v>
                </c:pt>
                <c:pt idx="73">
                  <c:v>108.685803555989</c:v>
                </c:pt>
                <c:pt idx="74">
                  <c:v>122.281184206815</c:v>
                </c:pt>
                <c:pt idx="75">
                  <c:v>111.775907409233</c:v>
                </c:pt>
                <c:pt idx="76">
                  <c:v>157.21931382664999</c:v>
                </c:pt>
                <c:pt idx="77">
                  <c:v>119.43939146100701</c:v>
                </c:pt>
                <c:pt idx="78">
                  <c:v>126.115234772275</c:v>
                </c:pt>
                <c:pt idx="79">
                  <c:v>81.3796179891348</c:v>
                </c:pt>
                <c:pt idx="80">
                  <c:v>89.486660035565805</c:v>
                </c:pt>
                <c:pt idx="81">
                  <c:v>138.03269342895999</c:v>
                </c:pt>
                <c:pt idx="82">
                  <c:v>91.810733150597898</c:v>
                </c:pt>
                <c:pt idx="83">
                  <c:v>162.241052879194</c:v>
                </c:pt>
                <c:pt idx="84">
                  <c:v>108.95635214463699</c:v>
                </c:pt>
                <c:pt idx="85">
                  <c:v>92.101810297006807</c:v>
                </c:pt>
                <c:pt idx="86">
                  <c:v>95.057664681402798</c:v>
                </c:pt>
                <c:pt idx="87">
                  <c:v>103.998161497647</c:v>
                </c:pt>
                <c:pt idx="88">
                  <c:v>53.075262221338399</c:v>
                </c:pt>
                <c:pt idx="89">
                  <c:v>84.490820268607294</c:v>
                </c:pt>
                <c:pt idx="90">
                  <c:v>137.007164822742</c:v>
                </c:pt>
                <c:pt idx="91">
                  <c:v>106.250332381384</c:v>
                </c:pt>
                <c:pt idx="92">
                  <c:v>131.03142671157801</c:v>
                </c:pt>
                <c:pt idx="93">
                  <c:v>109.970930365817</c:v>
                </c:pt>
                <c:pt idx="94">
                  <c:v>121.90899312637301</c:v>
                </c:pt>
                <c:pt idx="95">
                  <c:v>89.654735678693896</c:v>
                </c:pt>
                <c:pt idx="96">
                  <c:v>96.008786814322093</c:v>
                </c:pt>
                <c:pt idx="97">
                  <c:v>132.96125756952901</c:v>
                </c:pt>
                <c:pt idx="98">
                  <c:v>121.11205094822699</c:v>
                </c:pt>
                <c:pt idx="99">
                  <c:v>99.922831941251303</c:v>
                </c:pt>
                <c:pt idx="100">
                  <c:v>130.95417774317801</c:v>
                </c:pt>
                <c:pt idx="101">
                  <c:v>119.564588400837</c:v>
                </c:pt>
                <c:pt idx="102">
                  <c:v>119.158664559306</c:v>
                </c:pt>
                <c:pt idx="103">
                  <c:v>113.20476601901601</c:v>
                </c:pt>
                <c:pt idx="104">
                  <c:v>116.37617521892901</c:v>
                </c:pt>
                <c:pt idx="105">
                  <c:v>97.009287147204304</c:v>
                </c:pt>
                <c:pt idx="106">
                  <c:v>135.11077895542201</c:v>
                </c:pt>
                <c:pt idx="107">
                  <c:v>126.328765458194</c:v>
                </c:pt>
                <c:pt idx="108">
                  <c:v>136.85856267855399</c:v>
                </c:pt>
                <c:pt idx="109">
                  <c:v>185.61173097224901</c:v>
                </c:pt>
                <c:pt idx="110">
                  <c:v>141.27029631472999</c:v>
                </c:pt>
                <c:pt idx="111">
                  <c:v>107.728000814872</c:v>
                </c:pt>
                <c:pt idx="112">
                  <c:v>118.64112718757301</c:v>
                </c:pt>
                <c:pt idx="113">
                  <c:v>118.463728661799</c:v>
                </c:pt>
                <c:pt idx="114">
                  <c:v>102.78569480071</c:v>
                </c:pt>
                <c:pt idx="115">
                  <c:v>118.94791889360501</c:v>
                </c:pt>
                <c:pt idx="116">
                  <c:v>113.455289008096</c:v>
                </c:pt>
                <c:pt idx="117">
                  <c:v>81.339751753765995</c:v>
                </c:pt>
                <c:pt idx="118">
                  <c:v>131.35479676492301</c:v>
                </c:pt>
                <c:pt idx="119">
                  <c:v>95.1106250102616</c:v>
                </c:pt>
                <c:pt idx="120">
                  <c:v>132.33870569847301</c:v>
                </c:pt>
                <c:pt idx="121">
                  <c:v>91.739974329479494</c:v>
                </c:pt>
                <c:pt idx="122">
                  <c:v>106.92160753296901</c:v>
                </c:pt>
                <c:pt idx="123">
                  <c:v>105.369653156551</c:v>
                </c:pt>
                <c:pt idx="124">
                  <c:v>153.12596359662899</c:v>
                </c:pt>
                <c:pt idx="125">
                  <c:v>105.09358819105501</c:v>
                </c:pt>
                <c:pt idx="126">
                  <c:v>147.33557087531199</c:v>
                </c:pt>
                <c:pt idx="127">
                  <c:v>155.05131620376801</c:v>
                </c:pt>
                <c:pt idx="128">
                  <c:v>122.35567417432</c:v>
                </c:pt>
                <c:pt idx="129">
                  <c:v>104.584138521962</c:v>
                </c:pt>
                <c:pt idx="130">
                  <c:v>110.521058723888</c:v>
                </c:pt>
                <c:pt idx="131">
                  <c:v>128.562974226271</c:v>
                </c:pt>
                <c:pt idx="132">
                  <c:v>115.353580920257</c:v>
                </c:pt>
                <c:pt idx="133">
                  <c:v>120.874522475681</c:v>
                </c:pt>
                <c:pt idx="134">
                  <c:v>133.553285029698</c:v>
                </c:pt>
                <c:pt idx="135">
                  <c:v>114.886467931846</c:v>
                </c:pt>
                <c:pt idx="136">
                  <c:v>155.59550404719801</c:v>
                </c:pt>
                <c:pt idx="137">
                  <c:v>157.39591754844699</c:v>
                </c:pt>
                <c:pt idx="138">
                  <c:v>102.263202690529</c:v>
                </c:pt>
                <c:pt idx="139">
                  <c:v>154.17178575886101</c:v>
                </c:pt>
                <c:pt idx="140">
                  <c:v>119.431760866301</c:v>
                </c:pt>
                <c:pt idx="141">
                  <c:v>111.951865365465</c:v>
                </c:pt>
                <c:pt idx="142">
                  <c:v>101.308264760284</c:v>
                </c:pt>
                <c:pt idx="143">
                  <c:v>132.45875648807299</c:v>
                </c:pt>
                <c:pt idx="144">
                  <c:v>128.90948618834901</c:v>
                </c:pt>
                <c:pt idx="145">
                  <c:v>134.456533652004</c:v>
                </c:pt>
                <c:pt idx="146">
                  <c:v>101.47020495368599</c:v>
                </c:pt>
                <c:pt idx="147">
                  <c:v>113.984474077996</c:v>
                </c:pt>
                <c:pt idx="148">
                  <c:v>133.99269431380199</c:v>
                </c:pt>
                <c:pt idx="149">
                  <c:v>107.99676879068301</c:v>
                </c:pt>
                <c:pt idx="150">
                  <c:v>140.16404514043401</c:v>
                </c:pt>
                <c:pt idx="151">
                  <c:v>119.546626866514</c:v>
                </c:pt>
                <c:pt idx="152">
                  <c:v>165.96463644626999</c:v>
                </c:pt>
                <c:pt idx="153">
                  <c:v>118.044459963337</c:v>
                </c:pt>
                <c:pt idx="154">
                  <c:v>93.257516695760899</c:v>
                </c:pt>
                <c:pt idx="155">
                  <c:v>102.79997032257</c:v>
                </c:pt>
                <c:pt idx="156">
                  <c:v>97.518701876860405</c:v>
                </c:pt>
                <c:pt idx="157">
                  <c:v>113.004166244652</c:v>
                </c:pt>
                <c:pt idx="158">
                  <c:v>125.806262440582</c:v>
                </c:pt>
                <c:pt idx="159">
                  <c:v>111.804394744547</c:v>
                </c:pt>
                <c:pt idx="160">
                  <c:v>139.01738768700301</c:v>
                </c:pt>
                <c:pt idx="161">
                  <c:v>114.851637674778</c:v>
                </c:pt>
                <c:pt idx="162">
                  <c:v>116.174771853368</c:v>
                </c:pt>
                <c:pt idx="163">
                  <c:v>163.09692490586599</c:v>
                </c:pt>
                <c:pt idx="164">
                  <c:v>115.266951971525</c:v>
                </c:pt>
                <c:pt idx="165">
                  <c:v>125.81913063483999</c:v>
                </c:pt>
                <c:pt idx="166">
                  <c:v>109.13607932111999</c:v>
                </c:pt>
                <c:pt idx="167">
                  <c:v>68.9350168278621</c:v>
                </c:pt>
                <c:pt idx="168">
                  <c:v>139.63790661855799</c:v>
                </c:pt>
                <c:pt idx="169">
                  <c:v>139.577340909035</c:v>
                </c:pt>
                <c:pt idx="170">
                  <c:v>129.26753859640101</c:v>
                </c:pt>
                <c:pt idx="171">
                  <c:v>120.863253903085</c:v>
                </c:pt>
                <c:pt idx="172">
                  <c:v>131.888990110945</c:v>
                </c:pt>
                <c:pt idx="173">
                  <c:v>100.093913601713</c:v>
                </c:pt>
                <c:pt idx="174">
                  <c:v>163.14404890657599</c:v>
                </c:pt>
                <c:pt idx="175">
                  <c:v>114.001409284277</c:v>
                </c:pt>
                <c:pt idx="176">
                  <c:v>123.376115851964</c:v>
                </c:pt>
                <c:pt idx="177">
                  <c:v>139.260823055256</c:v>
                </c:pt>
                <c:pt idx="178">
                  <c:v>103.766073498948</c:v>
                </c:pt>
                <c:pt idx="179">
                  <c:v>129.87101589131399</c:v>
                </c:pt>
                <c:pt idx="180">
                  <c:v>126.178561529044</c:v>
                </c:pt>
                <c:pt idx="181">
                  <c:v>98.687944616223604</c:v>
                </c:pt>
                <c:pt idx="182">
                  <c:v>116.852987027099</c:v>
                </c:pt>
                <c:pt idx="183">
                  <c:v>56.600239096906797</c:v>
                </c:pt>
                <c:pt idx="184">
                  <c:v>126.105416464733</c:v>
                </c:pt>
                <c:pt idx="185">
                  <c:v>109.54172066351499</c:v>
                </c:pt>
                <c:pt idx="186">
                  <c:v>88.393986177251307</c:v>
                </c:pt>
                <c:pt idx="187">
                  <c:v>141.999578618334</c:v>
                </c:pt>
                <c:pt idx="188">
                  <c:v>102.582495883994</c:v>
                </c:pt>
                <c:pt idx="189">
                  <c:v>106.797562294294</c:v>
                </c:pt>
                <c:pt idx="190">
                  <c:v>113.491207469309</c:v>
                </c:pt>
                <c:pt idx="191">
                  <c:v>107.09805309966001</c:v>
                </c:pt>
                <c:pt idx="192">
                  <c:v>114.04769870167701</c:v>
                </c:pt>
                <c:pt idx="193">
                  <c:v>108.71731863350701</c:v>
                </c:pt>
                <c:pt idx="194">
                  <c:v>97.907548149251994</c:v>
                </c:pt>
                <c:pt idx="195">
                  <c:v>108.871024743967</c:v>
                </c:pt>
                <c:pt idx="196">
                  <c:v>115.150521348163</c:v>
                </c:pt>
                <c:pt idx="197">
                  <c:v>101.785241080378</c:v>
                </c:pt>
                <c:pt idx="198">
                  <c:v>163.00869519029101</c:v>
                </c:pt>
                <c:pt idx="199">
                  <c:v>144.15006676192201</c:v>
                </c:pt>
                <c:pt idx="200">
                  <c:v>119.376123976778</c:v>
                </c:pt>
                <c:pt idx="201">
                  <c:v>143.58977955089699</c:v>
                </c:pt>
                <c:pt idx="202">
                  <c:v>125.462693242683</c:v>
                </c:pt>
                <c:pt idx="203">
                  <c:v>89.162486175998396</c:v>
                </c:pt>
                <c:pt idx="204">
                  <c:v>124.849428747373</c:v>
                </c:pt>
                <c:pt idx="205">
                  <c:v>80.659822414689501</c:v>
                </c:pt>
                <c:pt idx="206">
                  <c:v>119.52080555579199</c:v>
                </c:pt>
                <c:pt idx="207">
                  <c:v>77.8417027558678</c:v>
                </c:pt>
                <c:pt idx="208">
                  <c:v>127.354603172916</c:v>
                </c:pt>
                <c:pt idx="209">
                  <c:v>100.476111720753</c:v>
                </c:pt>
                <c:pt idx="210">
                  <c:v>117.098618607796</c:v>
                </c:pt>
                <c:pt idx="211">
                  <c:v>109.119102088562</c:v>
                </c:pt>
                <c:pt idx="212">
                  <c:v>153.584520968097</c:v>
                </c:pt>
                <c:pt idx="213">
                  <c:v>78.733630608802102</c:v>
                </c:pt>
                <c:pt idx="214">
                  <c:v>118.50383231009801</c:v>
                </c:pt>
                <c:pt idx="215">
                  <c:v>140.66376313144301</c:v>
                </c:pt>
                <c:pt idx="216">
                  <c:v>62.135190820063002</c:v>
                </c:pt>
                <c:pt idx="217">
                  <c:v>85.506540500804604</c:v>
                </c:pt>
                <c:pt idx="218">
                  <c:v>104.367288385758</c:v>
                </c:pt>
                <c:pt idx="219">
                  <c:v>141.359663310548</c:v>
                </c:pt>
                <c:pt idx="220">
                  <c:v>79.432214742335404</c:v>
                </c:pt>
                <c:pt idx="221">
                  <c:v>106.952983378433</c:v>
                </c:pt>
                <c:pt idx="222">
                  <c:v>107.537483592784</c:v>
                </c:pt>
                <c:pt idx="223">
                  <c:v>78.930612362358502</c:v>
                </c:pt>
                <c:pt idx="224">
                  <c:v>105.019047822904</c:v>
                </c:pt>
                <c:pt idx="225">
                  <c:v>162.80149271726901</c:v>
                </c:pt>
                <c:pt idx="226">
                  <c:v>86.037446296103298</c:v>
                </c:pt>
                <c:pt idx="227">
                  <c:v>55.280593073672797</c:v>
                </c:pt>
                <c:pt idx="228">
                  <c:v>156.27227287287499</c:v>
                </c:pt>
                <c:pt idx="229">
                  <c:v>120.399433488886</c:v>
                </c:pt>
                <c:pt idx="230">
                  <c:v>165.431411735826</c:v>
                </c:pt>
                <c:pt idx="231">
                  <c:v>92.008705698510795</c:v>
                </c:pt>
                <c:pt idx="232">
                  <c:v>131.65209134208399</c:v>
                </c:pt>
                <c:pt idx="233">
                  <c:v>143.89421260122199</c:v>
                </c:pt>
                <c:pt idx="234">
                  <c:v>98.171216894711193</c:v>
                </c:pt>
                <c:pt idx="235">
                  <c:v>105.11316355508001</c:v>
                </c:pt>
                <c:pt idx="236">
                  <c:v>134.26481121434699</c:v>
                </c:pt>
                <c:pt idx="237">
                  <c:v>72.520977097199605</c:v>
                </c:pt>
                <c:pt idx="238">
                  <c:v>131.422674825835</c:v>
                </c:pt>
                <c:pt idx="239">
                  <c:v>89.159310043139797</c:v>
                </c:pt>
                <c:pt idx="240">
                  <c:v>94.869253122598394</c:v>
                </c:pt>
                <c:pt idx="241">
                  <c:v>127.505283082595</c:v>
                </c:pt>
                <c:pt idx="242">
                  <c:v>121.43655016022601</c:v>
                </c:pt>
                <c:pt idx="243">
                  <c:v>135.61695008517501</c:v>
                </c:pt>
                <c:pt idx="244">
                  <c:v>99.907908974567107</c:v>
                </c:pt>
                <c:pt idx="245">
                  <c:v>103.21395100510701</c:v>
                </c:pt>
                <c:pt idx="246">
                  <c:v>161.71604016732499</c:v>
                </c:pt>
                <c:pt idx="247">
                  <c:v>59.907898950573603</c:v>
                </c:pt>
                <c:pt idx="248">
                  <c:v>134.06733663140901</c:v>
                </c:pt>
                <c:pt idx="249">
                  <c:v>146.553380584716</c:v>
                </c:pt>
                <c:pt idx="250">
                  <c:v>114.73082471353599</c:v>
                </c:pt>
                <c:pt idx="251">
                  <c:v>113.08574146708</c:v>
                </c:pt>
                <c:pt idx="252">
                  <c:v>117.49632222727099</c:v>
                </c:pt>
                <c:pt idx="253">
                  <c:v>93.757376883671498</c:v>
                </c:pt>
                <c:pt idx="254">
                  <c:v>133.186524890502</c:v>
                </c:pt>
                <c:pt idx="255">
                  <c:v>66.578775945939199</c:v>
                </c:pt>
                <c:pt idx="256">
                  <c:v>97.057594649796599</c:v>
                </c:pt>
                <c:pt idx="257">
                  <c:v>140.95340030118101</c:v>
                </c:pt>
                <c:pt idx="258">
                  <c:v>121.34432431912801</c:v>
                </c:pt>
                <c:pt idx="259">
                  <c:v>93.897488730439804</c:v>
                </c:pt>
                <c:pt idx="260">
                  <c:v>88.644578695606398</c:v>
                </c:pt>
                <c:pt idx="261">
                  <c:v>106.792823092169</c:v>
                </c:pt>
                <c:pt idx="262">
                  <c:v>125.45771955166801</c:v>
                </c:pt>
                <c:pt idx="263">
                  <c:v>90.258111214593299</c:v>
                </c:pt>
                <c:pt idx="264">
                  <c:v>67.2752364723939</c:v>
                </c:pt>
                <c:pt idx="265">
                  <c:v>150.144729459481</c:v>
                </c:pt>
                <c:pt idx="266">
                  <c:v>113.558543826429</c:v>
                </c:pt>
                <c:pt idx="267">
                  <c:v>97.229245454987094</c:v>
                </c:pt>
                <c:pt idx="268">
                  <c:v>79.801236866911694</c:v>
                </c:pt>
                <c:pt idx="269">
                  <c:v>107.74539932553201</c:v>
                </c:pt>
                <c:pt idx="270">
                  <c:v>113.933450687635</c:v>
                </c:pt>
                <c:pt idx="271">
                  <c:v>109.701679830564</c:v>
                </c:pt>
                <c:pt idx="272">
                  <c:v>78.726313016635103</c:v>
                </c:pt>
                <c:pt idx="273">
                  <c:v>94.097202227451305</c:v>
                </c:pt>
                <c:pt idx="274">
                  <c:v>102.672422598799</c:v>
                </c:pt>
                <c:pt idx="275">
                  <c:v>114.652739732078</c:v>
                </c:pt>
                <c:pt idx="276">
                  <c:v>80.668269229087898</c:v>
                </c:pt>
                <c:pt idx="277">
                  <c:v>136.03372316401101</c:v>
                </c:pt>
                <c:pt idx="278">
                  <c:v>73.183105063024897</c:v>
                </c:pt>
                <c:pt idx="279">
                  <c:v>99.791519897299807</c:v>
                </c:pt>
                <c:pt idx="280">
                  <c:v>117.676206920966</c:v>
                </c:pt>
                <c:pt idx="281">
                  <c:v>125.126002734617</c:v>
                </c:pt>
                <c:pt idx="282">
                  <c:v>125.228993142186</c:v>
                </c:pt>
                <c:pt idx="283">
                  <c:v>134.46126857679201</c:v>
                </c:pt>
                <c:pt idx="284">
                  <c:v>144.047575014046</c:v>
                </c:pt>
                <c:pt idx="285">
                  <c:v>108.72892757359701</c:v>
                </c:pt>
                <c:pt idx="286">
                  <c:v>111.114278425527</c:v>
                </c:pt>
                <c:pt idx="287">
                  <c:v>154.69419013551399</c:v>
                </c:pt>
                <c:pt idx="288">
                  <c:v>129.97253425520699</c:v>
                </c:pt>
                <c:pt idx="289">
                  <c:v>128.09963195456999</c:v>
                </c:pt>
                <c:pt idx="290">
                  <c:v>136.56469625932601</c:v>
                </c:pt>
                <c:pt idx="291">
                  <c:v>92.245499587904106</c:v>
                </c:pt>
              </c:numCache>
            </c:numRef>
          </c:xVal>
          <c:yVal>
            <c:numRef>
              <c:f>'292RIL'!$K$2:$K$295</c:f>
              <c:numCache>
                <c:formatCode>0.00</c:formatCode>
                <c:ptCount val="294"/>
                <c:pt idx="0">
                  <c:v>62.228763290178101</c:v>
                </c:pt>
                <c:pt idx="1">
                  <c:v>58.398647092707797</c:v>
                </c:pt>
                <c:pt idx="2">
                  <c:v>67.938251841318902</c:v>
                </c:pt>
                <c:pt idx="3">
                  <c:v>77.704187246374104</c:v>
                </c:pt>
                <c:pt idx="4">
                  <c:v>56.936607797670803</c:v>
                </c:pt>
                <c:pt idx="5">
                  <c:v>58.6647073822975</c:v>
                </c:pt>
                <c:pt idx="6">
                  <c:v>72.223810597963293</c:v>
                </c:pt>
                <c:pt idx="7">
                  <c:v>67.243567647199598</c:v>
                </c:pt>
                <c:pt idx="8">
                  <c:v>47.9022004663384</c:v>
                </c:pt>
                <c:pt idx="9">
                  <c:v>62.425342227148498</c:v>
                </c:pt>
                <c:pt idx="10">
                  <c:v>58.003269178974499</c:v>
                </c:pt>
                <c:pt idx="11">
                  <c:v>55.729957707818201</c:v>
                </c:pt>
                <c:pt idx="12">
                  <c:v>68.929132899682799</c:v>
                </c:pt>
                <c:pt idx="13">
                  <c:v>69.467349869445997</c:v>
                </c:pt>
                <c:pt idx="14">
                  <c:v>43.955886393952802</c:v>
                </c:pt>
                <c:pt idx="15">
                  <c:v>48.3969850559291</c:v>
                </c:pt>
                <c:pt idx="16">
                  <c:v>47.734581566811499</c:v>
                </c:pt>
                <c:pt idx="17">
                  <c:v>53.963149336327</c:v>
                </c:pt>
                <c:pt idx="18">
                  <c:v>60.474570657113397</c:v>
                </c:pt>
                <c:pt idx="19">
                  <c:v>52.714785172957697</c:v>
                </c:pt>
                <c:pt idx="20">
                  <c:v>50.551641525222799</c:v>
                </c:pt>
                <c:pt idx="21">
                  <c:v>44.936317781137397</c:v>
                </c:pt>
                <c:pt idx="22">
                  <c:v>67.180766436604998</c:v>
                </c:pt>
                <c:pt idx="23">
                  <c:v>43.189913444553198</c:v>
                </c:pt>
                <c:pt idx="24">
                  <c:v>60.411170331965799</c:v>
                </c:pt>
                <c:pt idx="25">
                  <c:v>14.947028411218801</c:v>
                </c:pt>
                <c:pt idx="26">
                  <c:v>61.254846791595099</c:v>
                </c:pt>
                <c:pt idx="27">
                  <c:v>60.001715008676399</c:v>
                </c:pt>
                <c:pt idx="28">
                  <c:v>55.673661293305898</c:v>
                </c:pt>
                <c:pt idx="29">
                  <c:v>42.747807207142202</c:v>
                </c:pt>
                <c:pt idx="30">
                  <c:v>59.312503195903602</c:v>
                </c:pt>
                <c:pt idx="31">
                  <c:v>47.9983750350425</c:v>
                </c:pt>
                <c:pt idx="32">
                  <c:v>77.322276540066696</c:v>
                </c:pt>
                <c:pt idx="33">
                  <c:v>62.775785928698298</c:v>
                </c:pt>
                <c:pt idx="34">
                  <c:v>50.822938767402597</c:v>
                </c:pt>
                <c:pt idx="35">
                  <c:v>42.887768697559103</c:v>
                </c:pt>
                <c:pt idx="36">
                  <c:v>69.030662323876797</c:v>
                </c:pt>
                <c:pt idx="37">
                  <c:v>55.334032984598799</c:v>
                </c:pt>
                <c:pt idx="38">
                  <c:v>49.673041508934098</c:v>
                </c:pt>
                <c:pt idx="39">
                  <c:v>65.713870125904194</c:v>
                </c:pt>
                <c:pt idx="40">
                  <c:v>67.514002975373003</c:v>
                </c:pt>
                <c:pt idx="41">
                  <c:v>63.167526608214402</c:v>
                </c:pt>
                <c:pt idx="42">
                  <c:v>50.186291154217301</c:v>
                </c:pt>
                <c:pt idx="43">
                  <c:v>34.023256329648902</c:v>
                </c:pt>
                <c:pt idx="44">
                  <c:v>66.426277180282995</c:v>
                </c:pt>
                <c:pt idx="45">
                  <c:v>37.049953932151901</c:v>
                </c:pt>
                <c:pt idx="46">
                  <c:v>23.130219489150502</c:v>
                </c:pt>
                <c:pt idx="47">
                  <c:v>62.599536814255003</c:v>
                </c:pt>
                <c:pt idx="48">
                  <c:v>63.951103420073203</c:v>
                </c:pt>
                <c:pt idx="49">
                  <c:v>45.035331177826997</c:v>
                </c:pt>
                <c:pt idx="50">
                  <c:v>59.989490169730601</c:v>
                </c:pt>
                <c:pt idx="51">
                  <c:v>44.920242687760599</c:v>
                </c:pt>
                <c:pt idx="52">
                  <c:v>73.190256658584403</c:v>
                </c:pt>
                <c:pt idx="53">
                  <c:v>69.259823719268496</c:v>
                </c:pt>
                <c:pt idx="54">
                  <c:v>70.106101221638397</c:v>
                </c:pt>
                <c:pt idx="55">
                  <c:v>53.128841810669499</c:v>
                </c:pt>
                <c:pt idx="56">
                  <c:v>57.182594448297699</c:v>
                </c:pt>
                <c:pt idx="57">
                  <c:v>45.185689781243902</c:v>
                </c:pt>
                <c:pt idx="58">
                  <c:v>48.567972620586097</c:v>
                </c:pt>
                <c:pt idx="59">
                  <c:v>33.939468697867902</c:v>
                </c:pt>
                <c:pt idx="60">
                  <c:v>72.375143850000796</c:v>
                </c:pt>
                <c:pt idx="61">
                  <c:v>65.615017756812307</c:v>
                </c:pt>
                <c:pt idx="62">
                  <c:v>67.267258905588804</c:v>
                </c:pt>
                <c:pt idx="63">
                  <c:v>33.415359570950301</c:v>
                </c:pt>
                <c:pt idx="64">
                  <c:v>54.817736838917902</c:v>
                </c:pt>
                <c:pt idx="65">
                  <c:v>54.9046756138464</c:v>
                </c:pt>
                <c:pt idx="66">
                  <c:v>63.3775490974256</c:v>
                </c:pt>
                <c:pt idx="67">
                  <c:v>57.305730991656603</c:v>
                </c:pt>
                <c:pt idx="68">
                  <c:v>43.762730952829003</c:v>
                </c:pt>
                <c:pt idx="69">
                  <c:v>47.346116856653602</c:v>
                </c:pt>
                <c:pt idx="70">
                  <c:v>26.117868609791302</c:v>
                </c:pt>
                <c:pt idx="71">
                  <c:v>31.070496911565801</c:v>
                </c:pt>
                <c:pt idx="72">
                  <c:v>55.4780246612479</c:v>
                </c:pt>
                <c:pt idx="73">
                  <c:v>43.838755589278101</c:v>
                </c:pt>
                <c:pt idx="74">
                  <c:v>68.231644802832903</c:v>
                </c:pt>
                <c:pt idx="75">
                  <c:v>69.388084225036195</c:v>
                </c:pt>
                <c:pt idx="76">
                  <c:v>68.083686893998504</c:v>
                </c:pt>
                <c:pt idx="77">
                  <c:v>57.362631083849102</c:v>
                </c:pt>
                <c:pt idx="78">
                  <c:v>69.581218258306194</c:v>
                </c:pt>
                <c:pt idx="79">
                  <c:v>38.525775575964502</c:v>
                </c:pt>
                <c:pt idx="80">
                  <c:v>49.919442690220897</c:v>
                </c:pt>
                <c:pt idx="81">
                  <c:v>89.761608279646296</c:v>
                </c:pt>
                <c:pt idx="82">
                  <c:v>51.340608176601698</c:v>
                </c:pt>
                <c:pt idx="83">
                  <c:v>62.142554170048399</c:v>
                </c:pt>
                <c:pt idx="84">
                  <c:v>49.124964017840199</c:v>
                </c:pt>
                <c:pt idx="85">
                  <c:v>45.430878908599098</c:v>
                </c:pt>
                <c:pt idx="86">
                  <c:v>47.049721019486</c:v>
                </c:pt>
                <c:pt idx="87">
                  <c:v>40.076064527809898</c:v>
                </c:pt>
                <c:pt idx="88">
                  <c:v>30.7061183580327</c:v>
                </c:pt>
                <c:pt idx="89">
                  <c:v>53.6896236086492</c:v>
                </c:pt>
                <c:pt idx="90">
                  <c:v>45.262596811130699</c:v>
                </c:pt>
                <c:pt idx="91">
                  <c:v>49.722699699847801</c:v>
                </c:pt>
                <c:pt idx="92">
                  <c:v>68.268541944572405</c:v>
                </c:pt>
                <c:pt idx="93">
                  <c:v>56.943895381656198</c:v>
                </c:pt>
                <c:pt idx="94">
                  <c:v>64.804536499389002</c:v>
                </c:pt>
                <c:pt idx="95">
                  <c:v>49.906490528587199</c:v>
                </c:pt>
                <c:pt idx="96">
                  <c:v>41.599505592842704</c:v>
                </c:pt>
                <c:pt idx="97">
                  <c:v>55.2793148864179</c:v>
                </c:pt>
                <c:pt idx="98">
                  <c:v>67.831219248816097</c:v>
                </c:pt>
                <c:pt idx="99">
                  <c:v>71.852658229553597</c:v>
                </c:pt>
                <c:pt idx="100">
                  <c:v>62.1780589325164</c:v>
                </c:pt>
                <c:pt idx="101">
                  <c:v>44.665967511131598</c:v>
                </c:pt>
                <c:pt idx="102">
                  <c:v>73.896059301193006</c:v>
                </c:pt>
                <c:pt idx="103">
                  <c:v>51.969808160613098</c:v>
                </c:pt>
                <c:pt idx="104">
                  <c:v>59.393827564406998</c:v>
                </c:pt>
                <c:pt idx="105">
                  <c:v>46.437239872607002</c:v>
                </c:pt>
                <c:pt idx="106">
                  <c:v>59.838093580451797</c:v>
                </c:pt>
                <c:pt idx="107">
                  <c:v>61.675437469304299</c:v>
                </c:pt>
                <c:pt idx="108">
                  <c:v>64.873179933953097</c:v>
                </c:pt>
                <c:pt idx="109">
                  <c:v>60.998117668349103</c:v>
                </c:pt>
                <c:pt idx="110">
                  <c:v>57.776651778437802</c:v>
                </c:pt>
                <c:pt idx="111">
                  <c:v>53.749096416363997</c:v>
                </c:pt>
                <c:pt idx="112">
                  <c:v>40.455178520760398</c:v>
                </c:pt>
                <c:pt idx="113">
                  <c:v>64.979086326752693</c:v>
                </c:pt>
                <c:pt idx="114">
                  <c:v>54.117925526048801</c:v>
                </c:pt>
                <c:pt idx="115">
                  <c:v>69.756545713984494</c:v>
                </c:pt>
                <c:pt idx="116">
                  <c:v>68.937362637230194</c:v>
                </c:pt>
                <c:pt idx="117">
                  <c:v>53.086813767324202</c:v>
                </c:pt>
                <c:pt idx="118">
                  <c:v>68.747217221871495</c:v>
                </c:pt>
                <c:pt idx="119">
                  <c:v>53.652322233267</c:v>
                </c:pt>
                <c:pt idx="120">
                  <c:v>65.406771279427005</c:v>
                </c:pt>
                <c:pt idx="121">
                  <c:v>45.3188378110587</c:v>
                </c:pt>
                <c:pt idx="122">
                  <c:v>51.962019015966298</c:v>
                </c:pt>
                <c:pt idx="123">
                  <c:v>70.548300095799306</c:v>
                </c:pt>
                <c:pt idx="124">
                  <c:v>66.433985291178004</c:v>
                </c:pt>
                <c:pt idx="125">
                  <c:v>52.698567142806802</c:v>
                </c:pt>
                <c:pt idx="126">
                  <c:v>74.992422026640895</c:v>
                </c:pt>
                <c:pt idx="127">
                  <c:v>74.9687675728199</c:v>
                </c:pt>
                <c:pt idx="128">
                  <c:v>71.390415778272697</c:v>
                </c:pt>
                <c:pt idx="129">
                  <c:v>57.8144598550194</c:v>
                </c:pt>
                <c:pt idx="130">
                  <c:v>60.8634070558237</c:v>
                </c:pt>
                <c:pt idx="131">
                  <c:v>67.151010397833105</c:v>
                </c:pt>
                <c:pt idx="132">
                  <c:v>47.760218798772101</c:v>
                </c:pt>
                <c:pt idx="133">
                  <c:v>54.723426478951602</c:v>
                </c:pt>
                <c:pt idx="134">
                  <c:v>53.324767312468303</c:v>
                </c:pt>
                <c:pt idx="135">
                  <c:v>68.716062737809693</c:v>
                </c:pt>
                <c:pt idx="136">
                  <c:v>60.690622176783499</c:v>
                </c:pt>
                <c:pt idx="137">
                  <c:v>73.2726824605584</c:v>
                </c:pt>
                <c:pt idx="138">
                  <c:v>48.907363720225497</c:v>
                </c:pt>
                <c:pt idx="139">
                  <c:v>56.5282803310741</c:v>
                </c:pt>
                <c:pt idx="140">
                  <c:v>60.494691742409699</c:v>
                </c:pt>
                <c:pt idx="141">
                  <c:v>52.182556029250598</c:v>
                </c:pt>
                <c:pt idx="142">
                  <c:v>54.684124062309102</c:v>
                </c:pt>
                <c:pt idx="143">
                  <c:v>67.619307090393207</c:v>
                </c:pt>
                <c:pt idx="144">
                  <c:v>81.526557176821697</c:v>
                </c:pt>
                <c:pt idx="145">
                  <c:v>68.515192646184104</c:v>
                </c:pt>
                <c:pt idx="146">
                  <c:v>58.534088171506497</c:v>
                </c:pt>
                <c:pt idx="147">
                  <c:v>71.400439720775196</c:v>
                </c:pt>
                <c:pt idx="148">
                  <c:v>75.839446066971306</c:v>
                </c:pt>
                <c:pt idx="149">
                  <c:v>53.143145413158202</c:v>
                </c:pt>
                <c:pt idx="150">
                  <c:v>77.876863084471594</c:v>
                </c:pt>
                <c:pt idx="151">
                  <c:v>47.682791215634801</c:v>
                </c:pt>
                <c:pt idx="152">
                  <c:v>76.746646656122493</c:v>
                </c:pt>
                <c:pt idx="153">
                  <c:v>39.852888155989397</c:v>
                </c:pt>
                <c:pt idx="154">
                  <c:v>53.453998817307202</c:v>
                </c:pt>
                <c:pt idx="155">
                  <c:v>57.708977902140496</c:v>
                </c:pt>
                <c:pt idx="156">
                  <c:v>46.9863920382953</c:v>
                </c:pt>
                <c:pt idx="157">
                  <c:v>55.051136690148702</c:v>
                </c:pt>
                <c:pt idx="158">
                  <c:v>76.917340308128104</c:v>
                </c:pt>
                <c:pt idx="159">
                  <c:v>54.586982260412398</c:v>
                </c:pt>
                <c:pt idx="160">
                  <c:v>72.523284204896996</c:v>
                </c:pt>
                <c:pt idx="161">
                  <c:v>55.345648018814998</c:v>
                </c:pt>
                <c:pt idx="162">
                  <c:v>68.170838633156194</c:v>
                </c:pt>
                <c:pt idx="163">
                  <c:v>78.481274906535901</c:v>
                </c:pt>
                <c:pt idx="164">
                  <c:v>65.587733497379702</c:v>
                </c:pt>
                <c:pt idx="165">
                  <c:v>66.265035589739995</c:v>
                </c:pt>
                <c:pt idx="166">
                  <c:v>50.801745052524197</c:v>
                </c:pt>
                <c:pt idx="167">
                  <c:v>42.737939090985897</c:v>
                </c:pt>
                <c:pt idx="168">
                  <c:v>76.994456563937703</c:v>
                </c:pt>
                <c:pt idx="169">
                  <c:v>67.865986734055994</c:v>
                </c:pt>
                <c:pt idx="170">
                  <c:v>61.558470737030298</c:v>
                </c:pt>
                <c:pt idx="171">
                  <c:v>49.603164956258297</c:v>
                </c:pt>
                <c:pt idx="172">
                  <c:v>55.945418222928602</c:v>
                </c:pt>
                <c:pt idx="173">
                  <c:v>53.7932613890356</c:v>
                </c:pt>
                <c:pt idx="174">
                  <c:v>62.649828718977702</c:v>
                </c:pt>
                <c:pt idx="175">
                  <c:v>57.636055591277703</c:v>
                </c:pt>
                <c:pt idx="176">
                  <c:v>52.636521659307903</c:v>
                </c:pt>
                <c:pt idx="177">
                  <c:v>74.939789527598506</c:v>
                </c:pt>
                <c:pt idx="178">
                  <c:v>61.9327308905781</c:v>
                </c:pt>
                <c:pt idx="179">
                  <c:v>73.705330053414301</c:v>
                </c:pt>
                <c:pt idx="180">
                  <c:v>53.455930775373602</c:v>
                </c:pt>
                <c:pt idx="181">
                  <c:v>55.319810916211601</c:v>
                </c:pt>
                <c:pt idx="182">
                  <c:v>66.918111511030503</c:v>
                </c:pt>
                <c:pt idx="183">
                  <c:v>34.500168144843798</c:v>
                </c:pt>
                <c:pt idx="184">
                  <c:v>59.8671515487977</c:v>
                </c:pt>
                <c:pt idx="185">
                  <c:v>60.272865517870599</c:v>
                </c:pt>
                <c:pt idx="186">
                  <c:v>58.519176591984497</c:v>
                </c:pt>
                <c:pt idx="187">
                  <c:v>68.522972826877904</c:v>
                </c:pt>
                <c:pt idx="188">
                  <c:v>64.822843823809706</c:v>
                </c:pt>
                <c:pt idx="189">
                  <c:v>54.522125727556102</c:v>
                </c:pt>
                <c:pt idx="190">
                  <c:v>52.424747538961</c:v>
                </c:pt>
                <c:pt idx="191">
                  <c:v>52.471069252183</c:v>
                </c:pt>
                <c:pt idx="192">
                  <c:v>63.076170525134003</c:v>
                </c:pt>
                <c:pt idx="193">
                  <c:v>51.943395406610598</c:v>
                </c:pt>
                <c:pt idx="194">
                  <c:v>49.5141927031774</c:v>
                </c:pt>
                <c:pt idx="195">
                  <c:v>50.661701913418703</c:v>
                </c:pt>
                <c:pt idx="196">
                  <c:v>73.346381089243394</c:v>
                </c:pt>
                <c:pt idx="197">
                  <c:v>68.126170211203103</c:v>
                </c:pt>
                <c:pt idx="198">
                  <c:v>48.661076108408203</c:v>
                </c:pt>
                <c:pt idx="199">
                  <c:v>77.443033621398598</c:v>
                </c:pt>
                <c:pt idx="200">
                  <c:v>39.594267115784298</c:v>
                </c:pt>
                <c:pt idx="201">
                  <c:v>55.441086830721098</c:v>
                </c:pt>
                <c:pt idx="202">
                  <c:v>66.357265447804295</c:v>
                </c:pt>
                <c:pt idx="203">
                  <c:v>48.799422674181201</c:v>
                </c:pt>
                <c:pt idx="204">
                  <c:v>57.315104505564399</c:v>
                </c:pt>
                <c:pt idx="205">
                  <c:v>39.572211267588997</c:v>
                </c:pt>
                <c:pt idx="206">
                  <c:v>64.57069229679</c:v>
                </c:pt>
                <c:pt idx="207">
                  <c:v>44.3883794588074</c:v>
                </c:pt>
                <c:pt idx="208">
                  <c:v>55.7383861014887</c:v>
                </c:pt>
                <c:pt idx="209">
                  <c:v>55.409576347470797</c:v>
                </c:pt>
                <c:pt idx="210">
                  <c:v>59.578954766288497</c:v>
                </c:pt>
                <c:pt idx="211">
                  <c:v>49.5773399118832</c:v>
                </c:pt>
                <c:pt idx="212">
                  <c:v>52.4861316331965</c:v>
                </c:pt>
                <c:pt idx="213">
                  <c:v>42.7484113559183</c:v>
                </c:pt>
                <c:pt idx="214">
                  <c:v>57.747543127763599</c:v>
                </c:pt>
                <c:pt idx="215">
                  <c:v>71.176194423315494</c:v>
                </c:pt>
                <c:pt idx="216">
                  <c:v>30.479741215353101</c:v>
                </c:pt>
                <c:pt idx="217">
                  <c:v>44.804707868781101</c:v>
                </c:pt>
                <c:pt idx="218">
                  <c:v>50.571895257805103</c:v>
                </c:pt>
                <c:pt idx="219">
                  <c:v>59.285973094934299</c:v>
                </c:pt>
                <c:pt idx="220">
                  <c:v>34.4449869989771</c:v>
                </c:pt>
                <c:pt idx="221">
                  <c:v>53.147252028784997</c:v>
                </c:pt>
                <c:pt idx="222">
                  <c:v>61.872547565668597</c:v>
                </c:pt>
                <c:pt idx="223">
                  <c:v>38.349082435517801</c:v>
                </c:pt>
                <c:pt idx="224">
                  <c:v>57.994836855047197</c:v>
                </c:pt>
                <c:pt idx="225">
                  <c:v>77.542772529837293</c:v>
                </c:pt>
                <c:pt idx="226">
                  <c:v>48.5024956142043</c:v>
                </c:pt>
                <c:pt idx="227">
                  <c:v>36.675650741849701</c:v>
                </c:pt>
                <c:pt idx="228">
                  <c:v>68.841882979556701</c:v>
                </c:pt>
                <c:pt idx="229">
                  <c:v>53.469246146117101</c:v>
                </c:pt>
                <c:pt idx="230">
                  <c:v>77.146725226679294</c:v>
                </c:pt>
                <c:pt idx="231">
                  <c:v>49.714573677847703</c:v>
                </c:pt>
                <c:pt idx="232">
                  <c:v>72.1452047833872</c:v>
                </c:pt>
                <c:pt idx="233">
                  <c:v>61.224105229271203</c:v>
                </c:pt>
                <c:pt idx="234">
                  <c:v>54.831143955502</c:v>
                </c:pt>
                <c:pt idx="235">
                  <c:v>58.123288810507901</c:v>
                </c:pt>
                <c:pt idx="236">
                  <c:v>65.820666996051798</c:v>
                </c:pt>
                <c:pt idx="237">
                  <c:v>27.862315334933701</c:v>
                </c:pt>
                <c:pt idx="238">
                  <c:v>50.547663718224797</c:v>
                </c:pt>
                <c:pt idx="239">
                  <c:v>53.347964102649797</c:v>
                </c:pt>
                <c:pt idx="240">
                  <c:v>55.738785724877097</c:v>
                </c:pt>
                <c:pt idx="241">
                  <c:v>53.761862205532097</c:v>
                </c:pt>
                <c:pt idx="242">
                  <c:v>51.165547311828398</c:v>
                </c:pt>
                <c:pt idx="243">
                  <c:v>76.583561700425193</c:v>
                </c:pt>
                <c:pt idx="244">
                  <c:v>62.539253290501101</c:v>
                </c:pt>
                <c:pt idx="245">
                  <c:v>70.309604939792905</c:v>
                </c:pt>
                <c:pt idx="246">
                  <c:v>72.008993369485907</c:v>
                </c:pt>
                <c:pt idx="247">
                  <c:v>29.874157925509301</c:v>
                </c:pt>
                <c:pt idx="248">
                  <c:v>60.495269391364801</c:v>
                </c:pt>
                <c:pt idx="249">
                  <c:v>60.543312396194999</c:v>
                </c:pt>
                <c:pt idx="250">
                  <c:v>62.362950559233902</c:v>
                </c:pt>
                <c:pt idx="251">
                  <c:v>67.532916617211797</c:v>
                </c:pt>
                <c:pt idx="252">
                  <c:v>53.786248051335001</c:v>
                </c:pt>
                <c:pt idx="253">
                  <c:v>58.5799537320067</c:v>
                </c:pt>
                <c:pt idx="254">
                  <c:v>69.264165765486098</c:v>
                </c:pt>
                <c:pt idx="255">
                  <c:v>27.713639524670601</c:v>
                </c:pt>
                <c:pt idx="256">
                  <c:v>53.027540574231402</c:v>
                </c:pt>
                <c:pt idx="257">
                  <c:v>83.361283792046606</c:v>
                </c:pt>
                <c:pt idx="258">
                  <c:v>77.931575273137895</c:v>
                </c:pt>
                <c:pt idx="259">
                  <c:v>48.180574824539903</c:v>
                </c:pt>
                <c:pt idx="260">
                  <c:v>51.215350383177402</c:v>
                </c:pt>
                <c:pt idx="261">
                  <c:v>44.552763670319301</c:v>
                </c:pt>
                <c:pt idx="262">
                  <c:v>61.1035534093742</c:v>
                </c:pt>
                <c:pt idx="263">
                  <c:v>49.198506324979697</c:v>
                </c:pt>
                <c:pt idx="264">
                  <c:v>36.801757472518297</c:v>
                </c:pt>
                <c:pt idx="265">
                  <c:v>71.016905651463802</c:v>
                </c:pt>
                <c:pt idx="266">
                  <c:v>47.6072970072114</c:v>
                </c:pt>
                <c:pt idx="267">
                  <c:v>55.4324021030192</c:v>
                </c:pt>
                <c:pt idx="268">
                  <c:v>48.766033523268902</c:v>
                </c:pt>
                <c:pt idx="269">
                  <c:v>49.140031317307802</c:v>
                </c:pt>
                <c:pt idx="270">
                  <c:v>66.858853322077593</c:v>
                </c:pt>
                <c:pt idx="271">
                  <c:v>60.467448171316903</c:v>
                </c:pt>
                <c:pt idx="272">
                  <c:v>39.241608323173502</c:v>
                </c:pt>
                <c:pt idx="273">
                  <c:v>41.818266881949498</c:v>
                </c:pt>
                <c:pt idx="274">
                  <c:v>58.091084461038399</c:v>
                </c:pt>
                <c:pt idx="275">
                  <c:v>62.854990909693399</c:v>
                </c:pt>
                <c:pt idx="276">
                  <c:v>39.847641213764199</c:v>
                </c:pt>
                <c:pt idx="277">
                  <c:v>63.513116823478398</c:v>
                </c:pt>
                <c:pt idx="278">
                  <c:v>35.207650996949397</c:v>
                </c:pt>
                <c:pt idx="279">
                  <c:v>52.631130256452003</c:v>
                </c:pt>
                <c:pt idx="280">
                  <c:v>76.321613906962199</c:v>
                </c:pt>
                <c:pt idx="281">
                  <c:v>65.082131950152899</c:v>
                </c:pt>
                <c:pt idx="282">
                  <c:v>68.501584184559505</c:v>
                </c:pt>
                <c:pt idx="283">
                  <c:v>61.216488254482499</c:v>
                </c:pt>
                <c:pt idx="284">
                  <c:v>56.987558978432901</c:v>
                </c:pt>
                <c:pt idx="285">
                  <c:v>52.278126909927103</c:v>
                </c:pt>
                <c:pt idx="286">
                  <c:v>53.778379130412603</c:v>
                </c:pt>
                <c:pt idx="287">
                  <c:v>67.783022260063902</c:v>
                </c:pt>
                <c:pt idx="288">
                  <c:v>63.898588497955402</c:v>
                </c:pt>
                <c:pt idx="289">
                  <c:v>59.685049188367898</c:v>
                </c:pt>
                <c:pt idx="290">
                  <c:v>65.661661952138004</c:v>
                </c:pt>
                <c:pt idx="291">
                  <c:v>48.958639774978302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E9B5-4F8D-9F4F-0BF38910B90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987833599"/>
        <c:axId val="1987522735"/>
      </c:scatterChart>
      <c:valAx>
        <c:axId val="1987833599"/>
        <c:scaling>
          <c:orientation val="minMax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.00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987522735"/>
        <c:crosses val="autoZero"/>
        <c:crossBetween val="midCat"/>
      </c:valAx>
      <c:valAx>
        <c:axId val="1987522735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.00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987833599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 algn="ctr" rtl="0">
              <a:defRPr lang="en-US" sz="2000" b="0" i="0" u="none" strike="noStrike" kern="1200" spc="70" baseline="0">
                <a:solidFill>
                  <a:prstClr val="black">
                    <a:lumMod val="50000"/>
                    <a:lumOff val="50000"/>
                  </a:prst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US" sz="2000" b="1" i="0" u="none" strike="noStrike" kern="1200" spc="70" baseline="0" dirty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HI-GY</a:t>
            </a:r>
          </a:p>
        </c:rich>
      </c:tx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 algn="ctr" rtl="0">
            <a:defRPr lang="en-US" sz="2000" b="0" i="0" u="none" strike="noStrike" kern="1200" spc="70" baseline="0">
              <a:solidFill>
                <a:prstClr val="black">
                  <a:lumMod val="50000"/>
                  <a:lumOff val="50000"/>
                </a:prstClr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title>
    <c:autoTitleDeleted val="0"/>
    <c:plotArea>
      <c:layout/>
      <c:scatterChart>
        <c:scatterStyle val="lineMarker"/>
        <c:varyColors val="0"/>
        <c:ser>
          <c:idx val="0"/>
          <c:order val="0"/>
          <c:tx>
            <c:strRef>
              <c:f>'292RIL'!$K$1</c:f>
              <c:strCache>
                <c:ptCount val="1"/>
                <c:pt idx="0">
                  <c:v>GY</c:v>
                </c:pt>
              </c:strCache>
            </c:strRef>
          </c:tx>
          <c:spPr>
            <a:ln w="1905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trendline>
            <c:spPr>
              <a:ln w="19050" cap="rnd">
                <a:solidFill>
                  <a:schemeClr val="accent1"/>
                </a:solidFill>
                <a:prstDash val="sysDot"/>
              </a:ln>
              <a:effectLst/>
            </c:spPr>
            <c:trendlineType val="linear"/>
            <c:dispRSqr val="1"/>
            <c:dispEq val="1"/>
            <c:trendlineLbl>
              <c:layout>
                <c:manualLayout>
                  <c:x val="0.12770713035870515"/>
                  <c:y val="-0.30945100612423448"/>
                </c:manualLayout>
              </c:layout>
              <c:tx>
                <c:rich>
                  <a:bodyPr rot="0" spcFirstLastPara="1" vertOverflow="ellipsis" vert="horz" wrap="square" anchor="ctr" anchorCtr="1"/>
                  <a:lstStyle/>
                  <a:p>
                    <a:pPr algn="ctr" rtl="0">
                      <a:defRPr lang="en-US" sz="1197" b="0" i="0" u="none" strike="noStrike" kern="1200" baseline="0">
                        <a:solidFill>
                          <a:prstClr val="black">
                            <a:lumMod val="50000"/>
                            <a:lumOff val="50000"/>
                          </a:prstClr>
                        </a:solidFill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defRPr>
                    </a:pPr>
                    <a:r>
                      <a:rPr lang="en-US" sz="1197" b="1" i="0" u="none" strike="noStrike" kern="1200" baseline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rPr>
                      <a:t>y = 0.6078x + 26.348</a:t>
                    </a:r>
                    <a:br>
                      <a:rPr lang="en-US" sz="1197" b="1" i="0" u="none" strike="noStrike" kern="1200" baseline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rPr>
                    </a:br>
                    <a:r>
                      <a:rPr lang="en-US" sz="1197" b="1" i="0" u="none" strike="noStrike" kern="1200" baseline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rPr>
                      <a:t>R² = 0.1044</a:t>
                    </a:r>
                  </a:p>
                </c:rich>
              </c:tx>
              <c:numFmt formatCode="General" sourceLinked="0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anchor="ctr" anchorCtr="1"/>
                <a:lstStyle/>
                <a:p>
                  <a:pPr algn="ctr" rtl="0">
                    <a:defRPr lang="en-US" sz="1197" b="0" i="0" u="none" strike="noStrike" kern="1200" baseline="0">
                      <a:solidFill>
                        <a:prstClr val="black">
                          <a:lumMod val="50000"/>
                          <a:lumOff val="50000"/>
                        </a:prstClr>
                      </a:solidFill>
                      <a:latin typeface="Arial" panose="020B0604020202020204" pitchFamily="34" charset="0"/>
                      <a:ea typeface="+mn-ea"/>
                      <a:cs typeface="Arial" panose="020B0604020202020204" pitchFamily="34" charset="0"/>
                    </a:defRPr>
                  </a:pPr>
                  <a:endParaRPr lang="en-US"/>
                </a:p>
              </c:txPr>
            </c:trendlineLbl>
          </c:trendline>
          <c:xVal>
            <c:numRef>
              <c:f>'292RIL'!$I$2:$I$295</c:f>
              <c:numCache>
                <c:formatCode>0.00</c:formatCode>
                <c:ptCount val="294"/>
                <c:pt idx="0">
                  <c:v>43.689042829081302</c:v>
                </c:pt>
                <c:pt idx="1">
                  <c:v>61.6363689491751</c:v>
                </c:pt>
                <c:pt idx="2">
                  <c:v>63.9117643553965</c:v>
                </c:pt>
                <c:pt idx="3">
                  <c:v>50.586980709414703</c:v>
                </c:pt>
                <c:pt idx="4">
                  <c:v>50.1248866585793</c:v>
                </c:pt>
                <c:pt idx="5">
                  <c:v>51.135944123426597</c:v>
                </c:pt>
                <c:pt idx="6">
                  <c:v>53.492672384442301</c:v>
                </c:pt>
                <c:pt idx="7">
                  <c:v>51.367418490544999</c:v>
                </c:pt>
                <c:pt idx="8">
                  <c:v>55.398341793420599</c:v>
                </c:pt>
                <c:pt idx="9">
                  <c:v>55.111252005938802</c:v>
                </c:pt>
                <c:pt idx="10">
                  <c:v>41.652163394294703</c:v>
                </c:pt>
                <c:pt idx="11">
                  <c:v>54.191388707884499</c:v>
                </c:pt>
                <c:pt idx="12">
                  <c:v>59.929325374097303</c:v>
                </c:pt>
                <c:pt idx="13">
                  <c:v>57.0868987686395</c:v>
                </c:pt>
                <c:pt idx="14">
                  <c:v>48.227963978075003</c:v>
                </c:pt>
                <c:pt idx="15">
                  <c:v>54.692574426601396</c:v>
                </c:pt>
                <c:pt idx="16">
                  <c:v>44.797179686877897</c:v>
                </c:pt>
                <c:pt idx="17">
                  <c:v>41.911317106462498</c:v>
                </c:pt>
                <c:pt idx="18">
                  <c:v>44.442043015223099</c:v>
                </c:pt>
                <c:pt idx="19">
                  <c:v>50.535439856024801</c:v>
                </c:pt>
                <c:pt idx="20">
                  <c:v>51.129503033204102</c:v>
                </c:pt>
                <c:pt idx="21">
                  <c:v>53.537608863595899</c:v>
                </c:pt>
                <c:pt idx="22">
                  <c:v>48.817481371544901</c:v>
                </c:pt>
                <c:pt idx="23">
                  <c:v>50.637411697927902</c:v>
                </c:pt>
                <c:pt idx="24">
                  <c:v>50.893881943430003</c:v>
                </c:pt>
                <c:pt idx="25">
                  <c:v>35.950638784854597</c:v>
                </c:pt>
                <c:pt idx="26">
                  <c:v>45.003180824187901</c:v>
                </c:pt>
                <c:pt idx="27">
                  <c:v>54.581879280019301</c:v>
                </c:pt>
                <c:pt idx="28">
                  <c:v>46.467405862933802</c:v>
                </c:pt>
                <c:pt idx="29">
                  <c:v>53.699345707010501</c:v>
                </c:pt>
                <c:pt idx="30">
                  <c:v>51.775197879881198</c:v>
                </c:pt>
                <c:pt idx="31">
                  <c:v>42.518041265393997</c:v>
                </c:pt>
                <c:pt idx="32">
                  <c:v>58.928154420352399</c:v>
                </c:pt>
                <c:pt idx="33">
                  <c:v>51.833552093822803</c:v>
                </c:pt>
                <c:pt idx="34">
                  <c:v>44.7602056729582</c:v>
                </c:pt>
                <c:pt idx="35">
                  <c:v>47.016223612472601</c:v>
                </c:pt>
                <c:pt idx="36">
                  <c:v>51.520809428723702</c:v>
                </c:pt>
                <c:pt idx="37">
                  <c:v>48.371646013381103</c:v>
                </c:pt>
                <c:pt idx="38">
                  <c:v>51.537331738575602</c:v>
                </c:pt>
                <c:pt idx="39">
                  <c:v>52.457563330428599</c:v>
                </c:pt>
                <c:pt idx="40">
                  <c:v>46.2582051216271</c:v>
                </c:pt>
                <c:pt idx="41">
                  <c:v>53.509550056848902</c:v>
                </c:pt>
                <c:pt idx="42">
                  <c:v>48.394939948748799</c:v>
                </c:pt>
                <c:pt idx="43">
                  <c:v>50.775028545442801</c:v>
                </c:pt>
                <c:pt idx="44">
                  <c:v>51.354576729869997</c:v>
                </c:pt>
                <c:pt idx="45">
                  <c:v>46.519216627857702</c:v>
                </c:pt>
                <c:pt idx="46">
                  <c:v>50.945889347092397</c:v>
                </c:pt>
                <c:pt idx="47">
                  <c:v>46.856113260207302</c:v>
                </c:pt>
                <c:pt idx="48">
                  <c:v>45.6116436775783</c:v>
                </c:pt>
                <c:pt idx="49">
                  <c:v>45.0719893755535</c:v>
                </c:pt>
                <c:pt idx="50">
                  <c:v>48.4696480769041</c:v>
                </c:pt>
                <c:pt idx="51">
                  <c:v>53.092642105726597</c:v>
                </c:pt>
                <c:pt idx="52">
                  <c:v>51.619991553593501</c:v>
                </c:pt>
                <c:pt idx="53">
                  <c:v>44.3020637376503</c:v>
                </c:pt>
                <c:pt idx="54">
                  <c:v>52.024128364236198</c:v>
                </c:pt>
                <c:pt idx="55">
                  <c:v>43.384543736762801</c:v>
                </c:pt>
                <c:pt idx="56">
                  <c:v>45.760969111243703</c:v>
                </c:pt>
                <c:pt idx="57">
                  <c:v>48.623384624652601</c:v>
                </c:pt>
                <c:pt idx="58">
                  <c:v>35.040927154602599</c:v>
                </c:pt>
                <c:pt idx="59">
                  <c:v>53.306694591577298</c:v>
                </c:pt>
                <c:pt idx="60">
                  <c:v>55.999316671244998</c:v>
                </c:pt>
                <c:pt idx="61">
                  <c:v>53.379727852451303</c:v>
                </c:pt>
                <c:pt idx="62">
                  <c:v>56.970255179237903</c:v>
                </c:pt>
                <c:pt idx="63">
                  <c:v>40.954326792625899</c:v>
                </c:pt>
                <c:pt idx="64">
                  <c:v>39.959508333004301</c:v>
                </c:pt>
                <c:pt idx="65">
                  <c:v>46.421916740664003</c:v>
                </c:pt>
                <c:pt idx="66">
                  <c:v>54.531980153079502</c:v>
                </c:pt>
                <c:pt idx="67">
                  <c:v>45.240774240127301</c:v>
                </c:pt>
                <c:pt idx="68">
                  <c:v>41.114536343670402</c:v>
                </c:pt>
                <c:pt idx="69">
                  <c:v>46.258677929782301</c:v>
                </c:pt>
                <c:pt idx="70">
                  <c:v>58.923239967228398</c:v>
                </c:pt>
                <c:pt idx="71">
                  <c:v>56.481794770383701</c:v>
                </c:pt>
                <c:pt idx="72">
                  <c:v>46.0551441437241</c:v>
                </c:pt>
                <c:pt idx="73">
                  <c:v>42.893213940866502</c:v>
                </c:pt>
                <c:pt idx="74">
                  <c:v>54.002242795963497</c:v>
                </c:pt>
                <c:pt idx="75">
                  <c:v>59.645340578090803</c:v>
                </c:pt>
                <c:pt idx="76">
                  <c:v>46.057423787594701</c:v>
                </c:pt>
                <c:pt idx="77">
                  <c:v>48.748742006277602</c:v>
                </c:pt>
                <c:pt idx="78">
                  <c:v>55.706256763079402</c:v>
                </c:pt>
                <c:pt idx="79">
                  <c:v>47.027501383870302</c:v>
                </c:pt>
                <c:pt idx="80">
                  <c:v>55.292287992604003</c:v>
                </c:pt>
                <c:pt idx="81">
                  <c:v>62.044178429999</c:v>
                </c:pt>
                <c:pt idx="82">
                  <c:v>55.909652516225499</c:v>
                </c:pt>
                <c:pt idx="83">
                  <c:v>39.7386366215717</c:v>
                </c:pt>
                <c:pt idx="84">
                  <c:v>45.730535352514103</c:v>
                </c:pt>
                <c:pt idx="85">
                  <c:v>51.100278032052401</c:v>
                </c:pt>
                <c:pt idx="86">
                  <c:v>51.245280491547298</c:v>
                </c:pt>
                <c:pt idx="87">
                  <c:v>38.796303866502797</c:v>
                </c:pt>
                <c:pt idx="88">
                  <c:v>59.483379046562803</c:v>
                </c:pt>
                <c:pt idx="89">
                  <c:v>62.208524675704702</c:v>
                </c:pt>
                <c:pt idx="90">
                  <c:v>35.543246894767698</c:v>
                </c:pt>
                <c:pt idx="91">
                  <c:v>46.6811207746102</c:v>
                </c:pt>
                <c:pt idx="92">
                  <c:v>51.875827595690403</c:v>
                </c:pt>
                <c:pt idx="93">
                  <c:v>52.087756981757899</c:v>
                </c:pt>
                <c:pt idx="94">
                  <c:v>54.920727208461699</c:v>
                </c:pt>
                <c:pt idx="95">
                  <c:v>56.090401629115703</c:v>
                </c:pt>
                <c:pt idx="96">
                  <c:v>43.862850900804297</c:v>
                </c:pt>
                <c:pt idx="97">
                  <c:v>43.9526968675058</c:v>
                </c:pt>
                <c:pt idx="98">
                  <c:v>55.985262061889898</c:v>
                </c:pt>
                <c:pt idx="99">
                  <c:v>69.156328444134402</c:v>
                </c:pt>
                <c:pt idx="100">
                  <c:v>47.0905055659209</c:v>
                </c:pt>
                <c:pt idx="101">
                  <c:v>39.194433016856699</c:v>
                </c:pt>
                <c:pt idx="102">
                  <c:v>59.437484483923299</c:v>
                </c:pt>
                <c:pt idx="103">
                  <c:v>47.484038770306903</c:v>
                </c:pt>
                <c:pt idx="104">
                  <c:v>50.351999078558599</c:v>
                </c:pt>
                <c:pt idx="105">
                  <c:v>48.666041128643101</c:v>
                </c:pt>
                <c:pt idx="106">
                  <c:v>43.979745174941598</c:v>
                </c:pt>
                <c:pt idx="107">
                  <c:v>50.579313827891497</c:v>
                </c:pt>
                <c:pt idx="108">
                  <c:v>48.088389028471397</c:v>
                </c:pt>
                <c:pt idx="109">
                  <c:v>37.300375219217997</c:v>
                </c:pt>
                <c:pt idx="110">
                  <c:v>43.853382713579599</c:v>
                </c:pt>
                <c:pt idx="111">
                  <c:v>50.115686458069902</c:v>
                </c:pt>
                <c:pt idx="112">
                  <c:v>36.955501732154701</c:v>
                </c:pt>
                <c:pt idx="113">
                  <c:v>53.9869358547529</c:v>
                </c:pt>
                <c:pt idx="114">
                  <c:v>52.714936953325399</c:v>
                </c:pt>
                <c:pt idx="115">
                  <c:v>58.021196879830498</c:v>
                </c:pt>
                <c:pt idx="116">
                  <c:v>59.535794009871999</c:v>
                </c:pt>
                <c:pt idx="117">
                  <c:v>63.638131384462199</c:v>
                </c:pt>
                <c:pt idx="118">
                  <c:v>52.9595963138066</c:v>
                </c:pt>
                <c:pt idx="119">
                  <c:v>55.4794366003539</c:v>
                </c:pt>
                <c:pt idx="120">
                  <c:v>50.481569012728698</c:v>
                </c:pt>
                <c:pt idx="121">
                  <c:v>44.169163680301999</c:v>
                </c:pt>
                <c:pt idx="122">
                  <c:v>48.614219570119303</c:v>
                </c:pt>
                <c:pt idx="123">
                  <c:v>64.423513579069507</c:v>
                </c:pt>
                <c:pt idx="124">
                  <c:v>46.094863185397301</c:v>
                </c:pt>
                <c:pt idx="125">
                  <c:v>49.503037101173803</c:v>
                </c:pt>
                <c:pt idx="126">
                  <c:v>50.693100541686398</c:v>
                </c:pt>
                <c:pt idx="127">
                  <c:v>49.029379136881502</c:v>
                </c:pt>
                <c:pt idx="128">
                  <c:v>57.142291585650803</c:v>
                </c:pt>
                <c:pt idx="129">
                  <c:v>56.960606356584499</c:v>
                </c:pt>
                <c:pt idx="130">
                  <c:v>55.266531434643802</c:v>
                </c:pt>
                <c:pt idx="131">
                  <c:v>51.430617870045999</c:v>
                </c:pt>
                <c:pt idx="132">
                  <c:v>42.8545042713721</c:v>
                </c:pt>
                <c:pt idx="133">
                  <c:v>46.517822567331301</c:v>
                </c:pt>
                <c:pt idx="134">
                  <c:v>43.833451073597999</c:v>
                </c:pt>
                <c:pt idx="135">
                  <c:v>57.840760528045898</c:v>
                </c:pt>
                <c:pt idx="136">
                  <c:v>43.464435687104697</c:v>
                </c:pt>
                <c:pt idx="137">
                  <c:v>47.143742190112498</c:v>
                </c:pt>
                <c:pt idx="138">
                  <c:v>48.080340510699699</c:v>
                </c:pt>
                <c:pt idx="139">
                  <c:v>40.270256070111699</c:v>
                </c:pt>
                <c:pt idx="140">
                  <c:v>51.801934367266099</c:v>
                </c:pt>
                <c:pt idx="141">
                  <c:v>48.583673104747398</c:v>
                </c:pt>
                <c:pt idx="142">
                  <c:v>54.324882088107501</c:v>
                </c:pt>
                <c:pt idx="143">
                  <c:v>51.560880309424803</c:v>
                </c:pt>
                <c:pt idx="144">
                  <c:v>60.430126785662402</c:v>
                </c:pt>
                <c:pt idx="145">
                  <c:v>50.735250980771298</c:v>
                </c:pt>
                <c:pt idx="146">
                  <c:v>56.2210350139434</c:v>
                </c:pt>
                <c:pt idx="147">
                  <c:v>61.136623702136497</c:v>
                </c:pt>
                <c:pt idx="148">
                  <c:v>56.433363188225698</c:v>
                </c:pt>
                <c:pt idx="149">
                  <c:v>52.230608341219998</c:v>
                </c:pt>
                <c:pt idx="150">
                  <c:v>55.111332801861401</c:v>
                </c:pt>
                <c:pt idx="151">
                  <c:v>41.519901759238401</c:v>
                </c:pt>
                <c:pt idx="152">
                  <c:v>48.0873254092106</c:v>
                </c:pt>
                <c:pt idx="153">
                  <c:v>37.157856504828203</c:v>
                </c:pt>
                <c:pt idx="154">
                  <c:v>56.669068021625698</c:v>
                </c:pt>
                <c:pt idx="155">
                  <c:v>55.6115451195109</c:v>
                </c:pt>
                <c:pt idx="156">
                  <c:v>52.812605801416098</c:v>
                </c:pt>
                <c:pt idx="157">
                  <c:v>48.401197765459401</c:v>
                </c:pt>
                <c:pt idx="158">
                  <c:v>50.8323274216363</c:v>
                </c:pt>
                <c:pt idx="159">
                  <c:v>49.563210366658303</c:v>
                </c:pt>
                <c:pt idx="160">
                  <c:v>51.453454333948201</c:v>
                </c:pt>
                <c:pt idx="161">
                  <c:v>49.296243685398899</c:v>
                </c:pt>
                <c:pt idx="162">
                  <c:v>57.1693206228775</c:v>
                </c:pt>
                <c:pt idx="163">
                  <c:v>48.797936339162902</c:v>
                </c:pt>
                <c:pt idx="164">
                  <c:v>56.971734924859099</c:v>
                </c:pt>
                <c:pt idx="165">
                  <c:v>51.617907859216103</c:v>
                </c:pt>
                <c:pt idx="166">
                  <c:v>47.104356723000102</c:v>
                </c:pt>
                <c:pt idx="167">
                  <c:v>61.806225148143099</c:v>
                </c:pt>
                <c:pt idx="168">
                  <c:v>55.686393937454199</c:v>
                </c:pt>
                <c:pt idx="169">
                  <c:v>50.298781512445203</c:v>
                </c:pt>
                <c:pt idx="170">
                  <c:v>48.619257463392699</c:v>
                </c:pt>
                <c:pt idx="171">
                  <c:v>42.958210595663203</c:v>
                </c:pt>
                <c:pt idx="172">
                  <c:v>45.332709273310797</c:v>
                </c:pt>
                <c:pt idx="173">
                  <c:v>53.173778909434397</c:v>
                </c:pt>
                <c:pt idx="174">
                  <c:v>41.275494927497597</c:v>
                </c:pt>
                <c:pt idx="175">
                  <c:v>50.478608571372803</c:v>
                </c:pt>
                <c:pt idx="176">
                  <c:v>43.632702996889002</c:v>
                </c:pt>
                <c:pt idx="177">
                  <c:v>52.776357978248903</c:v>
                </c:pt>
                <c:pt idx="178">
                  <c:v>57.769076297329597</c:v>
                </c:pt>
                <c:pt idx="179">
                  <c:v>55.645368475867301</c:v>
                </c:pt>
                <c:pt idx="180">
                  <c:v>44.483640405214501</c:v>
                </c:pt>
                <c:pt idx="181">
                  <c:v>54.788407205207697</c:v>
                </c:pt>
                <c:pt idx="182">
                  <c:v>56.349846990137202</c:v>
                </c:pt>
                <c:pt idx="183">
                  <c:v>60.928171215323196</c:v>
                </c:pt>
                <c:pt idx="184">
                  <c:v>47.089457196121302</c:v>
                </c:pt>
                <c:pt idx="185">
                  <c:v>53.5708820256406</c:v>
                </c:pt>
                <c:pt idx="186">
                  <c:v>63.697262639688397</c:v>
                </c:pt>
                <c:pt idx="187">
                  <c:v>48.675598051997099</c:v>
                </c:pt>
                <c:pt idx="188">
                  <c:v>63.911321578846596</c:v>
                </c:pt>
                <c:pt idx="189">
                  <c:v>52.129247325933697</c:v>
                </c:pt>
                <c:pt idx="190">
                  <c:v>46.280494061541603</c:v>
                </c:pt>
                <c:pt idx="191">
                  <c:v>49.616800426335402</c:v>
                </c:pt>
                <c:pt idx="192">
                  <c:v>55.454114199038898</c:v>
                </c:pt>
                <c:pt idx="193">
                  <c:v>47.853244276291797</c:v>
                </c:pt>
                <c:pt idx="194">
                  <c:v>50.685902045890899</c:v>
                </c:pt>
                <c:pt idx="195">
                  <c:v>47.886107519718898</c:v>
                </c:pt>
                <c:pt idx="196">
                  <c:v>49.3999057723452</c:v>
                </c:pt>
                <c:pt idx="197">
                  <c:v>66.105801506410998</c:v>
                </c:pt>
                <c:pt idx="198">
                  <c:v>34.469687470150902</c:v>
                </c:pt>
                <c:pt idx="199">
                  <c:v>53.759354723187897</c:v>
                </c:pt>
                <c:pt idx="200">
                  <c:v>37.492851407658897</c:v>
                </c:pt>
                <c:pt idx="201">
                  <c:v>41.300287438393099</c:v>
                </c:pt>
                <c:pt idx="202">
                  <c:v>54.271810909750897</c:v>
                </c:pt>
                <c:pt idx="203">
                  <c:v>56.081484847720802</c:v>
                </c:pt>
                <c:pt idx="204">
                  <c:v>49.439105370895298</c:v>
                </c:pt>
                <c:pt idx="205">
                  <c:v>48.777738043279001</c:v>
                </c:pt>
                <c:pt idx="206">
                  <c:v>43.869649722355803</c:v>
                </c:pt>
                <c:pt idx="207">
                  <c:v>56.770104144339001</c:v>
                </c:pt>
                <c:pt idx="208">
                  <c:v>44.7835561439096</c:v>
                </c:pt>
                <c:pt idx="209">
                  <c:v>53.990098074992503</c:v>
                </c:pt>
                <c:pt idx="210">
                  <c:v>49.973100613957897</c:v>
                </c:pt>
                <c:pt idx="211">
                  <c:v>46.555165281761603</c:v>
                </c:pt>
                <c:pt idx="212">
                  <c:v>37.105731417051103</c:v>
                </c:pt>
                <c:pt idx="213">
                  <c:v>53.726578077771002</c:v>
                </c:pt>
                <c:pt idx="214">
                  <c:v>48.713671076363298</c:v>
                </c:pt>
                <c:pt idx="215">
                  <c:v>50.686559254730703</c:v>
                </c:pt>
                <c:pt idx="216">
                  <c:v>48.465458380820401</c:v>
                </c:pt>
                <c:pt idx="217">
                  <c:v>53.2221736600819</c:v>
                </c:pt>
                <c:pt idx="218">
                  <c:v>50.214827031640397</c:v>
                </c:pt>
                <c:pt idx="219">
                  <c:v>44.7987102802349</c:v>
                </c:pt>
                <c:pt idx="220">
                  <c:v>42.937678479553398</c:v>
                </c:pt>
                <c:pt idx="221">
                  <c:v>52.8536088724642</c:v>
                </c:pt>
                <c:pt idx="222">
                  <c:v>56.356572363098401</c:v>
                </c:pt>
                <c:pt idx="223">
                  <c:v>48.395733309027797</c:v>
                </c:pt>
                <c:pt idx="224">
                  <c:v>54.883785250265497</c:v>
                </c:pt>
                <c:pt idx="225">
                  <c:v>50.690315951926202</c:v>
                </c:pt>
                <c:pt idx="226">
                  <c:v>58.479084150866299</c:v>
                </c:pt>
                <c:pt idx="227">
                  <c:v>66.839948452183194</c:v>
                </c:pt>
                <c:pt idx="228">
                  <c:v>46.713515974300201</c:v>
                </c:pt>
                <c:pt idx="229">
                  <c:v>44.483438080956098</c:v>
                </c:pt>
                <c:pt idx="230">
                  <c:v>42.343990054170497</c:v>
                </c:pt>
                <c:pt idx="231">
                  <c:v>53.734915637841297</c:v>
                </c:pt>
                <c:pt idx="232">
                  <c:v>55.426900898415397</c:v>
                </c:pt>
                <c:pt idx="233">
                  <c:v>44.705549289832199</c:v>
                </c:pt>
                <c:pt idx="234">
                  <c:v>54.836477627036103</c:v>
                </c:pt>
                <c:pt idx="235">
                  <c:v>54.321393275639103</c:v>
                </c:pt>
                <c:pt idx="236">
                  <c:v>49.817138867627897</c:v>
                </c:pt>
                <c:pt idx="237">
                  <c:v>38.666998817570203</c:v>
                </c:pt>
                <c:pt idx="238">
                  <c:v>40.406842729210403</c:v>
                </c:pt>
                <c:pt idx="239">
                  <c:v>58.035960877751997</c:v>
                </c:pt>
                <c:pt idx="240">
                  <c:v>57.813801326573198</c:v>
                </c:pt>
                <c:pt idx="241">
                  <c:v>42.408609646400997</c:v>
                </c:pt>
                <c:pt idx="242">
                  <c:v>44.1107683894285</c:v>
                </c:pt>
                <c:pt idx="243">
                  <c:v>55.784434585518198</c:v>
                </c:pt>
                <c:pt idx="244">
                  <c:v>60.548859700771999</c:v>
                </c:pt>
                <c:pt idx="245">
                  <c:v>64.6402852674983</c:v>
                </c:pt>
                <c:pt idx="246">
                  <c:v>46.103182024383898</c:v>
                </c:pt>
                <c:pt idx="247">
                  <c:v>49.2258635712857</c:v>
                </c:pt>
                <c:pt idx="248">
                  <c:v>46.841689193967099</c:v>
                </c:pt>
                <c:pt idx="249">
                  <c:v>42.632015789835997</c:v>
                </c:pt>
                <c:pt idx="250">
                  <c:v>56.923779136598199</c:v>
                </c:pt>
                <c:pt idx="251">
                  <c:v>59.143060573480398</c:v>
                </c:pt>
                <c:pt idx="252">
                  <c:v>47.881398549137501</c:v>
                </c:pt>
                <c:pt idx="253">
                  <c:v>60.748896295060703</c:v>
                </c:pt>
                <c:pt idx="254">
                  <c:v>51.407186747279702</c:v>
                </c:pt>
                <c:pt idx="255">
                  <c:v>40.595332051182403</c:v>
                </c:pt>
                <c:pt idx="256">
                  <c:v>43.434877987669203</c:v>
                </c:pt>
                <c:pt idx="257">
                  <c:v>57.2093663352492</c:v>
                </c:pt>
                <c:pt idx="258">
                  <c:v>63.483748251269397</c:v>
                </c:pt>
                <c:pt idx="259">
                  <c:v>50.519809755843298</c:v>
                </c:pt>
                <c:pt idx="260">
                  <c:v>57.4560834714121</c:v>
                </c:pt>
                <c:pt idx="261">
                  <c:v>43.180417669686598</c:v>
                </c:pt>
                <c:pt idx="262">
                  <c:v>48.383246543121103</c:v>
                </c:pt>
                <c:pt idx="263">
                  <c:v>54.250132336703103</c:v>
                </c:pt>
                <c:pt idx="264">
                  <c:v>54.280576325239103</c:v>
                </c:pt>
                <c:pt idx="265">
                  <c:v>47.080396439854397</c:v>
                </c:pt>
                <c:pt idx="266">
                  <c:v>46.926783663598499</c:v>
                </c:pt>
                <c:pt idx="267">
                  <c:v>56.567421515344101</c:v>
                </c:pt>
                <c:pt idx="268">
                  <c:v>60.899330102594199</c:v>
                </c:pt>
                <c:pt idx="269">
                  <c:v>47.987535692183798</c:v>
                </c:pt>
                <c:pt idx="270">
                  <c:v>59.865240144643003</c:v>
                </c:pt>
                <c:pt idx="271">
                  <c:v>54.356019864133899</c:v>
                </c:pt>
                <c:pt idx="272">
                  <c:v>49.778738657946299</c:v>
                </c:pt>
                <c:pt idx="273">
                  <c:v>45.409413193791401</c:v>
                </c:pt>
                <c:pt idx="274">
                  <c:v>54.989260383494901</c:v>
                </c:pt>
                <c:pt idx="275">
                  <c:v>54.911456812751602</c:v>
                </c:pt>
                <c:pt idx="276">
                  <c:v>52.337057037372503</c:v>
                </c:pt>
                <c:pt idx="277">
                  <c:v>47.418373472069199</c:v>
                </c:pt>
                <c:pt idx="278">
                  <c:v>48.106913237957002</c:v>
                </c:pt>
                <c:pt idx="279">
                  <c:v>52.4432880688368</c:v>
                </c:pt>
                <c:pt idx="280">
                  <c:v>62.431578389815797</c:v>
                </c:pt>
                <c:pt idx="281">
                  <c:v>51.900261222789403</c:v>
                </c:pt>
                <c:pt idx="282">
                  <c:v>54.293928290039403</c:v>
                </c:pt>
                <c:pt idx="283">
                  <c:v>46.536348607135203</c:v>
                </c:pt>
                <c:pt idx="284">
                  <c:v>43.073970044800397</c:v>
                </c:pt>
                <c:pt idx="285">
                  <c:v>48.319340077357197</c:v>
                </c:pt>
                <c:pt idx="286">
                  <c:v>47.508228980477703</c:v>
                </c:pt>
                <c:pt idx="287">
                  <c:v>46.251468271673701</c:v>
                </c:pt>
                <c:pt idx="288">
                  <c:v>50.825138632927001</c:v>
                </c:pt>
                <c:pt idx="289">
                  <c:v>46.9340256243024</c:v>
                </c:pt>
                <c:pt idx="290">
                  <c:v>49.664363979165699</c:v>
                </c:pt>
                <c:pt idx="291">
                  <c:v>53.009363528322403</c:v>
                </c:pt>
              </c:numCache>
            </c:numRef>
          </c:xVal>
          <c:yVal>
            <c:numRef>
              <c:f>'292RIL'!$K$2:$K$295</c:f>
              <c:numCache>
                <c:formatCode>0.00</c:formatCode>
                <c:ptCount val="294"/>
                <c:pt idx="0">
                  <c:v>62.228763290178101</c:v>
                </c:pt>
                <c:pt idx="1">
                  <c:v>58.398647092707797</c:v>
                </c:pt>
                <c:pt idx="2">
                  <c:v>67.938251841318902</c:v>
                </c:pt>
                <c:pt idx="3">
                  <c:v>77.704187246374104</c:v>
                </c:pt>
                <c:pt idx="4">
                  <c:v>56.936607797670803</c:v>
                </c:pt>
                <c:pt idx="5">
                  <c:v>58.6647073822975</c:v>
                </c:pt>
                <c:pt idx="6">
                  <c:v>72.223810597963293</c:v>
                </c:pt>
                <c:pt idx="7">
                  <c:v>67.243567647199598</c:v>
                </c:pt>
                <c:pt idx="8">
                  <c:v>47.9022004663384</c:v>
                </c:pt>
                <c:pt idx="9">
                  <c:v>62.425342227148498</c:v>
                </c:pt>
                <c:pt idx="10">
                  <c:v>58.003269178974499</c:v>
                </c:pt>
                <c:pt idx="11">
                  <c:v>55.729957707818201</c:v>
                </c:pt>
                <c:pt idx="12">
                  <c:v>68.929132899682799</c:v>
                </c:pt>
                <c:pt idx="13">
                  <c:v>69.467349869445997</c:v>
                </c:pt>
                <c:pt idx="14">
                  <c:v>43.955886393952802</c:v>
                </c:pt>
                <c:pt idx="15">
                  <c:v>48.3969850559291</c:v>
                </c:pt>
                <c:pt idx="16">
                  <c:v>47.734581566811499</c:v>
                </c:pt>
                <c:pt idx="17">
                  <c:v>53.963149336327</c:v>
                </c:pt>
                <c:pt idx="18">
                  <c:v>60.474570657113397</c:v>
                </c:pt>
                <c:pt idx="19">
                  <c:v>52.714785172957697</c:v>
                </c:pt>
                <c:pt idx="20">
                  <c:v>50.551641525222799</c:v>
                </c:pt>
                <c:pt idx="21">
                  <c:v>44.936317781137397</c:v>
                </c:pt>
                <c:pt idx="22">
                  <c:v>67.180766436604998</c:v>
                </c:pt>
                <c:pt idx="23">
                  <c:v>43.189913444553198</c:v>
                </c:pt>
                <c:pt idx="24">
                  <c:v>60.411170331965799</c:v>
                </c:pt>
                <c:pt idx="25">
                  <c:v>14.947028411218801</c:v>
                </c:pt>
                <c:pt idx="26">
                  <c:v>61.254846791595099</c:v>
                </c:pt>
                <c:pt idx="27">
                  <c:v>60.001715008676399</c:v>
                </c:pt>
                <c:pt idx="28">
                  <c:v>55.673661293305898</c:v>
                </c:pt>
                <c:pt idx="29">
                  <c:v>42.747807207142202</c:v>
                </c:pt>
                <c:pt idx="30">
                  <c:v>59.312503195903602</c:v>
                </c:pt>
                <c:pt idx="31">
                  <c:v>47.9983750350425</c:v>
                </c:pt>
                <c:pt idx="32">
                  <c:v>77.322276540066696</c:v>
                </c:pt>
                <c:pt idx="33">
                  <c:v>62.775785928698298</c:v>
                </c:pt>
                <c:pt idx="34">
                  <c:v>50.822938767402597</c:v>
                </c:pt>
                <c:pt idx="35">
                  <c:v>42.887768697559103</c:v>
                </c:pt>
                <c:pt idx="36">
                  <c:v>69.030662323876797</c:v>
                </c:pt>
                <c:pt idx="37">
                  <c:v>55.334032984598799</c:v>
                </c:pt>
                <c:pt idx="38">
                  <c:v>49.673041508934098</c:v>
                </c:pt>
                <c:pt idx="39">
                  <c:v>65.713870125904194</c:v>
                </c:pt>
                <c:pt idx="40">
                  <c:v>67.514002975373003</c:v>
                </c:pt>
                <c:pt idx="41">
                  <c:v>63.167526608214402</c:v>
                </c:pt>
                <c:pt idx="42">
                  <c:v>50.186291154217301</c:v>
                </c:pt>
                <c:pt idx="43">
                  <c:v>34.023256329648902</c:v>
                </c:pt>
                <c:pt idx="44">
                  <c:v>66.426277180282995</c:v>
                </c:pt>
                <c:pt idx="45">
                  <c:v>37.049953932151901</c:v>
                </c:pt>
                <c:pt idx="46">
                  <c:v>23.130219489150502</c:v>
                </c:pt>
                <c:pt idx="47">
                  <c:v>62.599536814255003</c:v>
                </c:pt>
                <c:pt idx="48">
                  <c:v>63.951103420073203</c:v>
                </c:pt>
                <c:pt idx="49">
                  <c:v>45.035331177826997</c:v>
                </c:pt>
                <c:pt idx="50">
                  <c:v>59.989490169730601</c:v>
                </c:pt>
                <c:pt idx="51">
                  <c:v>44.920242687760599</c:v>
                </c:pt>
                <c:pt idx="52">
                  <c:v>73.190256658584403</c:v>
                </c:pt>
                <c:pt idx="53">
                  <c:v>69.259823719268496</c:v>
                </c:pt>
                <c:pt idx="54">
                  <c:v>70.106101221638397</c:v>
                </c:pt>
                <c:pt idx="55">
                  <c:v>53.128841810669499</c:v>
                </c:pt>
                <c:pt idx="56">
                  <c:v>57.182594448297699</c:v>
                </c:pt>
                <c:pt idx="57">
                  <c:v>45.185689781243902</c:v>
                </c:pt>
                <c:pt idx="58">
                  <c:v>48.567972620586097</c:v>
                </c:pt>
                <c:pt idx="59">
                  <c:v>33.939468697867902</c:v>
                </c:pt>
                <c:pt idx="60">
                  <c:v>72.375143850000796</c:v>
                </c:pt>
                <c:pt idx="61">
                  <c:v>65.615017756812307</c:v>
                </c:pt>
                <c:pt idx="62">
                  <c:v>67.267258905588804</c:v>
                </c:pt>
                <c:pt idx="63">
                  <c:v>33.415359570950301</c:v>
                </c:pt>
                <c:pt idx="64">
                  <c:v>54.817736838917902</c:v>
                </c:pt>
                <c:pt idx="65">
                  <c:v>54.9046756138464</c:v>
                </c:pt>
                <c:pt idx="66">
                  <c:v>63.3775490974256</c:v>
                </c:pt>
                <c:pt idx="67">
                  <c:v>57.305730991656603</c:v>
                </c:pt>
                <c:pt idx="68">
                  <c:v>43.762730952829003</c:v>
                </c:pt>
                <c:pt idx="69">
                  <c:v>47.346116856653602</c:v>
                </c:pt>
                <c:pt idx="70">
                  <c:v>26.117868609791302</c:v>
                </c:pt>
                <c:pt idx="71">
                  <c:v>31.070496911565801</c:v>
                </c:pt>
                <c:pt idx="72">
                  <c:v>55.4780246612479</c:v>
                </c:pt>
                <c:pt idx="73">
                  <c:v>43.838755589278101</c:v>
                </c:pt>
                <c:pt idx="74">
                  <c:v>68.231644802832903</c:v>
                </c:pt>
                <c:pt idx="75">
                  <c:v>69.388084225036195</c:v>
                </c:pt>
                <c:pt idx="76">
                  <c:v>68.083686893998504</c:v>
                </c:pt>
                <c:pt idx="77">
                  <c:v>57.362631083849102</c:v>
                </c:pt>
                <c:pt idx="78">
                  <c:v>69.581218258306194</c:v>
                </c:pt>
                <c:pt idx="79">
                  <c:v>38.525775575964502</c:v>
                </c:pt>
                <c:pt idx="80">
                  <c:v>49.919442690220897</c:v>
                </c:pt>
                <c:pt idx="81">
                  <c:v>89.761608279646296</c:v>
                </c:pt>
                <c:pt idx="82">
                  <c:v>51.340608176601698</c:v>
                </c:pt>
                <c:pt idx="83">
                  <c:v>62.142554170048399</c:v>
                </c:pt>
                <c:pt idx="84">
                  <c:v>49.124964017840199</c:v>
                </c:pt>
                <c:pt idx="85">
                  <c:v>45.430878908599098</c:v>
                </c:pt>
                <c:pt idx="86">
                  <c:v>47.049721019486</c:v>
                </c:pt>
                <c:pt idx="87">
                  <c:v>40.076064527809898</c:v>
                </c:pt>
                <c:pt idx="88">
                  <c:v>30.7061183580327</c:v>
                </c:pt>
                <c:pt idx="89">
                  <c:v>53.6896236086492</c:v>
                </c:pt>
                <c:pt idx="90">
                  <c:v>45.262596811130699</c:v>
                </c:pt>
                <c:pt idx="91">
                  <c:v>49.722699699847801</c:v>
                </c:pt>
                <c:pt idx="92">
                  <c:v>68.268541944572405</c:v>
                </c:pt>
                <c:pt idx="93">
                  <c:v>56.943895381656198</c:v>
                </c:pt>
                <c:pt idx="94">
                  <c:v>64.804536499389002</c:v>
                </c:pt>
                <c:pt idx="95">
                  <c:v>49.906490528587199</c:v>
                </c:pt>
                <c:pt idx="96">
                  <c:v>41.599505592842704</c:v>
                </c:pt>
                <c:pt idx="97">
                  <c:v>55.2793148864179</c:v>
                </c:pt>
                <c:pt idx="98">
                  <c:v>67.831219248816097</c:v>
                </c:pt>
                <c:pt idx="99">
                  <c:v>71.852658229553597</c:v>
                </c:pt>
                <c:pt idx="100">
                  <c:v>62.1780589325164</c:v>
                </c:pt>
                <c:pt idx="101">
                  <c:v>44.665967511131598</c:v>
                </c:pt>
                <c:pt idx="102">
                  <c:v>73.896059301193006</c:v>
                </c:pt>
                <c:pt idx="103">
                  <c:v>51.969808160613098</c:v>
                </c:pt>
                <c:pt idx="104">
                  <c:v>59.393827564406998</c:v>
                </c:pt>
                <c:pt idx="105">
                  <c:v>46.437239872607002</c:v>
                </c:pt>
                <c:pt idx="106">
                  <c:v>59.838093580451797</c:v>
                </c:pt>
                <c:pt idx="107">
                  <c:v>61.675437469304299</c:v>
                </c:pt>
                <c:pt idx="108">
                  <c:v>64.873179933953097</c:v>
                </c:pt>
                <c:pt idx="109">
                  <c:v>60.998117668349103</c:v>
                </c:pt>
                <c:pt idx="110">
                  <c:v>57.776651778437802</c:v>
                </c:pt>
                <c:pt idx="111">
                  <c:v>53.749096416363997</c:v>
                </c:pt>
                <c:pt idx="112">
                  <c:v>40.455178520760398</c:v>
                </c:pt>
                <c:pt idx="113">
                  <c:v>64.979086326752693</c:v>
                </c:pt>
                <c:pt idx="114">
                  <c:v>54.117925526048801</c:v>
                </c:pt>
                <c:pt idx="115">
                  <c:v>69.756545713984494</c:v>
                </c:pt>
                <c:pt idx="116">
                  <c:v>68.937362637230194</c:v>
                </c:pt>
                <c:pt idx="117">
                  <c:v>53.086813767324202</c:v>
                </c:pt>
                <c:pt idx="118">
                  <c:v>68.747217221871495</c:v>
                </c:pt>
                <c:pt idx="119">
                  <c:v>53.652322233267</c:v>
                </c:pt>
                <c:pt idx="120">
                  <c:v>65.406771279427005</c:v>
                </c:pt>
                <c:pt idx="121">
                  <c:v>45.3188378110587</c:v>
                </c:pt>
                <c:pt idx="122">
                  <c:v>51.962019015966298</c:v>
                </c:pt>
                <c:pt idx="123">
                  <c:v>70.548300095799306</c:v>
                </c:pt>
                <c:pt idx="124">
                  <c:v>66.433985291178004</c:v>
                </c:pt>
                <c:pt idx="125">
                  <c:v>52.698567142806802</c:v>
                </c:pt>
                <c:pt idx="126">
                  <c:v>74.992422026640895</c:v>
                </c:pt>
                <c:pt idx="127">
                  <c:v>74.9687675728199</c:v>
                </c:pt>
                <c:pt idx="128">
                  <c:v>71.390415778272697</c:v>
                </c:pt>
                <c:pt idx="129">
                  <c:v>57.8144598550194</c:v>
                </c:pt>
                <c:pt idx="130">
                  <c:v>60.8634070558237</c:v>
                </c:pt>
                <c:pt idx="131">
                  <c:v>67.151010397833105</c:v>
                </c:pt>
                <c:pt idx="132">
                  <c:v>47.760218798772101</c:v>
                </c:pt>
                <c:pt idx="133">
                  <c:v>54.723426478951602</c:v>
                </c:pt>
                <c:pt idx="134">
                  <c:v>53.324767312468303</c:v>
                </c:pt>
                <c:pt idx="135">
                  <c:v>68.716062737809693</c:v>
                </c:pt>
                <c:pt idx="136">
                  <c:v>60.690622176783499</c:v>
                </c:pt>
                <c:pt idx="137">
                  <c:v>73.2726824605584</c:v>
                </c:pt>
                <c:pt idx="138">
                  <c:v>48.907363720225497</c:v>
                </c:pt>
                <c:pt idx="139">
                  <c:v>56.5282803310741</c:v>
                </c:pt>
                <c:pt idx="140">
                  <c:v>60.494691742409699</c:v>
                </c:pt>
                <c:pt idx="141">
                  <c:v>52.182556029250598</c:v>
                </c:pt>
                <c:pt idx="142">
                  <c:v>54.684124062309102</c:v>
                </c:pt>
                <c:pt idx="143">
                  <c:v>67.619307090393207</c:v>
                </c:pt>
                <c:pt idx="144">
                  <c:v>81.526557176821697</c:v>
                </c:pt>
                <c:pt idx="145">
                  <c:v>68.515192646184104</c:v>
                </c:pt>
                <c:pt idx="146">
                  <c:v>58.534088171506497</c:v>
                </c:pt>
                <c:pt idx="147">
                  <c:v>71.400439720775196</c:v>
                </c:pt>
                <c:pt idx="148">
                  <c:v>75.839446066971306</c:v>
                </c:pt>
                <c:pt idx="149">
                  <c:v>53.143145413158202</c:v>
                </c:pt>
                <c:pt idx="150">
                  <c:v>77.876863084471594</c:v>
                </c:pt>
                <c:pt idx="151">
                  <c:v>47.682791215634801</c:v>
                </c:pt>
                <c:pt idx="152">
                  <c:v>76.746646656122493</c:v>
                </c:pt>
                <c:pt idx="153">
                  <c:v>39.852888155989397</c:v>
                </c:pt>
                <c:pt idx="154">
                  <c:v>53.453998817307202</c:v>
                </c:pt>
                <c:pt idx="155">
                  <c:v>57.708977902140496</c:v>
                </c:pt>
                <c:pt idx="156">
                  <c:v>46.9863920382953</c:v>
                </c:pt>
                <c:pt idx="157">
                  <c:v>55.051136690148702</c:v>
                </c:pt>
                <c:pt idx="158">
                  <c:v>76.917340308128104</c:v>
                </c:pt>
                <c:pt idx="159">
                  <c:v>54.586982260412398</c:v>
                </c:pt>
                <c:pt idx="160">
                  <c:v>72.523284204896996</c:v>
                </c:pt>
                <c:pt idx="161">
                  <c:v>55.345648018814998</c:v>
                </c:pt>
                <c:pt idx="162">
                  <c:v>68.170838633156194</c:v>
                </c:pt>
                <c:pt idx="163">
                  <c:v>78.481274906535901</c:v>
                </c:pt>
                <c:pt idx="164">
                  <c:v>65.587733497379702</c:v>
                </c:pt>
                <c:pt idx="165">
                  <c:v>66.265035589739995</c:v>
                </c:pt>
                <c:pt idx="166">
                  <c:v>50.801745052524197</c:v>
                </c:pt>
                <c:pt idx="167">
                  <c:v>42.737939090985897</c:v>
                </c:pt>
                <c:pt idx="168">
                  <c:v>76.994456563937703</c:v>
                </c:pt>
                <c:pt idx="169">
                  <c:v>67.865986734055994</c:v>
                </c:pt>
                <c:pt idx="170">
                  <c:v>61.558470737030298</c:v>
                </c:pt>
                <c:pt idx="171">
                  <c:v>49.603164956258297</c:v>
                </c:pt>
                <c:pt idx="172">
                  <c:v>55.945418222928602</c:v>
                </c:pt>
                <c:pt idx="173">
                  <c:v>53.7932613890356</c:v>
                </c:pt>
                <c:pt idx="174">
                  <c:v>62.649828718977702</c:v>
                </c:pt>
                <c:pt idx="175">
                  <c:v>57.636055591277703</c:v>
                </c:pt>
                <c:pt idx="176">
                  <c:v>52.636521659307903</c:v>
                </c:pt>
                <c:pt idx="177">
                  <c:v>74.939789527598506</c:v>
                </c:pt>
                <c:pt idx="178">
                  <c:v>61.9327308905781</c:v>
                </c:pt>
                <c:pt idx="179">
                  <c:v>73.705330053414301</c:v>
                </c:pt>
                <c:pt idx="180">
                  <c:v>53.455930775373602</c:v>
                </c:pt>
                <c:pt idx="181">
                  <c:v>55.319810916211601</c:v>
                </c:pt>
                <c:pt idx="182">
                  <c:v>66.918111511030503</c:v>
                </c:pt>
                <c:pt idx="183">
                  <c:v>34.500168144843798</c:v>
                </c:pt>
                <c:pt idx="184">
                  <c:v>59.8671515487977</c:v>
                </c:pt>
                <c:pt idx="185">
                  <c:v>60.272865517870599</c:v>
                </c:pt>
                <c:pt idx="186">
                  <c:v>58.519176591984497</c:v>
                </c:pt>
                <c:pt idx="187">
                  <c:v>68.522972826877904</c:v>
                </c:pt>
                <c:pt idx="188">
                  <c:v>64.822843823809706</c:v>
                </c:pt>
                <c:pt idx="189">
                  <c:v>54.522125727556102</c:v>
                </c:pt>
                <c:pt idx="190">
                  <c:v>52.424747538961</c:v>
                </c:pt>
                <c:pt idx="191">
                  <c:v>52.471069252183</c:v>
                </c:pt>
                <c:pt idx="192">
                  <c:v>63.076170525134003</c:v>
                </c:pt>
                <c:pt idx="193">
                  <c:v>51.943395406610598</c:v>
                </c:pt>
                <c:pt idx="194">
                  <c:v>49.5141927031774</c:v>
                </c:pt>
                <c:pt idx="195">
                  <c:v>50.661701913418703</c:v>
                </c:pt>
                <c:pt idx="196">
                  <c:v>73.346381089243394</c:v>
                </c:pt>
                <c:pt idx="197">
                  <c:v>68.126170211203103</c:v>
                </c:pt>
                <c:pt idx="198">
                  <c:v>48.661076108408203</c:v>
                </c:pt>
                <c:pt idx="199">
                  <c:v>77.443033621398598</c:v>
                </c:pt>
                <c:pt idx="200">
                  <c:v>39.594267115784298</c:v>
                </c:pt>
                <c:pt idx="201">
                  <c:v>55.441086830721098</c:v>
                </c:pt>
                <c:pt idx="202">
                  <c:v>66.357265447804295</c:v>
                </c:pt>
                <c:pt idx="203">
                  <c:v>48.799422674181201</c:v>
                </c:pt>
                <c:pt idx="204">
                  <c:v>57.315104505564399</c:v>
                </c:pt>
                <c:pt idx="205">
                  <c:v>39.572211267588997</c:v>
                </c:pt>
                <c:pt idx="206">
                  <c:v>64.57069229679</c:v>
                </c:pt>
                <c:pt idx="207">
                  <c:v>44.3883794588074</c:v>
                </c:pt>
                <c:pt idx="208">
                  <c:v>55.7383861014887</c:v>
                </c:pt>
                <c:pt idx="209">
                  <c:v>55.409576347470797</c:v>
                </c:pt>
                <c:pt idx="210">
                  <c:v>59.578954766288497</c:v>
                </c:pt>
                <c:pt idx="211">
                  <c:v>49.5773399118832</c:v>
                </c:pt>
                <c:pt idx="212">
                  <c:v>52.4861316331965</c:v>
                </c:pt>
                <c:pt idx="213">
                  <c:v>42.7484113559183</c:v>
                </c:pt>
                <c:pt idx="214">
                  <c:v>57.747543127763599</c:v>
                </c:pt>
                <c:pt idx="215">
                  <c:v>71.176194423315494</c:v>
                </c:pt>
                <c:pt idx="216">
                  <c:v>30.479741215353101</c:v>
                </c:pt>
                <c:pt idx="217">
                  <c:v>44.804707868781101</c:v>
                </c:pt>
                <c:pt idx="218">
                  <c:v>50.571895257805103</c:v>
                </c:pt>
                <c:pt idx="219">
                  <c:v>59.285973094934299</c:v>
                </c:pt>
                <c:pt idx="220">
                  <c:v>34.4449869989771</c:v>
                </c:pt>
                <c:pt idx="221">
                  <c:v>53.147252028784997</c:v>
                </c:pt>
                <c:pt idx="222">
                  <c:v>61.872547565668597</c:v>
                </c:pt>
                <c:pt idx="223">
                  <c:v>38.349082435517801</c:v>
                </c:pt>
                <c:pt idx="224">
                  <c:v>57.994836855047197</c:v>
                </c:pt>
                <c:pt idx="225">
                  <c:v>77.542772529837293</c:v>
                </c:pt>
                <c:pt idx="226">
                  <c:v>48.5024956142043</c:v>
                </c:pt>
                <c:pt idx="227">
                  <c:v>36.675650741849701</c:v>
                </c:pt>
                <c:pt idx="228">
                  <c:v>68.841882979556701</c:v>
                </c:pt>
                <c:pt idx="229">
                  <c:v>53.469246146117101</c:v>
                </c:pt>
                <c:pt idx="230">
                  <c:v>77.146725226679294</c:v>
                </c:pt>
                <c:pt idx="231">
                  <c:v>49.714573677847703</c:v>
                </c:pt>
                <c:pt idx="232">
                  <c:v>72.1452047833872</c:v>
                </c:pt>
                <c:pt idx="233">
                  <c:v>61.224105229271203</c:v>
                </c:pt>
                <c:pt idx="234">
                  <c:v>54.831143955502</c:v>
                </c:pt>
                <c:pt idx="235">
                  <c:v>58.123288810507901</c:v>
                </c:pt>
                <c:pt idx="236">
                  <c:v>65.820666996051798</c:v>
                </c:pt>
                <c:pt idx="237">
                  <c:v>27.862315334933701</c:v>
                </c:pt>
                <c:pt idx="238">
                  <c:v>50.547663718224797</c:v>
                </c:pt>
                <c:pt idx="239">
                  <c:v>53.347964102649797</c:v>
                </c:pt>
                <c:pt idx="240">
                  <c:v>55.738785724877097</c:v>
                </c:pt>
                <c:pt idx="241">
                  <c:v>53.761862205532097</c:v>
                </c:pt>
                <c:pt idx="242">
                  <c:v>51.165547311828398</c:v>
                </c:pt>
                <c:pt idx="243">
                  <c:v>76.583561700425193</c:v>
                </c:pt>
                <c:pt idx="244">
                  <c:v>62.539253290501101</c:v>
                </c:pt>
                <c:pt idx="245">
                  <c:v>70.309604939792905</c:v>
                </c:pt>
                <c:pt idx="246">
                  <c:v>72.008993369485907</c:v>
                </c:pt>
                <c:pt idx="247">
                  <c:v>29.874157925509301</c:v>
                </c:pt>
                <c:pt idx="248">
                  <c:v>60.495269391364801</c:v>
                </c:pt>
                <c:pt idx="249">
                  <c:v>60.543312396194999</c:v>
                </c:pt>
                <c:pt idx="250">
                  <c:v>62.362950559233902</c:v>
                </c:pt>
                <c:pt idx="251">
                  <c:v>67.532916617211797</c:v>
                </c:pt>
                <c:pt idx="252">
                  <c:v>53.786248051335001</c:v>
                </c:pt>
                <c:pt idx="253">
                  <c:v>58.5799537320067</c:v>
                </c:pt>
                <c:pt idx="254">
                  <c:v>69.264165765486098</c:v>
                </c:pt>
                <c:pt idx="255">
                  <c:v>27.713639524670601</c:v>
                </c:pt>
                <c:pt idx="256">
                  <c:v>53.027540574231402</c:v>
                </c:pt>
                <c:pt idx="257">
                  <c:v>83.361283792046606</c:v>
                </c:pt>
                <c:pt idx="258">
                  <c:v>77.931575273137895</c:v>
                </c:pt>
                <c:pt idx="259">
                  <c:v>48.180574824539903</c:v>
                </c:pt>
                <c:pt idx="260">
                  <c:v>51.215350383177402</c:v>
                </c:pt>
                <c:pt idx="261">
                  <c:v>44.552763670319301</c:v>
                </c:pt>
                <c:pt idx="262">
                  <c:v>61.1035534093742</c:v>
                </c:pt>
                <c:pt idx="263">
                  <c:v>49.198506324979697</c:v>
                </c:pt>
                <c:pt idx="264">
                  <c:v>36.801757472518297</c:v>
                </c:pt>
                <c:pt idx="265">
                  <c:v>71.016905651463802</c:v>
                </c:pt>
                <c:pt idx="266">
                  <c:v>47.6072970072114</c:v>
                </c:pt>
                <c:pt idx="267">
                  <c:v>55.4324021030192</c:v>
                </c:pt>
                <c:pt idx="268">
                  <c:v>48.766033523268902</c:v>
                </c:pt>
                <c:pt idx="269">
                  <c:v>49.140031317307802</c:v>
                </c:pt>
                <c:pt idx="270">
                  <c:v>66.858853322077593</c:v>
                </c:pt>
                <c:pt idx="271">
                  <c:v>60.467448171316903</c:v>
                </c:pt>
                <c:pt idx="272">
                  <c:v>39.241608323173502</c:v>
                </c:pt>
                <c:pt idx="273">
                  <c:v>41.818266881949498</c:v>
                </c:pt>
                <c:pt idx="274">
                  <c:v>58.091084461038399</c:v>
                </c:pt>
                <c:pt idx="275">
                  <c:v>62.854990909693399</c:v>
                </c:pt>
                <c:pt idx="276">
                  <c:v>39.847641213764199</c:v>
                </c:pt>
                <c:pt idx="277">
                  <c:v>63.513116823478398</c:v>
                </c:pt>
                <c:pt idx="278">
                  <c:v>35.207650996949397</c:v>
                </c:pt>
                <c:pt idx="279">
                  <c:v>52.631130256452003</c:v>
                </c:pt>
                <c:pt idx="280">
                  <c:v>76.321613906962199</c:v>
                </c:pt>
                <c:pt idx="281">
                  <c:v>65.082131950152899</c:v>
                </c:pt>
                <c:pt idx="282">
                  <c:v>68.501584184559505</c:v>
                </c:pt>
                <c:pt idx="283">
                  <c:v>61.216488254482499</c:v>
                </c:pt>
                <c:pt idx="284">
                  <c:v>56.987558978432901</c:v>
                </c:pt>
                <c:pt idx="285">
                  <c:v>52.278126909927103</c:v>
                </c:pt>
                <c:pt idx="286">
                  <c:v>53.778379130412603</c:v>
                </c:pt>
                <c:pt idx="287">
                  <c:v>67.783022260063902</c:v>
                </c:pt>
                <c:pt idx="288">
                  <c:v>63.898588497955402</c:v>
                </c:pt>
                <c:pt idx="289">
                  <c:v>59.685049188367898</c:v>
                </c:pt>
                <c:pt idx="290">
                  <c:v>65.661661952138004</c:v>
                </c:pt>
                <c:pt idx="291">
                  <c:v>48.958639774978302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56F9-4B4D-9D1F-3C5CAE12D95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987833599"/>
        <c:axId val="1987522735"/>
      </c:scatterChart>
      <c:valAx>
        <c:axId val="1987833599"/>
        <c:scaling>
          <c:orientation val="minMax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.00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en-US" sz="1197" b="0" i="0" u="none" strike="noStrike" kern="1200" baseline="0">
                <a:solidFill>
                  <a:schemeClr val="dk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987522735"/>
        <c:crosses val="autoZero"/>
        <c:crossBetween val="midCat"/>
      </c:valAx>
      <c:valAx>
        <c:axId val="1987522735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.00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en-US" sz="1197" b="0" i="0" u="none" strike="noStrike" kern="1200" baseline="0">
                <a:solidFill>
                  <a:schemeClr val="dk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987833599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lang="en-US" sz="1197" b="0" i="0" u="none" strike="noStrike" kern="1200" baseline="0">
          <a:solidFill>
            <a:schemeClr val="dk1"/>
          </a:solidFill>
          <a:latin typeface="+mn-lt"/>
          <a:ea typeface="+mn-ea"/>
          <a:cs typeface="+mn-cs"/>
        </a:defRPr>
      </a:pPr>
      <a:endParaRPr lang="en-US"/>
    </a:p>
  </c:txPr>
  <c:externalData r:id="rId3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 algn="ctr" rtl="0">
              <a:defRPr lang="en-US" sz="2000" b="0" i="0" u="none" strike="noStrike" kern="1200" spc="70" baseline="0">
                <a:solidFill>
                  <a:prstClr val="black">
                    <a:lumMod val="50000"/>
                    <a:lumOff val="50000"/>
                  </a:prst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US" sz="2000" b="1" i="0" u="none" strike="noStrike" kern="1200" spc="70" baseline="0" dirty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%PodSet- GY</a:t>
            </a:r>
          </a:p>
        </c:rich>
      </c:tx>
      <c:layout>
        <c:manualLayout>
          <c:xMode val="edge"/>
          <c:yMode val="edge"/>
          <c:x val="0.28919832210438573"/>
          <c:y val="4.6296296296296294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 algn="ctr" rtl="0">
            <a:defRPr lang="en-US" sz="2000" b="0" i="0" u="none" strike="noStrike" kern="1200" spc="70" baseline="0">
              <a:solidFill>
                <a:prstClr val="black">
                  <a:lumMod val="50000"/>
                  <a:lumOff val="50000"/>
                </a:prstClr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title>
    <c:autoTitleDeleted val="0"/>
    <c:plotArea>
      <c:layout/>
      <c:scatterChart>
        <c:scatterStyle val="lineMarker"/>
        <c:varyColors val="0"/>
        <c:ser>
          <c:idx val="0"/>
          <c:order val="0"/>
          <c:tx>
            <c:strRef>
              <c:f>'292RIL'!$K$1</c:f>
              <c:strCache>
                <c:ptCount val="1"/>
                <c:pt idx="0">
                  <c:v>GY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trendline>
            <c:spPr>
              <a:ln w="19050" cap="rnd">
                <a:solidFill>
                  <a:schemeClr val="accent1"/>
                </a:solidFill>
                <a:prstDash val="sysDot"/>
              </a:ln>
              <a:effectLst/>
            </c:spPr>
            <c:trendlineType val="linear"/>
            <c:dispRSqr val="1"/>
            <c:dispEq val="1"/>
            <c:trendlineLbl>
              <c:layout>
                <c:manualLayout>
                  <c:x val="0.10875284339457568"/>
                  <c:y val="-0.20930300379119277"/>
                </c:manualLayout>
              </c:layout>
              <c:tx>
                <c:rich>
                  <a:bodyPr rot="0" spcFirstLastPara="1" vertOverflow="ellipsis" vert="horz" wrap="square" anchor="ctr" anchorCtr="1"/>
                  <a:lstStyle/>
                  <a:p>
                    <a:pPr algn="ctr" rtl="0">
                      <a:defRPr lang="en-US" sz="1197" b="0" i="0" u="none" strike="noStrike" kern="1200" baseline="0">
                        <a:solidFill>
                          <a:prstClr val="black">
                            <a:lumMod val="50000"/>
                            <a:lumOff val="50000"/>
                          </a:prstClr>
                        </a:solidFill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defRPr>
                    </a:pPr>
                    <a:r>
                      <a:rPr lang="en-US" sz="1197" b="1" i="0" u="none" strike="noStrike" kern="1200" baseline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rPr>
                      <a:t>y = 0.7223x + 30.168</a:t>
                    </a:r>
                    <a:br>
                      <a:rPr lang="en-US" sz="1197" b="1" i="0" u="none" strike="noStrike" kern="1200" baseline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rPr>
                    </a:br>
                    <a:r>
                      <a:rPr lang="en-US" sz="1197" b="1" i="0" u="none" strike="noStrike" kern="1200" baseline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rPr>
                      <a:t>R² = 0.3984</a:t>
                    </a:r>
                  </a:p>
                </c:rich>
              </c:tx>
              <c:numFmt formatCode="General" sourceLinked="0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anchor="ctr" anchorCtr="1"/>
                <a:lstStyle/>
                <a:p>
                  <a:pPr algn="ctr" rtl="0">
                    <a:defRPr lang="en-US" sz="1197" b="0" i="0" u="none" strike="noStrike" kern="1200" baseline="0">
                      <a:solidFill>
                        <a:prstClr val="black">
                          <a:lumMod val="50000"/>
                          <a:lumOff val="50000"/>
                        </a:prstClr>
                      </a:solidFill>
                      <a:latin typeface="Arial" panose="020B0604020202020204" pitchFamily="34" charset="0"/>
                      <a:ea typeface="+mn-ea"/>
                      <a:cs typeface="Arial" panose="020B0604020202020204" pitchFamily="34" charset="0"/>
                    </a:defRPr>
                  </a:pPr>
                  <a:endParaRPr lang="en-US"/>
                </a:p>
              </c:txPr>
            </c:trendlineLbl>
          </c:trendline>
          <c:xVal>
            <c:numRef>
              <c:f>'292RIL'!$J$2:$J$295</c:f>
              <c:numCache>
                <c:formatCode>0.00</c:formatCode>
                <c:ptCount val="294"/>
                <c:pt idx="0">
                  <c:v>48.019800000000004</c:v>
                </c:pt>
                <c:pt idx="1">
                  <c:v>32.702600000000004</c:v>
                </c:pt>
                <c:pt idx="2">
                  <c:v>32.5809</c:v>
                </c:pt>
                <c:pt idx="3">
                  <c:v>53.779200000000003</c:v>
                </c:pt>
                <c:pt idx="4">
                  <c:v>51.541899999999998</c:v>
                </c:pt>
                <c:pt idx="5">
                  <c:v>48.226799999999997</c:v>
                </c:pt>
                <c:pt idx="6">
                  <c:v>31.042899999999999</c:v>
                </c:pt>
                <c:pt idx="7">
                  <c:v>43.204500000000003</c:v>
                </c:pt>
                <c:pt idx="8">
                  <c:v>23.070900000000002</c:v>
                </c:pt>
                <c:pt idx="9">
                  <c:v>33.915300000000002</c:v>
                </c:pt>
                <c:pt idx="10">
                  <c:v>33.900100000000002</c:v>
                </c:pt>
                <c:pt idx="11">
                  <c:v>44.725900000000003</c:v>
                </c:pt>
                <c:pt idx="12">
                  <c:v>34.747500000000002</c:v>
                </c:pt>
                <c:pt idx="13">
                  <c:v>27.2911</c:v>
                </c:pt>
                <c:pt idx="14">
                  <c:v>38.985799999999998</c:v>
                </c:pt>
                <c:pt idx="15">
                  <c:v>31.143000000000001</c:v>
                </c:pt>
                <c:pt idx="16">
                  <c:v>27.7532</c:v>
                </c:pt>
                <c:pt idx="17">
                  <c:v>56.638199999999998</c:v>
                </c:pt>
                <c:pt idx="18">
                  <c:v>30.690999999999999</c:v>
                </c:pt>
                <c:pt idx="19">
                  <c:v>42.901800000000001</c:v>
                </c:pt>
                <c:pt idx="20">
                  <c:v>31.350200000000001</c:v>
                </c:pt>
                <c:pt idx="21">
                  <c:v>21.827999999999999</c:v>
                </c:pt>
                <c:pt idx="22">
                  <c:v>48.750500000000002</c:v>
                </c:pt>
                <c:pt idx="23">
                  <c:v>36.866700000000002</c:v>
                </c:pt>
                <c:pt idx="24">
                  <c:v>35.860700000000001</c:v>
                </c:pt>
                <c:pt idx="25">
                  <c:v>3.6807999999999979</c:v>
                </c:pt>
                <c:pt idx="26">
                  <c:v>38.133200000000002</c:v>
                </c:pt>
                <c:pt idx="27">
                  <c:v>30.367899999999999</c:v>
                </c:pt>
                <c:pt idx="28">
                  <c:v>45.121699999999997</c:v>
                </c:pt>
                <c:pt idx="29">
                  <c:v>40.086399999999998</c:v>
                </c:pt>
                <c:pt idx="30">
                  <c:v>32.462699999999998</c:v>
                </c:pt>
                <c:pt idx="31">
                  <c:v>34.514200000000002</c:v>
                </c:pt>
                <c:pt idx="32">
                  <c:v>45.796300000000002</c:v>
                </c:pt>
                <c:pt idx="33">
                  <c:v>71.250799999999998</c:v>
                </c:pt>
                <c:pt idx="34">
                  <c:v>47.535800000000002</c:v>
                </c:pt>
                <c:pt idx="35">
                  <c:v>25.931699999999999</c:v>
                </c:pt>
                <c:pt idx="36">
                  <c:v>44.870800000000003</c:v>
                </c:pt>
                <c:pt idx="37">
                  <c:v>37.198700000000002</c:v>
                </c:pt>
                <c:pt idx="38">
                  <c:v>40.083300000000001</c:v>
                </c:pt>
                <c:pt idx="39">
                  <c:v>46.366700000000002</c:v>
                </c:pt>
                <c:pt idx="40">
                  <c:v>42.996499999999997</c:v>
                </c:pt>
                <c:pt idx="41">
                  <c:v>46.851300000000002</c:v>
                </c:pt>
                <c:pt idx="42">
                  <c:v>27.267499999999998</c:v>
                </c:pt>
                <c:pt idx="43">
                  <c:v>18.288499999999999</c:v>
                </c:pt>
                <c:pt idx="44">
                  <c:v>42.5366</c:v>
                </c:pt>
                <c:pt idx="45">
                  <c:v>26.578699999999998</c:v>
                </c:pt>
                <c:pt idx="46">
                  <c:v>12.441700000000001</c:v>
                </c:pt>
                <c:pt idx="47">
                  <c:v>36.374200000000002</c:v>
                </c:pt>
                <c:pt idx="48">
                  <c:v>52.193399999999997</c:v>
                </c:pt>
                <c:pt idx="49">
                  <c:v>26.993600000000001</c:v>
                </c:pt>
                <c:pt idx="50">
                  <c:v>37.560099999999998</c:v>
                </c:pt>
                <c:pt idx="51">
                  <c:v>27.472000000000001</c:v>
                </c:pt>
                <c:pt idx="52">
                  <c:v>52.075499999999998</c:v>
                </c:pt>
                <c:pt idx="53">
                  <c:v>46.762299999999996</c:v>
                </c:pt>
                <c:pt idx="54">
                  <c:v>52.829099999999997</c:v>
                </c:pt>
                <c:pt idx="55">
                  <c:v>41.354999999999997</c:v>
                </c:pt>
                <c:pt idx="56">
                  <c:v>40.823599999999999</c:v>
                </c:pt>
                <c:pt idx="57">
                  <c:v>40.884999999999998</c:v>
                </c:pt>
                <c:pt idx="58">
                  <c:v>41.735999999999997</c:v>
                </c:pt>
                <c:pt idx="59">
                  <c:v>27.3994</c:v>
                </c:pt>
                <c:pt idx="60">
                  <c:v>51.101100000000002</c:v>
                </c:pt>
                <c:pt idx="61">
                  <c:v>33.791600000000003</c:v>
                </c:pt>
                <c:pt idx="62">
                  <c:v>31.289400000000001</c:v>
                </c:pt>
                <c:pt idx="63">
                  <c:v>10.801600000000001</c:v>
                </c:pt>
                <c:pt idx="64">
                  <c:v>52.542400000000001</c:v>
                </c:pt>
                <c:pt idx="65">
                  <c:v>25.9861</c:v>
                </c:pt>
                <c:pt idx="66">
                  <c:v>31.491700000000002</c:v>
                </c:pt>
                <c:pt idx="67">
                  <c:v>43.294400000000003</c:v>
                </c:pt>
                <c:pt idx="68">
                  <c:v>30.980499999999999</c:v>
                </c:pt>
                <c:pt idx="69">
                  <c:v>38.738700000000001</c:v>
                </c:pt>
                <c:pt idx="70">
                  <c:v>10.7697</c:v>
                </c:pt>
                <c:pt idx="71">
                  <c:v>24.816200000000002</c:v>
                </c:pt>
                <c:pt idx="72">
                  <c:v>50.5717</c:v>
                </c:pt>
                <c:pt idx="73">
                  <c:v>36.905000000000001</c:v>
                </c:pt>
                <c:pt idx="74">
                  <c:v>53.061300000000003</c:v>
                </c:pt>
                <c:pt idx="75">
                  <c:v>32.552999999999997</c:v>
                </c:pt>
                <c:pt idx="76">
                  <c:v>43.328899999999997</c:v>
                </c:pt>
                <c:pt idx="77">
                  <c:v>30.0168</c:v>
                </c:pt>
                <c:pt idx="78">
                  <c:v>31.502400000000002</c:v>
                </c:pt>
                <c:pt idx="79">
                  <c:v>28.5288</c:v>
                </c:pt>
                <c:pt idx="80">
                  <c:v>50.219200000000001</c:v>
                </c:pt>
                <c:pt idx="81">
                  <c:v>51.684899999999999</c:v>
                </c:pt>
                <c:pt idx="82">
                  <c:v>28.324400000000001</c:v>
                </c:pt>
                <c:pt idx="83">
                  <c:v>42.346600000000002</c:v>
                </c:pt>
                <c:pt idx="84">
                  <c:v>31.195499999999999</c:v>
                </c:pt>
                <c:pt idx="85">
                  <c:v>21.4451</c:v>
                </c:pt>
                <c:pt idx="86">
                  <c:v>31.433700000000002</c:v>
                </c:pt>
                <c:pt idx="87">
                  <c:v>17.4681</c:v>
                </c:pt>
                <c:pt idx="88">
                  <c:v>19.6921</c:v>
                </c:pt>
                <c:pt idx="89">
                  <c:v>38.103299999999997</c:v>
                </c:pt>
                <c:pt idx="90">
                  <c:v>45.508800000000001</c:v>
                </c:pt>
                <c:pt idx="91">
                  <c:v>31.664400000000001</c:v>
                </c:pt>
                <c:pt idx="92">
                  <c:v>32.730600000000003</c:v>
                </c:pt>
                <c:pt idx="93">
                  <c:v>37.305</c:v>
                </c:pt>
                <c:pt idx="94">
                  <c:v>37.34019</c:v>
                </c:pt>
                <c:pt idx="95">
                  <c:v>30.0291</c:v>
                </c:pt>
                <c:pt idx="96">
                  <c:v>25.212800000000001</c:v>
                </c:pt>
                <c:pt idx="97">
                  <c:v>40.1616</c:v>
                </c:pt>
                <c:pt idx="98">
                  <c:v>40.909799999999997</c:v>
                </c:pt>
                <c:pt idx="99">
                  <c:v>35.930500000000002</c:v>
                </c:pt>
                <c:pt idx="100">
                  <c:v>43.280099999999997</c:v>
                </c:pt>
                <c:pt idx="101">
                  <c:v>44.6004</c:v>
                </c:pt>
                <c:pt idx="102">
                  <c:v>52.764299999999999</c:v>
                </c:pt>
                <c:pt idx="103">
                  <c:v>28.3993</c:v>
                </c:pt>
                <c:pt idx="104">
                  <c:v>39.493099999999998</c:v>
                </c:pt>
                <c:pt idx="105">
                  <c:v>41.926699999999997</c:v>
                </c:pt>
                <c:pt idx="106">
                  <c:v>45.834400000000002</c:v>
                </c:pt>
                <c:pt idx="107">
                  <c:v>40.254599999999996</c:v>
                </c:pt>
                <c:pt idx="108">
                  <c:v>42.520200000000003</c:v>
                </c:pt>
                <c:pt idx="109">
                  <c:v>51.315399999999997</c:v>
                </c:pt>
                <c:pt idx="110">
                  <c:v>51.938299999999998</c:v>
                </c:pt>
                <c:pt idx="111">
                  <c:v>25.858599999999999</c:v>
                </c:pt>
                <c:pt idx="112">
                  <c:v>27.429600000000001</c:v>
                </c:pt>
                <c:pt idx="113">
                  <c:v>46.6496</c:v>
                </c:pt>
                <c:pt idx="114">
                  <c:v>39.726799999999997</c:v>
                </c:pt>
                <c:pt idx="115">
                  <c:v>45.830100000000002</c:v>
                </c:pt>
                <c:pt idx="116">
                  <c:v>38.631900000000002</c:v>
                </c:pt>
                <c:pt idx="117">
                  <c:v>22.9543</c:v>
                </c:pt>
                <c:pt idx="118">
                  <c:v>48.851399999999998</c:v>
                </c:pt>
                <c:pt idx="119">
                  <c:v>27.081499999999998</c:v>
                </c:pt>
                <c:pt idx="120">
                  <c:v>26.647100000000002</c:v>
                </c:pt>
                <c:pt idx="121">
                  <c:v>34.854199999999999</c:v>
                </c:pt>
                <c:pt idx="122">
                  <c:v>47.543799999999997</c:v>
                </c:pt>
                <c:pt idx="123">
                  <c:v>46.8232</c:v>
                </c:pt>
                <c:pt idx="124">
                  <c:v>47.974499999999999</c:v>
                </c:pt>
                <c:pt idx="125">
                  <c:v>36.741</c:v>
                </c:pt>
                <c:pt idx="126">
                  <c:v>43.955599999999997</c:v>
                </c:pt>
                <c:pt idx="127">
                  <c:v>47.652200000000001</c:v>
                </c:pt>
                <c:pt idx="128">
                  <c:v>45.004899999999999</c:v>
                </c:pt>
                <c:pt idx="129">
                  <c:v>45.199100000000001</c:v>
                </c:pt>
                <c:pt idx="130">
                  <c:v>30.5504</c:v>
                </c:pt>
                <c:pt idx="131">
                  <c:v>27.939299999999999</c:v>
                </c:pt>
                <c:pt idx="132">
                  <c:v>40.603999999999999</c:v>
                </c:pt>
                <c:pt idx="133">
                  <c:v>31.632300000000001</c:v>
                </c:pt>
                <c:pt idx="134">
                  <c:v>46.399100000000004</c:v>
                </c:pt>
                <c:pt idx="135">
                  <c:v>40.909199999999998</c:v>
                </c:pt>
                <c:pt idx="136">
                  <c:v>29.566200000000002</c:v>
                </c:pt>
                <c:pt idx="137">
                  <c:v>45.815799999999996</c:v>
                </c:pt>
                <c:pt idx="138">
                  <c:v>24.884399999999999</c:v>
                </c:pt>
                <c:pt idx="139">
                  <c:v>48.0685</c:v>
                </c:pt>
                <c:pt idx="140">
                  <c:v>44.809800000000003</c:v>
                </c:pt>
                <c:pt idx="141">
                  <c:v>31.845300000000002</c:v>
                </c:pt>
                <c:pt idx="142">
                  <c:v>30.423200000000001</c:v>
                </c:pt>
                <c:pt idx="143">
                  <c:v>33.617400000000004</c:v>
                </c:pt>
                <c:pt idx="144">
                  <c:v>42.042900000000003</c:v>
                </c:pt>
                <c:pt idx="145">
                  <c:v>31.127800000000001</c:v>
                </c:pt>
                <c:pt idx="146">
                  <c:v>40.256700000000002</c:v>
                </c:pt>
                <c:pt idx="147">
                  <c:v>38.581000000000003</c:v>
                </c:pt>
                <c:pt idx="148">
                  <c:v>42.843200000000003</c:v>
                </c:pt>
                <c:pt idx="149">
                  <c:v>32.683099999999996</c:v>
                </c:pt>
                <c:pt idx="150">
                  <c:v>39.743899999999996</c:v>
                </c:pt>
                <c:pt idx="151">
                  <c:v>42.116599999999998</c:v>
                </c:pt>
                <c:pt idx="152">
                  <c:v>50.1751</c:v>
                </c:pt>
                <c:pt idx="153">
                  <c:v>32.004599999999996</c:v>
                </c:pt>
                <c:pt idx="154">
                  <c:v>26.087800000000001</c:v>
                </c:pt>
                <c:pt idx="155">
                  <c:v>38.110900000000001</c:v>
                </c:pt>
                <c:pt idx="156">
                  <c:v>22.165700000000001</c:v>
                </c:pt>
                <c:pt idx="157">
                  <c:v>40.142699999999998</c:v>
                </c:pt>
                <c:pt idx="158">
                  <c:v>39.6738</c:v>
                </c:pt>
                <c:pt idx="159">
                  <c:v>39.064500000000002</c:v>
                </c:pt>
                <c:pt idx="160">
                  <c:v>49.445399999999999</c:v>
                </c:pt>
                <c:pt idx="161">
                  <c:v>59.234400000000001</c:v>
                </c:pt>
                <c:pt idx="162">
                  <c:v>35.649900000000002</c:v>
                </c:pt>
                <c:pt idx="163">
                  <c:v>42.266500000000001</c:v>
                </c:pt>
                <c:pt idx="164">
                  <c:v>40.229999999999997</c:v>
                </c:pt>
                <c:pt idx="165">
                  <c:v>39.191200000000002</c:v>
                </c:pt>
                <c:pt idx="166">
                  <c:v>24.303899999999999</c:v>
                </c:pt>
                <c:pt idx="167">
                  <c:v>25.904400000000003</c:v>
                </c:pt>
                <c:pt idx="168">
                  <c:v>44.665300000000002</c:v>
                </c:pt>
                <c:pt idx="169">
                  <c:v>45.320900000000002</c:v>
                </c:pt>
                <c:pt idx="170">
                  <c:v>41.752400000000002</c:v>
                </c:pt>
                <c:pt idx="171">
                  <c:v>41.836599999999997</c:v>
                </c:pt>
                <c:pt idx="172">
                  <c:v>41.192599999999999</c:v>
                </c:pt>
                <c:pt idx="173">
                  <c:v>30.355800000000002</c:v>
                </c:pt>
                <c:pt idx="174">
                  <c:v>49.043799999999997</c:v>
                </c:pt>
                <c:pt idx="175">
                  <c:v>40.455500000000001</c:v>
                </c:pt>
                <c:pt idx="176">
                  <c:v>43.946600000000004</c:v>
                </c:pt>
                <c:pt idx="177">
                  <c:v>57.349599999999995</c:v>
                </c:pt>
                <c:pt idx="178">
                  <c:v>39.637999999999998</c:v>
                </c:pt>
                <c:pt idx="179">
                  <c:v>34.652999999999999</c:v>
                </c:pt>
                <c:pt idx="180">
                  <c:v>29.8231</c:v>
                </c:pt>
                <c:pt idx="181">
                  <c:v>27.652799999999999</c:v>
                </c:pt>
                <c:pt idx="182">
                  <c:v>61.895600000000002</c:v>
                </c:pt>
                <c:pt idx="183">
                  <c:v>18.646000000000001</c:v>
                </c:pt>
                <c:pt idx="184">
                  <c:v>38.023800000000001</c:v>
                </c:pt>
                <c:pt idx="185">
                  <c:v>35.438000000000002</c:v>
                </c:pt>
                <c:pt idx="186">
                  <c:v>31.860500000000002</c:v>
                </c:pt>
                <c:pt idx="187">
                  <c:v>33.7776</c:v>
                </c:pt>
                <c:pt idx="188">
                  <c:v>44.987899999999996</c:v>
                </c:pt>
                <c:pt idx="189">
                  <c:v>42.968499999999999</c:v>
                </c:pt>
                <c:pt idx="190">
                  <c:v>45.022100000000002</c:v>
                </c:pt>
                <c:pt idx="191">
                  <c:v>46.641800000000003</c:v>
                </c:pt>
                <c:pt idx="192">
                  <c:v>57.049900000000001</c:v>
                </c:pt>
                <c:pt idx="193">
                  <c:v>29.382899999999999</c:v>
                </c:pt>
                <c:pt idx="194">
                  <c:v>23.4862</c:v>
                </c:pt>
                <c:pt idx="195">
                  <c:v>23.450900000000001</c:v>
                </c:pt>
                <c:pt idx="196">
                  <c:v>56.288699999999999</c:v>
                </c:pt>
                <c:pt idx="197">
                  <c:v>23.403700000000001</c:v>
                </c:pt>
                <c:pt idx="198">
                  <c:v>39.7532</c:v>
                </c:pt>
                <c:pt idx="199">
                  <c:v>52.330799999999996</c:v>
                </c:pt>
                <c:pt idx="200">
                  <c:v>20.012799999999999</c:v>
                </c:pt>
                <c:pt idx="201">
                  <c:v>34.145899999999997</c:v>
                </c:pt>
                <c:pt idx="202">
                  <c:v>43.8962</c:v>
                </c:pt>
                <c:pt idx="203">
                  <c:v>32.081499999999998</c:v>
                </c:pt>
                <c:pt idx="204">
                  <c:v>40.699600000000004</c:v>
                </c:pt>
                <c:pt idx="205">
                  <c:v>20.0059</c:v>
                </c:pt>
                <c:pt idx="206">
                  <c:v>43.656199999999998</c:v>
                </c:pt>
                <c:pt idx="207">
                  <c:v>31.711600000000001</c:v>
                </c:pt>
                <c:pt idx="208">
                  <c:v>41.583199999999998</c:v>
                </c:pt>
                <c:pt idx="209">
                  <c:v>39.984000000000002</c:v>
                </c:pt>
                <c:pt idx="210">
                  <c:v>37.113199999999999</c:v>
                </c:pt>
                <c:pt idx="211">
                  <c:v>37.601300000000002</c:v>
                </c:pt>
                <c:pt idx="212">
                  <c:v>38.367699999999999</c:v>
                </c:pt>
                <c:pt idx="213">
                  <c:v>36.3658</c:v>
                </c:pt>
                <c:pt idx="214">
                  <c:v>26.433199999999999</c:v>
                </c:pt>
                <c:pt idx="215">
                  <c:v>41.291499999999999</c:v>
                </c:pt>
                <c:pt idx="216">
                  <c:v>17.4146</c:v>
                </c:pt>
                <c:pt idx="217">
                  <c:v>35.0991</c:v>
                </c:pt>
                <c:pt idx="218">
                  <c:v>19.637599999999999</c:v>
                </c:pt>
                <c:pt idx="219">
                  <c:v>38.5379</c:v>
                </c:pt>
                <c:pt idx="220">
                  <c:v>7.6700000000000017</c:v>
                </c:pt>
                <c:pt idx="221">
                  <c:v>26.924199999999999</c:v>
                </c:pt>
                <c:pt idx="222">
                  <c:v>47.931200000000004</c:v>
                </c:pt>
                <c:pt idx="223">
                  <c:v>27.722999999999999</c:v>
                </c:pt>
                <c:pt idx="224">
                  <c:v>36.379300000000001</c:v>
                </c:pt>
                <c:pt idx="225">
                  <c:v>47.880400000000002</c:v>
                </c:pt>
                <c:pt idx="226">
                  <c:v>33.678800000000003</c:v>
                </c:pt>
                <c:pt idx="227">
                  <c:v>20.572099999999999</c:v>
                </c:pt>
                <c:pt idx="228">
                  <c:v>45.486899999999999</c:v>
                </c:pt>
                <c:pt idx="229">
                  <c:v>30.6065</c:v>
                </c:pt>
                <c:pt idx="230">
                  <c:v>43.740200000000002</c:v>
                </c:pt>
                <c:pt idx="231">
                  <c:v>25.573399999999999</c:v>
                </c:pt>
                <c:pt idx="232">
                  <c:v>37.678600000000003</c:v>
                </c:pt>
                <c:pt idx="233">
                  <c:v>38.8855</c:v>
                </c:pt>
                <c:pt idx="234">
                  <c:v>34.299300000000002</c:v>
                </c:pt>
                <c:pt idx="235">
                  <c:v>20.618300000000001</c:v>
                </c:pt>
                <c:pt idx="236">
                  <c:v>37.784599999999998</c:v>
                </c:pt>
                <c:pt idx="237">
                  <c:v>15.621700000000001</c:v>
                </c:pt>
                <c:pt idx="238">
                  <c:v>44.298699999999997</c:v>
                </c:pt>
                <c:pt idx="239">
                  <c:v>30.260999999999999</c:v>
                </c:pt>
                <c:pt idx="240">
                  <c:v>38.878399999999999</c:v>
                </c:pt>
                <c:pt idx="241">
                  <c:v>41.192300000000003</c:v>
                </c:pt>
                <c:pt idx="242">
                  <c:v>41.826300000000003</c:v>
                </c:pt>
                <c:pt idx="243">
                  <c:v>47.705500000000001</c:v>
                </c:pt>
                <c:pt idx="244">
                  <c:v>48.0779</c:v>
                </c:pt>
                <c:pt idx="245">
                  <c:v>43.563400000000001</c:v>
                </c:pt>
                <c:pt idx="246">
                  <c:v>51.885800000000003</c:v>
                </c:pt>
                <c:pt idx="247">
                  <c:v>10.1221</c:v>
                </c:pt>
                <c:pt idx="248">
                  <c:v>52.0548</c:v>
                </c:pt>
                <c:pt idx="249">
                  <c:v>21.558299999999999</c:v>
                </c:pt>
                <c:pt idx="250">
                  <c:v>44.682900000000004</c:v>
                </c:pt>
                <c:pt idx="251">
                  <c:v>39.156300000000002</c:v>
                </c:pt>
                <c:pt idx="252">
                  <c:v>41.399799999999999</c:v>
                </c:pt>
                <c:pt idx="253">
                  <c:v>44.803800000000003</c:v>
                </c:pt>
                <c:pt idx="254">
                  <c:v>40.701599999999999</c:v>
                </c:pt>
                <c:pt idx="255">
                  <c:v>19.331700000000001</c:v>
                </c:pt>
                <c:pt idx="256">
                  <c:v>31.444800000000001</c:v>
                </c:pt>
                <c:pt idx="257">
                  <c:v>45.307400000000001</c:v>
                </c:pt>
                <c:pt idx="258">
                  <c:v>51.8992</c:v>
                </c:pt>
                <c:pt idx="259">
                  <c:v>30.3797</c:v>
                </c:pt>
                <c:pt idx="260">
                  <c:v>31.698900000000002</c:v>
                </c:pt>
                <c:pt idx="261">
                  <c:v>30.711199999999998</c:v>
                </c:pt>
                <c:pt idx="262">
                  <c:v>47.115099999999998</c:v>
                </c:pt>
                <c:pt idx="263">
                  <c:v>44.392600000000002</c:v>
                </c:pt>
                <c:pt idx="264">
                  <c:v>24.8278</c:v>
                </c:pt>
                <c:pt idx="265">
                  <c:v>52.807200000000002</c:v>
                </c:pt>
                <c:pt idx="266">
                  <c:v>43.543999999999997</c:v>
                </c:pt>
                <c:pt idx="267">
                  <c:v>30.677500000000002</c:v>
                </c:pt>
                <c:pt idx="268">
                  <c:v>23.5245</c:v>
                </c:pt>
                <c:pt idx="269">
                  <c:v>41.944899999999997</c:v>
                </c:pt>
                <c:pt idx="270">
                  <c:v>40.494500000000002</c:v>
                </c:pt>
                <c:pt idx="271">
                  <c:v>47.919200000000004</c:v>
                </c:pt>
                <c:pt idx="272">
                  <c:v>18.110399999999998</c:v>
                </c:pt>
                <c:pt idx="273">
                  <c:v>21.272200000000002</c:v>
                </c:pt>
                <c:pt idx="274">
                  <c:v>47.018799999999999</c:v>
                </c:pt>
                <c:pt idx="275">
                  <c:v>32.689599999999999</c:v>
                </c:pt>
                <c:pt idx="276">
                  <c:v>20.275600000000001</c:v>
                </c:pt>
                <c:pt idx="277">
                  <c:v>44.13</c:v>
                </c:pt>
                <c:pt idx="278">
                  <c:v>31.317299999999999</c:v>
                </c:pt>
                <c:pt idx="279">
                  <c:v>46.957499999999996</c:v>
                </c:pt>
                <c:pt idx="280">
                  <c:v>36.950600000000001</c:v>
                </c:pt>
                <c:pt idx="281">
                  <c:v>51.695399999999999</c:v>
                </c:pt>
                <c:pt idx="282">
                  <c:v>48.278999999999996</c:v>
                </c:pt>
                <c:pt idx="283">
                  <c:v>44.698799999999999</c:v>
                </c:pt>
                <c:pt idx="284">
                  <c:v>31.471299999999999</c:v>
                </c:pt>
                <c:pt idx="285">
                  <c:v>34.948900000000002</c:v>
                </c:pt>
                <c:pt idx="286">
                  <c:v>41.5214</c:v>
                </c:pt>
                <c:pt idx="287">
                  <c:v>47.941200000000002</c:v>
                </c:pt>
                <c:pt idx="288">
                  <c:v>62.090900000000005</c:v>
                </c:pt>
                <c:pt idx="289">
                  <c:v>27.483499999999999</c:v>
                </c:pt>
                <c:pt idx="290">
                  <c:v>37.643700000000003</c:v>
                </c:pt>
                <c:pt idx="291">
                  <c:v>24.2437</c:v>
                </c:pt>
              </c:numCache>
            </c:numRef>
          </c:xVal>
          <c:yVal>
            <c:numRef>
              <c:f>'292RIL'!$K$2:$K$295</c:f>
              <c:numCache>
                <c:formatCode>0.00</c:formatCode>
                <c:ptCount val="294"/>
                <c:pt idx="0">
                  <c:v>62.228763290178101</c:v>
                </c:pt>
                <c:pt idx="1">
                  <c:v>58.398647092707797</c:v>
                </c:pt>
                <c:pt idx="2">
                  <c:v>67.938251841318902</c:v>
                </c:pt>
                <c:pt idx="3">
                  <c:v>77.704187246374104</c:v>
                </c:pt>
                <c:pt idx="4">
                  <c:v>56.936607797670803</c:v>
                </c:pt>
                <c:pt idx="5">
                  <c:v>58.6647073822975</c:v>
                </c:pt>
                <c:pt idx="6">
                  <c:v>72.223810597963293</c:v>
                </c:pt>
                <c:pt idx="7">
                  <c:v>67.243567647199598</c:v>
                </c:pt>
                <c:pt idx="8">
                  <c:v>47.9022004663384</c:v>
                </c:pt>
                <c:pt idx="9">
                  <c:v>62.425342227148498</c:v>
                </c:pt>
                <c:pt idx="10">
                  <c:v>58.003269178974499</c:v>
                </c:pt>
                <c:pt idx="11">
                  <c:v>55.729957707818201</c:v>
                </c:pt>
                <c:pt idx="12">
                  <c:v>68.929132899682799</c:v>
                </c:pt>
                <c:pt idx="13">
                  <c:v>69.467349869445997</c:v>
                </c:pt>
                <c:pt idx="14">
                  <c:v>43.955886393952802</c:v>
                </c:pt>
                <c:pt idx="15">
                  <c:v>48.3969850559291</c:v>
                </c:pt>
                <c:pt idx="16">
                  <c:v>47.734581566811499</c:v>
                </c:pt>
                <c:pt idx="17">
                  <c:v>53.963149336327</c:v>
                </c:pt>
                <c:pt idx="18">
                  <c:v>60.474570657113397</c:v>
                </c:pt>
                <c:pt idx="19">
                  <c:v>52.714785172957697</c:v>
                </c:pt>
                <c:pt idx="20">
                  <c:v>50.551641525222799</c:v>
                </c:pt>
                <c:pt idx="21">
                  <c:v>44.936317781137397</c:v>
                </c:pt>
                <c:pt idx="22">
                  <c:v>67.180766436604998</c:v>
                </c:pt>
                <c:pt idx="23">
                  <c:v>43.189913444553198</c:v>
                </c:pt>
                <c:pt idx="24">
                  <c:v>60.411170331965799</c:v>
                </c:pt>
                <c:pt idx="25">
                  <c:v>14.947028411218801</c:v>
                </c:pt>
                <c:pt idx="26">
                  <c:v>61.254846791595099</c:v>
                </c:pt>
                <c:pt idx="27">
                  <c:v>60.001715008676399</c:v>
                </c:pt>
                <c:pt idx="28">
                  <c:v>55.673661293305898</c:v>
                </c:pt>
                <c:pt idx="29">
                  <c:v>42.747807207142202</c:v>
                </c:pt>
                <c:pt idx="30">
                  <c:v>59.312503195903602</c:v>
                </c:pt>
                <c:pt idx="31">
                  <c:v>47.9983750350425</c:v>
                </c:pt>
                <c:pt idx="32">
                  <c:v>77.322276540066696</c:v>
                </c:pt>
                <c:pt idx="33">
                  <c:v>62.775785928698298</c:v>
                </c:pt>
                <c:pt idx="34">
                  <c:v>50.822938767402597</c:v>
                </c:pt>
                <c:pt idx="35">
                  <c:v>42.887768697559103</c:v>
                </c:pt>
                <c:pt idx="36">
                  <c:v>69.030662323876797</c:v>
                </c:pt>
                <c:pt idx="37">
                  <c:v>55.334032984598799</c:v>
                </c:pt>
                <c:pt idx="38">
                  <c:v>49.673041508934098</c:v>
                </c:pt>
                <c:pt idx="39">
                  <c:v>65.713870125904194</c:v>
                </c:pt>
                <c:pt idx="40">
                  <c:v>67.514002975373003</c:v>
                </c:pt>
                <c:pt idx="41">
                  <c:v>63.167526608214402</c:v>
                </c:pt>
                <c:pt idx="42">
                  <c:v>50.186291154217301</c:v>
                </c:pt>
                <c:pt idx="43">
                  <c:v>34.023256329648902</c:v>
                </c:pt>
                <c:pt idx="44">
                  <c:v>66.426277180282995</c:v>
                </c:pt>
                <c:pt idx="45">
                  <c:v>37.049953932151901</c:v>
                </c:pt>
                <c:pt idx="46">
                  <c:v>23.130219489150502</c:v>
                </c:pt>
                <c:pt idx="47">
                  <c:v>62.599536814255003</c:v>
                </c:pt>
                <c:pt idx="48">
                  <c:v>63.951103420073203</c:v>
                </c:pt>
                <c:pt idx="49">
                  <c:v>45.035331177826997</c:v>
                </c:pt>
                <c:pt idx="50">
                  <c:v>59.989490169730601</c:v>
                </c:pt>
                <c:pt idx="51">
                  <c:v>44.920242687760599</c:v>
                </c:pt>
                <c:pt idx="52">
                  <c:v>73.190256658584403</c:v>
                </c:pt>
                <c:pt idx="53">
                  <c:v>69.259823719268496</c:v>
                </c:pt>
                <c:pt idx="54">
                  <c:v>70.106101221638397</c:v>
                </c:pt>
                <c:pt idx="55">
                  <c:v>53.128841810669499</c:v>
                </c:pt>
                <c:pt idx="56">
                  <c:v>57.182594448297699</c:v>
                </c:pt>
                <c:pt idx="57">
                  <c:v>45.185689781243902</c:v>
                </c:pt>
                <c:pt idx="58">
                  <c:v>48.567972620586097</c:v>
                </c:pt>
                <c:pt idx="59">
                  <c:v>33.939468697867902</c:v>
                </c:pt>
                <c:pt idx="60">
                  <c:v>72.375143850000796</c:v>
                </c:pt>
                <c:pt idx="61">
                  <c:v>65.615017756812307</c:v>
                </c:pt>
                <c:pt idx="62">
                  <c:v>67.267258905588804</c:v>
                </c:pt>
                <c:pt idx="63">
                  <c:v>33.415359570950301</c:v>
                </c:pt>
                <c:pt idx="64">
                  <c:v>54.817736838917902</c:v>
                </c:pt>
                <c:pt idx="65">
                  <c:v>54.9046756138464</c:v>
                </c:pt>
                <c:pt idx="66">
                  <c:v>63.3775490974256</c:v>
                </c:pt>
                <c:pt idx="67">
                  <c:v>57.305730991656603</c:v>
                </c:pt>
                <c:pt idx="68">
                  <c:v>43.762730952829003</c:v>
                </c:pt>
                <c:pt idx="69">
                  <c:v>47.346116856653602</c:v>
                </c:pt>
                <c:pt idx="70">
                  <c:v>26.117868609791302</c:v>
                </c:pt>
                <c:pt idx="71">
                  <c:v>31.070496911565801</c:v>
                </c:pt>
                <c:pt idx="72">
                  <c:v>55.4780246612479</c:v>
                </c:pt>
                <c:pt idx="73">
                  <c:v>43.838755589278101</c:v>
                </c:pt>
                <c:pt idx="74">
                  <c:v>68.231644802832903</c:v>
                </c:pt>
                <c:pt idx="75">
                  <c:v>69.388084225036195</c:v>
                </c:pt>
                <c:pt idx="76">
                  <c:v>68.083686893998504</c:v>
                </c:pt>
                <c:pt idx="77">
                  <c:v>57.362631083849102</c:v>
                </c:pt>
                <c:pt idx="78">
                  <c:v>69.581218258306194</c:v>
                </c:pt>
                <c:pt idx="79">
                  <c:v>38.525775575964502</c:v>
                </c:pt>
                <c:pt idx="80">
                  <c:v>49.919442690220897</c:v>
                </c:pt>
                <c:pt idx="81">
                  <c:v>89.761608279646296</c:v>
                </c:pt>
                <c:pt idx="82">
                  <c:v>51.340608176601698</c:v>
                </c:pt>
                <c:pt idx="83">
                  <c:v>62.142554170048399</c:v>
                </c:pt>
                <c:pt idx="84">
                  <c:v>49.124964017840199</c:v>
                </c:pt>
                <c:pt idx="85">
                  <c:v>45.430878908599098</c:v>
                </c:pt>
                <c:pt idx="86">
                  <c:v>47.049721019486</c:v>
                </c:pt>
                <c:pt idx="87">
                  <c:v>40.076064527809898</c:v>
                </c:pt>
                <c:pt idx="88">
                  <c:v>30.7061183580327</c:v>
                </c:pt>
                <c:pt idx="89">
                  <c:v>53.6896236086492</c:v>
                </c:pt>
                <c:pt idx="90">
                  <c:v>45.262596811130699</c:v>
                </c:pt>
                <c:pt idx="91">
                  <c:v>49.722699699847801</c:v>
                </c:pt>
                <c:pt idx="92">
                  <c:v>68.268541944572405</c:v>
                </c:pt>
                <c:pt idx="93">
                  <c:v>56.943895381656198</c:v>
                </c:pt>
                <c:pt idx="94">
                  <c:v>64.804536499389002</c:v>
                </c:pt>
                <c:pt idx="95">
                  <c:v>49.906490528587199</c:v>
                </c:pt>
                <c:pt idx="96">
                  <c:v>41.599505592842704</c:v>
                </c:pt>
                <c:pt idx="97">
                  <c:v>55.2793148864179</c:v>
                </c:pt>
                <c:pt idx="98">
                  <c:v>67.831219248816097</c:v>
                </c:pt>
                <c:pt idx="99">
                  <c:v>71.852658229553597</c:v>
                </c:pt>
                <c:pt idx="100">
                  <c:v>62.1780589325164</c:v>
                </c:pt>
                <c:pt idx="101">
                  <c:v>44.665967511131598</c:v>
                </c:pt>
                <c:pt idx="102">
                  <c:v>73.896059301193006</c:v>
                </c:pt>
                <c:pt idx="103">
                  <c:v>51.969808160613098</c:v>
                </c:pt>
                <c:pt idx="104">
                  <c:v>59.393827564406998</c:v>
                </c:pt>
                <c:pt idx="105">
                  <c:v>46.437239872607002</c:v>
                </c:pt>
                <c:pt idx="106">
                  <c:v>59.838093580451797</c:v>
                </c:pt>
                <c:pt idx="107">
                  <c:v>61.675437469304299</c:v>
                </c:pt>
                <c:pt idx="108">
                  <c:v>64.873179933953097</c:v>
                </c:pt>
                <c:pt idx="109">
                  <c:v>60.998117668349103</c:v>
                </c:pt>
                <c:pt idx="110">
                  <c:v>57.776651778437802</c:v>
                </c:pt>
                <c:pt idx="111">
                  <c:v>53.749096416363997</c:v>
                </c:pt>
                <c:pt idx="112">
                  <c:v>40.455178520760398</c:v>
                </c:pt>
                <c:pt idx="113">
                  <c:v>64.979086326752693</c:v>
                </c:pt>
                <c:pt idx="114">
                  <c:v>54.117925526048801</c:v>
                </c:pt>
                <c:pt idx="115">
                  <c:v>69.756545713984494</c:v>
                </c:pt>
                <c:pt idx="116">
                  <c:v>68.937362637230194</c:v>
                </c:pt>
                <c:pt idx="117">
                  <c:v>53.086813767324202</c:v>
                </c:pt>
                <c:pt idx="118">
                  <c:v>68.747217221871495</c:v>
                </c:pt>
                <c:pt idx="119">
                  <c:v>53.652322233267</c:v>
                </c:pt>
                <c:pt idx="120">
                  <c:v>65.406771279427005</c:v>
                </c:pt>
                <c:pt idx="121">
                  <c:v>45.3188378110587</c:v>
                </c:pt>
                <c:pt idx="122">
                  <c:v>51.962019015966298</c:v>
                </c:pt>
                <c:pt idx="123">
                  <c:v>70.548300095799306</c:v>
                </c:pt>
                <c:pt idx="124">
                  <c:v>66.433985291178004</c:v>
                </c:pt>
                <c:pt idx="125">
                  <c:v>52.698567142806802</c:v>
                </c:pt>
                <c:pt idx="126">
                  <c:v>74.992422026640895</c:v>
                </c:pt>
                <c:pt idx="127">
                  <c:v>74.9687675728199</c:v>
                </c:pt>
                <c:pt idx="128">
                  <c:v>71.390415778272697</c:v>
                </c:pt>
                <c:pt idx="129">
                  <c:v>57.8144598550194</c:v>
                </c:pt>
                <c:pt idx="130">
                  <c:v>60.8634070558237</c:v>
                </c:pt>
                <c:pt idx="131">
                  <c:v>67.151010397833105</c:v>
                </c:pt>
                <c:pt idx="132">
                  <c:v>47.760218798772101</c:v>
                </c:pt>
                <c:pt idx="133">
                  <c:v>54.723426478951602</c:v>
                </c:pt>
                <c:pt idx="134">
                  <c:v>53.324767312468303</c:v>
                </c:pt>
                <c:pt idx="135">
                  <c:v>68.716062737809693</c:v>
                </c:pt>
                <c:pt idx="136">
                  <c:v>60.690622176783499</c:v>
                </c:pt>
                <c:pt idx="137">
                  <c:v>73.2726824605584</c:v>
                </c:pt>
                <c:pt idx="138">
                  <c:v>48.907363720225497</c:v>
                </c:pt>
                <c:pt idx="139">
                  <c:v>56.5282803310741</c:v>
                </c:pt>
                <c:pt idx="140">
                  <c:v>60.494691742409699</c:v>
                </c:pt>
                <c:pt idx="141">
                  <c:v>52.182556029250598</c:v>
                </c:pt>
                <c:pt idx="142">
                  <c:v>54.684124062309102</c:v>
                </c:pt>
                <c:pt idx="143">
                  <c:v>67.619307090393207</c:v>
                </c:pt>
                <c:pt idx="144">
                  <c:v>81.526557176821697</c:v>
                </c:pt>
                <c:pt idx="145">
                  <c:v>68.515192646184104</c:v>
                </c:pt>
                <c:pt idx="146">
                  <c:v>58.534088171506497</c:v>
                </c:pt>
                <c:pt idx="147">
                  <c:v>71.400439720775196</c:v>
                </c:pt>
                <c:pt idx="148">
                  <c:v>75.839446066971306</c:v>
                </c:pt>
                <c:pt idx="149">
                  <c:v>53.143145413158202</c:v>
                </c:pt>
                <c:pt idx="150">
                  <c:v>77.876863084471594</c:v>
                </c:pt>
                <c:pt idx="151">
                  <c:v>47.682791215634801</c:v>
                </c:pt>
                <c:pt idx="152">
                  <c:v>76.746646656122493</c:v>
                </c:pt>
                <c:pt idx="153">
                  <c:v>39.852888155989397</c:v>
                </c:pt>
                <c:pt idx="154">
                  <c:v>53.453998817307202</c:v>
                </c:pt>
                <c:pt idx="155">
                  <c:v>57.708977902140496</c:v>
                </c:pt>
                <c:pt idx="156">
                  <c:v>46.9863920382953</c:v>
                </c:pt>
                <c:pt idx="157">
                  <c:v>55.051136690148702</c:v>
                </c:pt>
                <c:pt idx="158">
                  <c:v>76.917340308128104</c:v>
                </c:pt>
                <c:pt idx="159">
                  <c:v>54.586982260412398</c:v>
                </c:pt>
                <c:pt idx="160">
                  <c:v>72.523284204896996</c:v>
                </c:pt>
                <c:pt idx="161">
                  <c:v>55.345648018814998</c:v>
                </c:pt>
                <c:pt idx="162">
                  <c:v>68.170838633156194</c:v>
                </c:pt>
                <c:pt idx="163">
                  <c:v>78.481274906535901</c:v>
                </c:pt>
                <c:pt idx="164">
                  <c:v>65.587733497379702</c:v>
                </c:pt>
                <c:pt idx="165">
                  <c:v>66.265035589739995</c:v>
                </c:pt>
                <c:pt idx="166">
                  <c:v>50.801745052524197</c:v>
                </c:pt>
                <c:pt idx="167">
                  <c:v>42.737939090985897</c:v>
                </c:pt>
                <c:pt idx="168">
                  <c:v>76.994456563937703</c:v>
                </c:pt>
                <c:pt idx="169">
                  <c:v>67.865986734055994</c:v>
                </c:pt>
                <c:pt idx="170">
                  <c:v>61.558470737030298</c:v>
                </c:pt>
                <c:pt idx="171">
                  <c:v>49.603164956258297</c:v>
                </c:pt>
                <c:pt idx="172">
                  <c:v>55.945418222928602</c:v>
                </c:pt>
                <c:pt idx="173">
                  <c:v>53.7932613890356</c:v>
                </c:pt>
                <c:pt idx="174">
                  <c:v>62.649828718977702</c:v>
                </c:pt>
                <c:pt idx="175">
                  <c:v>57.636055591277703</c:v>
                </c:pt>
                <c:pt idx="176">
                  <c:v>52.636521659307903</c:v>
                </c:pt>
                <c:pt idx="177">
                  <c:v>74.939789527598506</c:v>
                </c:pt>
                <c:pt idx="178">
                  <c:v>61.9327308905781</c:v>
                </c:pt>
                <c:pt idx="179">
                  <c:v>73.705330053414301</c:v>
                </c:pt>
                <c:pt idx="180">
                  <c:v>53.455930775373602</c:v>
                </c:pt>
                <c:pt idx="181">
                  <c:v>55.319810916211601</c:v>
                </c:pt>
                <c:pt idx="182">
                  <c:v>66.918111511030503</c:v>
                </c:pt>
                <c:pt idx="183">
                  <c:v>34.500168144843798</c:v>
                </c:pt>
                <c:pt idx="184">
                  <c:v>59.8671515487977</c:v>
                </c:pt>
                <c:pt idx="185">
                  <c:v>60.272865517870599</c:v>
                </c:pt>
                <c:pt idx="186">
                  <c:v>58.519176591984497</c:v>
                </c:pt>
                <c:pt idx="187">
                  <c:v>68.522972826877904</c:v>
                </c:pt>
                <c:pt idx="188">
                  <c:v>64.822843823809706</c:v>
                </c:pt>
                <c:pt idx="189">
                  <c:v>54.522125727556102</c:v>
                </c:pt>
                <c:pt idx="190">
                  <c:v>52.424747538961</c:v>
                </c:pt>
                <c:pt idx="191">
                  <c:v>52.471069252183</c:v>
                </c:pt>
                <c:pt idx="192">
                  <c:v>63.076170525134003</c:v>
                </c:pt>
                <c:pt idx="193">
                  <c:v>51.943395406610598</c:v>
                </c:pt>
                <c:pt idx="194">
                  <c:v>49.5141927031774</c:v>
                </c:pt>
                <c:pt idx="195">
                  <c:v>50.661701913418703</c:v>
                </c:pt>
                <c:pt idx="196">
                  <c:v>73.346381089243394</c:v>
                </c:pt>
                <c:pt idx="197">
                  <c:v>68.126170211203103</c:v>
                </c:pt>
                <c:pt idx="198">
                  <c:v>48.661076108408203</c:v>
                </c:pt>
                <c:pt idx="199">
                  <c:v>77.443033621398598</c:v>
                </c:pt>
                <c:pt idx="200">
                  <c:v>39.594267115784298</c:v>
                </c:pt>
                <c:pt idx="201">
                  <c:v>55.441086830721098</c:v>
                </c:pt>
                <c:pt idx="202">
                  <c:v>66.357265447804295</c:v>
                </c:pt>
                <c:pt idx="203">
                  <c:v>48.799422674181201</c:v>
                </c:pt>
                <c:pt idx="204">
                  <c:v>57.315104505564399</c:v>
                </c:pt>
                <c:pt idx="205">
                  <c:v>39.572211267588997</c:v>
                </c:pt>
                <c:pt idx="206">
                  <c:v>64.57069229679</c:v>
                </c:pt>
                <c:pt idx="207">
                  <c:v>44.3883794588074</c:v>
                </c:pt>
                <c:pt idx="208">
                  <c:v>55.7383861014887</c:v>
                </c:pt>
                <c:pt idx="209">
                  <c:v>55.409576347470797</c:v>
                </c:pt>
                <c:pt idx="210">
                  <c:v>59.578954766288497</c:v>
                </c:pt>
                <c:pt idx="211">
                  <c:v>49.5773399118832</c:v>
                </c:pt>
                <c:pt idx="212">
                  <c:v>52.4861316331965</c:v>
                </c:pt>
                <c:pt idx="213">
                  <c:v>42.7484113559183</c:v>
                </c:pt>
                <c:pt idx="214">
                  <c:v>57.747543127763599</c:v>
                </c:pt>
                <c:pt idx="215">
                  <c:v>71.176194423315494</c:v>
                </c:pt>
                <c:pt idx="216">
                  <c:v>30.479741215353101</c:v>
                </c:pt>
                <c:pt idx="217">
                  <c:v>44.804707868781101</c:v>
                </c:pt>
                <c:pt idx="218">
                  <c:v>50.571895257805103</c:v>
                </c:pt>
                <c:pt idx="219">
                  <c:v>59.285973094934299</c:v>
                </c:pt>
                <c:pt idx="220">
                  <c:v>34.4449869989771</c:v>
                </c:pt>
                <c:pt idx="221">
                  <c:v>53.147252028784997</c:v>
                </c:pt>
                <c:pt idx="222">
                  <c:v>61.872547565668597</c:v>
                </c:pt>
                <c:pt idx="223">
                  <c:v>38.349082435517801</c:v>
                </c:pt>
                <c:pt idx="224">
                  <c:v>57.994836855047197</c:v>
                </c:pt>
                <c:pt idx="225">
                  <c:v>77.542772529837293</c:v>
                </c:pt>
                <c:pt idx="226">
                  <c:v>48.5024956142043</c:v>
                </c:pt>
                <c:pt idx="227">
                  <c:v>36.675650741849701</c:v>
                </c:pt>
                <c:pt idx="228">
                  <c:v>68.841882979556701</c:v>
                </c:pt>
                <c:pt idx="229">
                  <c:v>53.469246146117101</c:v>
                </c:pt>
                <c:pt idx="230">
                  <c:v>77.146725226679294</c:v>
                </c:pt>
                <c:pt idx="231">
                  <c:v>49.714573677847703</c:v>
                </c:pt>
                <c:pt idx="232">
                  <c:v>72.1452047833872</c:v>
                </c:pt>
                <c:pt idx="233">
                  <c:v>61.224105229271203</c:v>
                </c:pt>
                <c:pt idx="234">
                  <c:v>54.831143955502</c:v>
                </c:pt>
                <c:pt idx="235">
                  <c:v>58.123288810507901</c:v>
                </c:pt>
                <c:pt idx="236">
                  <c:v>65.820666996051798</c:v>
                </c:pt>
                <c:pt idx="237">
                  <c:v>27.862315334933701</c:v>
                </c:pt>
                <c:pt idx="238">
                  <c:v>50.547663718224797</c:v>
                </c:pt>
                <c:pt idx="239">
                  <c:v>53.347964102649797</c:v>
                </c:pt>
                <c:pt idx="240">
                  <c:v>55.738785724877097</c:v>
                </c:pt>
                <c:pt idx="241">
                  <c:v>53.761862205532097</c:v>
                </c:pt>
                <c:pt idx="242">
                  <c:v>51.165547311828398</c:v>
                </c:pt>
                <c:pt idx="243">
                  <c:v>76.583561700425193</c:v>
                </c:pt>
                <c:pt idx="244">
                  <c:v>62.539253290501101</c:v>
                </c:pt>
                <c:pt idx="245">
                  <c:v>70.309604939792905</c:v>
                </c:pt>
                <c:pt idx="246">
                  <c:v>72.008993369485907</c:v>
                </c:pt>
                <c:pt idx="247">
                  <c:v>29.874157925509301</c:v>
                </c:pt>
                <c:pt idx="248">
                  <c:v>60.495269391364801</c:v>
                </c:pt>
                <c:pt idx="249">
                  <c:v>60.543312396194999</c:v>
                </c:pt>
                <c:pt idx="250">
                  <c:v>62.362950559233902</c:v>
                </c:pt>
                <c:pt idx="251">
                  <c:v>67.532916617211797</c:v>
                </c:pt>
                <c:pt idx="252">
                  <c:v>53.786248051335001</c:v>
                </c:pt>
                <c:pt idx="253">
                  <c:v>58.5799537320067</c:v>
                </c:pt>
                <c:pt idx="254">
                  <c:v>69.264165765486098</c:v>
                </c:pt>
                <c:pt idx="255">
                  <c:v>27.713639524670601</c:v>
                </c:pt>
                <c:pt idx="256">
                  <c:v>53.027540574231402</c:v>
                </c:pt>
                <c:pt idx="257">
                  <c:v>83.361283792046606</c:v>
                </c:pt>
                <c:pt idx="258">
                  <c:v>77.931575273137895</c:v>
                </c:pt>
                <c:pt idx="259">
                  <c:v>48.180574824539903</c:v>
                </c:pt>
                <c:pt idx="260">
                  <c:v>51.215350383177402</c:v>
                </c:pt>
                <c:pt idx="261">
                  <c:v>44.552763670319301</c:v>
                </c:pt>
                <c:pt idx="262">
                  <c:v>61.1035534093742</c:v>
                </c:pt>
                <c:pt idx="263">
                  <c:v>49.198506324979697</c:v>
                </c:pt>
                <c:pt idx="264">
                  <c:v>36.801757472518297</c:v>
                </c:pt>
                <c:pt idx="265">
                  <c:v>71.016905651463802</c:v>
                </c:pt>
                <c:pt idx="266">
                  <c:v>47.6072970072114</c:v>
                </c:pt>
                <c:pt idx="267">
                  <c:v>55.4324021030192</c:v>
                </c:pt>
                <c:pt idx="268">
                  <c:v>48.766033523268902</c:v>
                </c:pt>
                <c:pt idx="269">
                  <c:v>49.140031317307802</c:v>
                </c:pt>
                <c:pt idx="270">
                  <c:v>66.858853322077593</c:v>
                </c:pt>
                <c:pt idx="271">
                  <c:v>60.467448171316903</c:v>
                </c:pt>
                <c:pt idx="272">
                  <c:v>39.241608323173502</c:v>
                </c:pt>
                <c:pt idx="273">
                  <c:v>41.818266881949498</c:v>
                </c:pt>
                <c:pt idx="274">
                  <c:v>58.091084461038399</c:v>
                </c:pt>
                <c:pt idx="275">
                  <c:v>62.854990909693399</c:v>
                </c:pt>
                <c:pt idx="276">
                  <c:v>39.847641213764199</c:v>
                </c:pt>
                <c:pt idx="277">
                  <c:v>63.513116823478398</c:v>
                </c:pt>
                <c:pt idx="278">
                  <c:v>35.207650996949397</c:v>
                </c:pt>
                <c:pt idx="279">
                  <c:v>52.631130256452003</c:v>
                </c:pt>
                <c:pt idx="280">
                  <c:v>76.321613906962199</c:v>
                </c:pt>
                <c:pt idx="281">
                  <c:v>65.082131950152899</c:v>
                </c:pt>
                <c:pt idx="282">
                  <c:v>68.501584184559505</c:v>
                </c:pt>
                <c:pt idx="283">
                  <c:v>61.216488254482499</c:v>
                </c:pt>
                <c:pt idx="284">
                  <c:v>56.987558978432901</c:v>
                </c:pt>
                <c:pt idx="285">
                  <c:v>52.278126909927103</c:v>
                </c:pt>
                <c:pt idx="286">
                  <c:v>53.778379130412603</c:v>
                </c:pt>
                <c:pt idx="287">
                  <c:v>67.783022260063902</c:v>
                </c:pt>
                <c:pt idx="288">
                  <c:v>63.898588497955402</c:v>
                </c:pt>
                <c:pt idx="289">
                  <c:v>59.685049188367898</c:v>
                </c:pt>
                <c:pt idx="290">
                  <c:v>65.661661952138004</c:v>
                </c:pt>
                <c:pt idx="291">
                  <c:v>48.958639774978302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51BE-4E59-A7E6-311C935881D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987833599"/>
        <c:axId val="1987522735"/>
      </c:scatterChart>
      <c:valAx>
        <c:axId val="1987833599"/>
        <c:scaling>
          <c:orientation val="minMax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.00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987522735"/>
        <c:crosses val="autoZero"/>
        <c:crossBetween val="midCat"/>
      </c:valAx>
      <c:valAx>
        <c:axId val="1987522735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.00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987833599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6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5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6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6" indent="0" algn="ctr">
              <a:buNone/>
              <a:defRPr sz="2000"/>
            </a:lvl2pPr>
            <a:lvl3pPr marL="914411" indent="0" algn="ctr">
              <a:buNone/>
              <a:defRPr sz="1801"/>
            </a:lvl3pPr>
            <a:lvl4pPr marL="1371617" indent="0" algn="ctr">
              <a:buNone/>
              <a:defRPr sz="1600"/>
            </a:lvl4pPr>
            <a:lvl5pPr marL="1828823" indent="0" algn="ctr">
              <a:buNone/>
              <a:defRPr sz="1600"/>
            </a:lvl5pPr>
            <a:lvl6pPr marL="2286029" indent="0" algn="ctr">
              <a:buNone/>
              <a:defRPr sz="1600"/>
            </a:lvl6pPr>
            <a:lvl7pPr marL="2743234" indent="0" algn="ctr">
              <a:buNone/>
              <a:defRPr sz="1600"/>
            </a:lvl7pPr>
            <a:lvl8pPr marL="3200440" indent="0" algn="ctr">
              <a:buNone/>
              <a:defRPr sz="1600"/>
            </a:lvl8pPr>
            <a:lvl9pPr marL="3657646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5C7E28-1FD0-469D-AA77-6C519717E558}" type="datetimeFigureOut">
              <a:rPr lang="en-US" smtClean="0"/>
              <a:t>9/12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7B4516-034E-4A33-A551-A4DD3C6DAE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2527067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5C7E28-1FD0-469D-AA77-6C519717E558}" type="datetimeFigureOut">
              <a:rPr lang="en-US" smtClean="0"/>
              <a:t>9/12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7B4516-034E-4A33-A551-A4DD3C6DAE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5301725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899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199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5C7E28-1FD0-469D-AA77-6C519717E558}" type="datetimeFigureOut">
              <a:rPr lang="en-US" smtClean="0"/>
              <a:t>9/12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7B4516-034E-4A33-A551-A4DD3C6DAE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8619691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5C7E28-1FD0-469D-AA77-6C519717E558}" type="datetimeFigureOut">
              <a:rPr lang="en-US" smtClean="0"/>
              <a:t>9/12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7B4516-034E-4A33-A551-A4DD3C6DAE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9845940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2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2" y="4589464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6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11" indent="0">
              <a:buNone/>
              <a:defRPr sz="1801">
                <a:solidFill>
                  <a:schemeClr val="tx1">
                    <a:tint val="75000"/>
                  </a:schemeClr>
                </a:solidFill>
              </a:defRPr>
            </a:lvl3pPr>
            <a:lvl4pPr marL="1371617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23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29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34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4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46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5C7E28-1FD0-469D-AA77-6C519717E558}" type="datetimeFigureOut">
              <a:rPr lang="en-US" smtClean="0"/>
              <a:t>9/12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7B4516-034E-4A33-A551-A4DD3C6DAE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8987154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1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1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5C7E28-1FD0-469D-AA77-6C519717E558}" type="datetimeFigureOut">
              <a:rPr lang="en-US" smtClean="0"/>
              <a:t>9/12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7B4516-034E-4A33-A551-A4DD3C6DAE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7915216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9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9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6" indent="0">
              <a:buNone/>
              <a:defRPr sz="2000" b="1"/>
            </a:lvl2pPr>
            <a:lvl3pPr marL="914411" indent="0">
              <a:buNone/>
              <a:defRPr sz="1801" b="1"/>
            </a:lvl3pPr>
            <a:lvl4pPr marL="1371617" indent="0">
              <a:buNone/>
              <a:defRPr sz="1600" b="1"/>
            </a:lvl4pPr>
            <a:lvl5pPr marL="1828823" indent="0">
              <a:buNone/>
              <a:defRPr sz="1600" b="1"/>
            </a:lvl5pPr>
            <a:lvl6pPr marL="2286029" indent="0">
              <a:buNone/>
              <a:defRPr sz="1600" b="1"/>
            </a:lvl6pPr>
            <a:lvl7pPr marL="2743234" indent="0">
              <a:buNone/>
              <a:defRPr sz="1600" b="1"/>
            </a:lvl7pPr>
            <a:lvl8pPr marL="3200440" indent="0">
              <a:buNone/>
              <a:defRPr sz="1600" b="1"/>
            </a:lvl8pPr>
            <a:lvl9pPr marL="3657646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9" y="2505076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2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6" indent="0">
              <a:buNone/>
              <a:defRPr sz="2000" b="1"/>
            </a:lvl2pPr>
            <a:lvl3pPr marL="914411" indent="0">
              <a:buNone/>
              <a:defRPr sz="1801" b="1"/>
            </a:lvl3pPr>
            <a:lvl4pPr marL="1371617" indent="0">
              <a:buNone/>
              <a:defRPr sz="1600" b="1"/>
            </a:lvl4pPr>
            <a:lvl5pPr marL="1828823" indent="0">
              <a:buNone/>
              <a:defRPr sz="1600" b="1"/>
            </a:lvl5pPr>
            <a:lvl6pPr marL="2286029" indent="0">
              <a:buNone/>
              <a:defRPr sz="1600" b="1"/>
            </a:lvl6pPr>
            <a:lvl7pPr marL="2743234" indent="0">
              <a:buNone/>
              <a:defRPr sz="1600" b="1"/>
            </a:lvl7pPr>
            <a:lvl8pPr marL="3200440" indent="0">
              <a:buNone/>
              <a:defRPr sz="1600" b="1"/>
            </a:lvl8pPr>
            <a:lvl9pPr marL="3657646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2" y="2505076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5C7E28-1FD0-469D-AA77-6C519717E558}" type="datetimeFigureOut">
              <a:rPr lang="en-US" smtClean="0"/>
              <a:t>9/12/20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7B4516-034E-4A33-A551-A4DD3C6DAE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2403648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5C7E28-1FD0-469D-AA77-6C519717E558}" type="datetimeFigureOut">
              <a:rPr lang="en-US" smtClean="0"/>
              <a:t>9/12/20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7B4516-034E-4A33-A551-A4DD3C6DAE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8666579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5C7E28-1FD0-469D-AA77-6C519717E558}" type="datetimeFigureOut">
              <a:rPr lang="en-US" smtClean="0"/>
              <a:t>9/12/20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7B4516-034E-4A33-A551-A4DD3C6DAE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6131071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90" y="457200"/>
            <a:ext cx="3932236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1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90" y="2057400"/>
            <a:ext cx="3932236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6" indent="0">
              <a:buNone/>
              <a:defRPr sz="1401"/>
            </a:lvl2pPr>
            <a:lvl3pPr marL="914411" indent="0">
              <a:buNone/>
              <a:defRPr sz="1200"/>
            </a:lvl3pPr>
            <a:lvl4pPr marL="1371617" indent="0">
              <a:buNone/>
              <a:defRPr sz="1001"/>
            </a:lvl4pPr>
            <a:lvl5pPr marL="1828823" indent="0">
              <a:buNone/>
              <a:defRPr sz="1001"/>
            </a:lvl5pPr>
            <a:lvl6pPr marL="2286029" indent="0">
              <a:buNone/>
              <a:defRPr sz="1001"/>
            </a:lvl6pPr>
            <a:lvl7pPr marL="2743234" indent="0">
              <a:buNone/>
              <a:defRPr sz="1001"/>
            </a:lvl7pPr>
            <a:lvl8pPr marL="3200440" indent="0">
              <a:buNone/>
              <a:defRPr sz="1001"/>
            </a:lvl8pPr>
            <a:lvl9pPr marL="3657646" indent="0">
              <a:buNone/>
              <a:defRPr sz="100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5C7E28-1FD0-469D-AA77-6C519717E558}" type="datetimeFigureOut">
              <a:rPr lang="en-US" smtClean="0"/>
              <a:t>9/12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7B4516-034E-4A33-A551-A4DD3C6DAE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2563250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90" y="457200"/>
            <a:ext cx="3932236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1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6" indent="0">
              <a:buNone/>
              <a:defRPr sz="2800"/>
            </a:lvl2pPr>
            <a:lvl3pPr marL="914411" indent="0">
              <a:buNone/>
              <a:defRPr sz="2400"/>
            </a:lvl3pPr>
            <a:lvl4pPr marL="1371617" indent="0">
              <a:buNone/>
              <a:defRPr sz="2000"/>
            </a:lvl4pPr>
            <a:lvl5pPr marL="1828823" indent="0">
              <a:buNone/>
              <a:defRPr sz="2000"/>
            </a:lvl5pPr>
            <a:lvl6pPr marL="2286029" indent="0">
              <a:buNone/>
              <a:defRPr sz="2000"/>
            </a:lvl6pPr>
            <a:lvl7pPr marL="2743234" indent="0">
              <a:buNone/>
              <a:defRPr sz="2000"/>
            </a:lvl7pPr>
            <a:lvl8pPr marL="3200440" indent="0">
              <a:buNone/>
              <a:defRPr sz="2000"/>
            </a:lvl8pPr>
            <a:lvl9pPr marL="3657646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90" y="2057400"/>
            <a:ext cx="3932236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6" indent="0">
              <a:buNone/>
              <a:defRPr sz="1401"/>
            </a:lvl2pPr>
            <a:lvl3pPr marL="914411" indent="0">
              <a:buNone/>
              <a:defRPr sz="1200"/>
            </a:lvl3pPr>
            <a:lvl4pPr marL="1371617" indent="0">
              <a:buNone/>
              <a:defRPr sz="1001"/>
            </a:lvl4pPr>
            <a:lvl5pPr marL="1828823" indent="0">
              <a:buNone/>
              <a:defRPr sz="1001"/>
            </a:lvl5pPr>
            <a:lvl6pPr marL="2286029" indent="0">
              <a:buNone/>
              <a:defRPr sz="1001"/>
            </a:lvl6pPr>
            <a:lvl7pPr marL="2743234" indent="0">
              <a:buNone/>
              <a:defRPr sz="1001"/>
            </a:lvl7pPr>
            <a:lvl8pPr marL="3200440" indent="0">
              <a:buNone/>
              <a:defRPr sz="1001"/>
            </a:lvl8pPr>
            <a:lvl9pPr marL="3657646" indent="0">
              <a:buNone/>
              <a:defRPr sz="100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5C7E28-1FD0-469D-AA77-6C519717E558}" type="datetimeFigureOut">
              <a:rPr lang="en-US" smtClean="0"/>
              <a:t>9/12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7B4516-034E-4A33-A551-A4DD3C6DAE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8438958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2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2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1" y="6356351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35C7E28-1FD0-469D-AA77-6C519717E558}" type="datetimeFigureOut">
              <a:rPr lang="en-US" smtClean="0"/>
              <a:t>9/12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2" y="6356351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1" y="6356351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67B4516-034E-4A33-A551-A4DD3C6DAE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003161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11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4" indent="-228604" algn="l" defTabSz="914411" rtl="0" eaLnBrk="1" latinLnBrk="0" hangingPunct="1">
        <a:lnSpc>
          <a:spcPct val="90000"/>
        </a:lnSpc>
        <a:spcBef>
          <a:spcPts val="1001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9" indent="-228604" algn="l" defTabSz="914411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15" indent="-228604" algn="l" defTabSz="914411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21" indent="-228604" algn="l" defTabSz="914411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1" kern="1200">
          <a:solidFill>
            <a:schemeClr val="tx1"/>
          </a:solidFill>
          <a:latin typeface="+mn-lt"/>
          <a:ea typeface="+mn-ea"/>
          <a:cs typeface="+mn-cs"/>
        </a:defRPr>
      </a:lvl4pPr>
      <a:lvl5pPr marL="2057427" indent="-228604" algn="l" defTabSz="914411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1" kern="1200">
          <a:solidFill>
            <a:schemeClr val="tx1"/>
          </a:solidFill>
          <a:latin typeface="+mn-lt"/>
          <a:ea typeface="+mn-ea"/>
          <a:cs typeface="+mn-cs"/>
        </a:defRPr>
      </a:lvl5pPr>
      <a:lvl6pPr marL="2514632" indent="-228604" algn="l" defTabSz="914411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1" kern="1200">
          <a:solidFill>
            <a:schemeClr val="tx1"/>
          </a:solidFill>
          <a:latin typeface="+mn-lt"/>
          <a:ea typeface="+mn-ea"/>
          <a:cs typeface="+mn-cs"/>
        </a:defRPr>
      </a:lvl6pPr>
      <a:lvl7pPr marL="2971838" indent="-228604" algn="l" defTabSz="914411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1" kern="1200">
          <a:solidFill>
            <a:schemeClr val="tx1"/>
          </a:solidFill>
          <a:latin typeface="+mn-lt"/>
          <a:ea typeface="+mn-ea"/>
          <a:cs typeface="+mn-cs"/>
        </a:defRPr>
      </a:lvl7pPr>
      <a:lvl8pPr marL="3429044" indent="-228604" algn="l" defTabSz="914411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1" kern="1200">
          <a:solidFill>
            <a:schemeClr val="tx1"/>
          </a:solidFill>
          <a:latin typeface="+mn-lt"/>
          <a:ea typeface="+mn-ea"/>
          <a:cs typeface="+mn-cs"/>
        </a:defRPr>
      </a:lvl8pPr>
      <a:lvl9pPr marL="3886249" indent="-228604" algn="l" defTabSz="914411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1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11" rtl="0" eaLnBrk="1" latinLnBrk="0" hangingPunct="1">
        <a:defRPr sz="1801" kern="1200">
          <a:solidFill>
            <a:schemeClr val="tx1"/>
          </a:solidFill>
          <a:latin typeface="+mn-lt"/>
          <a:ea typeface="+mn-ea"/>
          <a:cs typeface="+mn-cs"/>
        </a:defRPr>
      </a:lvl1pPr>
      <a:lvl2pPr marL="457206" algn="l" defTabSz="914411" rtl="0" eaLnBrk="1" latinLnBrk="0" hangingPunct="1">
        <a:defRPr sz="1801" kern="1200">
          <a:solidFill>
            <a:schemeClr val="tx1"/>
          </a:solidFill>
          <a:latin typeface="+mn-lt"/>
          <a:ea typeface="+mn-ea"/>
          <a:cs typeface="+mn-cs"/>
        </a:defRPr>
      </a:lvl2pPr>
      <a:lvl3pPr marL="914411" algn="l" defTabSz="914411" rtl="0" eaLnBrk="1" latinLnBrk="0" hangingPunct="1">
        <a:defRPr sz="1801" kern="1200">
          <a:solidFill>
            <a:schemeClr val="tx1"/>
          </a:solidFill>
          <a:latin typeface="+mn-lt"/>
          <a:ea typeface="+mn-ea"/>
          <a:cs typeface="+mn-cs"/>
        </a:defRPr>
      </a:lvl3pPr>
      <a:lvl4pPr marL="1371617" algn="l" defTabSz="914411" rtl="0" eaLnBrk="1" latinLnBrk="0" hangingPunct="1">
        <a:defRPr sz="1801" kern="1200">
          <a:solidFill>
            <a:schemeClr val="tx1"/>
          </a:solidFill>
          <a:latin typeface="+mn-lt"/>
          <a:ea typeface="+mn-ea"/>
          <a:cs typeface="+mn-cs"/>
        </a:defRPr>
      </a:lvl4pPr>
      <a:lvl5pPr marL="1828823" algn="l" defTabSz="914411" rtl="0" eaLnBrk="1" latinLnBrk="0" hangingPunct="1">
        <a:defRPr sz="1801" kern="1200">
          <a:solidFill>
            <a:schemeClr val="tx1"/>
          </a:solidFill>
          <a:latin typeface="+mn-lt"/>
          <a:ea typeface="+mn-ea"/>
          <a:cs typeface="+mn-cs"/>
        </a:defRPr>
      </a:lvl5pPr>
      <a:lvl6pPr marL="2286029" algn="l" defTabSz="914411" rtl="0" eaLnBrk="1" latinLnBrk="0" hangingPunct="1">
        <a:defRPr sz="1801" kern="1200">
          <a:solidFill>
            <a:schemeClr val="tx1"/>
          </a:solidFill>
          <a:latin typeface="+mn-lt"/>
          <a:ea typeface="+mn-ea"/>
          <a:cs typeface="+mn-cs"/>
        </a:defRPr>
      </a:lvl6pPr>
      <a:lvl7pPr marL="2743234" algn="l" defTabSz="914411" rtl="0" eaLnBrk="1" latinLnBrk="0" hangingPunct="1">
        <a:defRPr sz="1801" kern="1200">
          <a:solidFill>
            <a:schemeClr val="tx1"/>
          </a:solidFill>
          <a:latin typeface="+mn-lt"/>
          <a:ea typeface="+mn-ea"/>
          <a:cs typeface="+mn-cs"/>
        </a:defRPr>
      </a:lvl7pPr>
      <a:lvl8pPr marL="3200440" algn="l" defTabSz="914411" rtl="0" eaLnBrk="1" latinLnBrk="0" hangingPunct="1">
        <a:defRPr sz="1801" kern="1200">
          <a:solidFill>
            <a:schemeClr val="tx1"/>
          </a:solidFill>
          <a:latin typeface="+mn-lt"/>
          <a:ea typeface="+mn-ea"/>
          <a:cs typeface="+mn-cs"/>
        </a:defRPr>
      </a:lvl8pPr>
      <a:lvl9pPr marL="3657646" algn="l" defTabSz="914411" rtl="0" eaLnBrk="1" latinLnBrk="0" hangingPunct="1">
        <a:defRPr sz="1801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Relationship Id="rId5" Type="http://schemas.openxmlformats.org/officeDocument/2006/relationships/chart" Target="../charts/chart4.xml"/><Relationship Id="rId4" Type="http://schemas.openxmlformats.org/officeDocument/2006/relationships/chart" Target="../charts/chart3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chart" Target="../charts/chart6.xml"/><Relationship Id="rId2" Type="http://schemas.openxmlformats.org/officeDocument/2006/relationships/chart" Target="../charts/chart5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8" name="Chart 7">
            <a:extLst>
              <a:ext uri="{FF2B5EF4-FFF2-40B4-BE49-F238E27FC236}">
                <a16:creationId xmlns:a16="http://schemas.microsoft.com/office/drawing/2014/main" id="{5496260C-9BCC-4823-9DFC-10DEDB43960B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105338850"/>
              </p:ext>
            </p:extLst>
          </p:nvPr>
        </p:nvGraphicFramePr>
        <p:xfrm>
          <a:off x="192159" y="591005"/>
          <a:ext cx="5426764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9" name="Chart 8">
            <a:extLst>
              <a:ext uri="{FF2B5EF4-FFF2-40B4-BE49-F238E27FC236}">
                <a16:creationId xmlns:a16="http://schemas.microsoft.com/office/drawing/2014/main" id="{5496260C-9BCC-4823-9DFC-10DEDB43960B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059496333"/>
              </p:ext>
            </p:extLst>
          </p:nvPr>
        </p:nvGraphicFramePr>
        <p:xfrm>
          <a:off x="6513444" y="591005"/>
          <a:ext cx="5307495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10" name="Chart 9">
            <a:extLst>
              <a:ext uri="{FF2B5EF4-FFF2-40B4-BE49-F238E27FC236}">
                <a16:creationId xmlns:a16="http://schemas.microsoft.com/office/drawing/2014/main" id="{5496260C-9BCC-4823-9DFC-10DEDB43960B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856543731"/>
              </p:ext>
            </p:extLst>
          </p:nvPr>
        </p:nvGraphicFramePr>
        <p:xfrm>
          <a:off x="291548" y="3809572"/>
          <a:ext cx="5221355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11" name="Chart 10">
            <a:extLst>
              <a:ext uri="{FF2B5EF4-FFF2-40B4-BE49-F238E27FC236}">
                <a16:creationId xmlns:a16="http://schemas.microsoft.com/office/drawing/2014/main" id="{5496260C-9BCC-4823-9DFC-10DEDB43960B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632560103"/>
              </p:ext>
            </p:extLst>
          </p:nvPr>
        </p:nvGraphicFramePr>
        <p:xfrm>
          <a:off x="6513445" y="3863011"/>
          <a:ext cx="5307493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</p:spTree>
    <p:extLst>
      <p:ext uri="{BB962C8B-B14F-4D97-AF65-F5344CB8AC3E}">
        <p14:creationId xmlns:p14="http://schemas.microsoft.com/office/powerpoint/2010/main" val="382497309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Chart 3">
            <a:extLst>
              <a:ext uri="{FF2B5EF4-FFF2-40B4-BE49-F238E27FC236}">
                <a16:creationId xmlns:a16="http://schemas.microsoft.com/office/drawing/2014/main" id="{5496260C-9BCC-4823-9DFC-10DEDB43960B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047734770"/>
              </p:ext>
            </p:extLst>
          </p:nvPr>
        </p:nvGraphicFramePr>
        <p:xfrm>
          <a:off x="596350" y="755622"/>
          <a:ext cx="5015948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5" name="Chart 4">
            <a:extLst>
              <a:ext uri="{FF2B5EF4-FFF2-40B4-BE49-F238E27FC236}">
                <a16:creationId xmlns:a16="http://schemas.microsoft.com/office/drawing/2014/main" id="{5496260C-9BCC-4823-9DFC-10DEDB43960B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798637937"/>
              </p:ext>
            </p:extLst>
          </p:nvPr>
        </p:nvGraphicFramePr>
        <p:xfrm>
          <a:off x="6195392" y="755622"/>
          <a:ext cx="5002695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</p:spTree>
    <p:extLst>
      <p:ext uri="{BB962C8B-B14F-4D97-AF65-F5344CB8AC3E}">
        <p14:creationId xmlns:p14="http://schemas.microsoft.com/office/powerpoint/2010/main" val="395606403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0</TotalTime>
  <Words>8</Words>
  <Application>Microsoft Office PowerPoint</Application>
  <PresentationFormat>Widescreen</PresentationFormat>
  <Paragraphs>6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6" baseType="lpstr">
      <vt:lpstr>Arial</vt:lpstr>
      <vt:lpstr>Calibri</vt:lpstr>
      <vt:lpstr>Calibri Light</vt:lpstr>
      <vt:lpstr>Office Theme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PRONOB PAUL</dc:creator>
  <cp:lastModifiedBy>Pronob J. Paul</cp:lastModifiedBy>
  <cp:revision>8</cp:revision>
  <dcterms:created xsi:type="dcterms:W3CDTF">2016-06-06T04:59:49Z</dcterms:created>
  <dcterms:modified xsi:type="dcterms:W3CDTF">2017-09-12T08:41:22Z</dcterms:modified>
</cp:coreProperties>
</file>